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249" r:id="rId2"/>
    <p:sldId id="276" r:id="rId3"/>
    <p:sldId id="1248" r:id="rId4"/>
    <p:sldId id="124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uthor" initials="Editor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08" autoAdjust="0"/>
    <p:restoredTop sz="94660"/>
  </p:normalViewPr>
  <p:slideViewPr>
    <p:cSldViewPr snapToGrid="0">
      <p:cViewPr varScale="1">
        <p:scale>
          <a:sx n="82" d="100"/>
          <a:sy n="82" d="100"/>
        </p:scale>
        <p:origin x="62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19EE6-E698-4155-B48B-4A49F2A130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03FD91-B41E-4FE6-A514-1F52AC4098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9565E-3F01-4F15-8496-8FEE61BF4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77C6C3-ACE0-49A3-B8D1-D5CDCDEF8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E095B6-1B86-4F21-A73B-3C18D2ED9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0474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A3D55D-1A4E-459D-A557-0A4CDE6B4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C5573F-A392-4EEA-A251-2CAA8328E7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59198E-7D0A-4F49-AD5D-8A25B1CE5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A0648D-EE4E-44B4-8510-4698B521E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BA034-866C-4235-AAA6-4BEE8962C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9714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B77ADD-A363-4259-9CF4-A30297FF77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602636-40F0-4F29-858A-41B771158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1A940D-3BAA-473F-AF4B-64F229FF7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E5937-A378-42F6-BE30-97CB223D8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07CAF-A7A4-4C52-BDE4-935966FDC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508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E103B-185E-49C0-9649-CAA1E1CF9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29B1C3-0D07-45F5-8E91-3C1A4405F6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77C3FE-9292-48B8-9BAD-EB902F146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2C3F2-1394-4393-B21A-EA391BF5D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244962-417C-4CCB-8782-731ECD38E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8660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D53E1-1134-4715-A751-9E2FC2D53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B44157-5E32-4D8B-94AE-C12719D53C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820586-2555-45D1-9CCE-3E10EF0B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E6C095-2DF4-42DD-A334-FFB0C269B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36603-55F4-4237-8E2A-CACAAA48F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0363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E87E81-8198-4F9E-B56E-57C99BF47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55AAA5-7F66-4E23-A4ED-F46567481A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A8A576-5FB2-4E48-B4E1-16787F00F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2AB8B-8642-4A89-93C7-13BF4965F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5771A9-6A14-4DCF-8943-B522C3A67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96B78F-0DFE-40E0-84E0-7AD69C01A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38980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C1D37-6E95-4107-9C78-CCA466935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49D0E2-E20E-45E2-B981-F3A785D175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FC1168-EADE-4BEC-839F-F1FCF20762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56A62D-FB13-44C0-B9B5-78F1476AFA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EE78ED-7C3E-496C-A7E8-42E15E58D4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43C14B-59C6-415E-8657-DF72E230E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7FBC8B-BEF8-40CE-ACF3-52BF172CC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76FDDA-D307-4BE1-8C98-98A2C7C56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42721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48F80-E894-442D-93C6-FE37CCAA4D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35522F-9DA7-4123-ACA3-EEDB40C80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8744B1-2544-41DD-A027-71DB0C593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7F667B-DC23-4ABF-9125-6BDFDD423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7783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49196A-0C5B-4C22-ADD2-2B91F0F53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39A9E5-EDDC-46B6-A05F-AB7FBE1C2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6A0D1F-772E-4F68-8779-9E106E351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9429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FAFAD-7157-4359-9BA6-90CA02B5D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2E7BC1-F6AA-4840-86B3-EC8D638568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08D8D0-26D4-4FEF-82F3-2DC102B15B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BEFD94-9144-4C52-97C9-D6A124538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F5E021-FAEC-42DE-B3ED-C2ABDB82A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5DFCD3-AD4A-498F-858D-55F438A36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6114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9EFF0-2972-4029-9727-0798320A7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96A92B-5493-4B4E-8F90-874A9DD64E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F98276-02F4-4DFD-AA64-113BDDE213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547871-ADBB-46F9-AA56-B4374700C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EF725E-84E4-40BF-A3A4-00FED1930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DE7EF8-A065-4848-99E9-D91335D11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613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EBE4A8-36F3-4D02-ADA8-0D06D235E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AD9923-D6C8-4972-AEB0-516385127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10BEA0-99E3-4E4F-837E-166E9BA6DF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B9CD97-00F9-47E4-82C3-F39B8E96C7B5}" type="datetimeFigureOut">
              <a:rPr lang="en-IN" smtClean="0"/>
              <a:t>11-08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BA79C-4813-4323-B608-BF152BBECE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53FD6-1021-4732-89EE-DB2CD5A816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E9486-B21E-46C9-A358-755EAE327B7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7305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CE07FD-6AB0-35DF-0562-AFFAC8760F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0ACC9F75-5CCD-9FC0-F9D8-3501DA8538D5}"/>
              </a:ext>
            </a:extLst>
          </p:cNvPr>
          <p:cNvGrpSpPr/>
          <p:nvPr/>
        </p:nvGrpSpPr>
        <p:grpSpPr>
          <a:xfrm>
            <a:off x="1499598" y="2550771"/>
            <a:ext cx="2278753" cy="1746733"/>
            <a:chOff x="2268863" y="2379407"/>
            <a:chExt cx="2278753" cy="1746733"/>
          </a:xfrm>
        </p:grpSpPr>
        <p:sp>
          <p:nvSpPr>
            <p:cNvPr id="3" name="フリーフォーム: 図形 2">
              <a:extLst>
                <a:ext uri="{FF2B5EF4-FFF2-40B4-BE49-F238E27FC236}">
                  <a16:creationId xmlns:a16="http://schemas.microsoft.com/office/drawing/2014/main" id="{6EF781B4-9EB2-FEA7-7C3E-754D7794588F}"/>
                </a:ext>
              </a:extLst>
            </p:cNvPr>
            <p:cNvSpPr/>
            <p:nvPr/>
          </p:nvSpPr>
          <p:spPr>
            <a:xfrm>
              <a:off x="2268863" y="2379407"/>
              <a:ext cx="2278753" cy="1746733"/>
            </a:xfrm>
            <a:custGeom>
              <a:avLst/>
              <a:gdLst>
                <a:gd name="connsiteX0" fmla="*/ 1037952 w 5580712"/>
                <a:gd name="connsiteY0" fmla="*/ 4043680 h 4048195"/>
                <a:gd name="connsiteX1" fmla="*/ 570592 w 5580712"/>
                <a:gd name="connsiteY1" fmla="*/ 3921760 h 4048195"/>
                <a:gd name="connsiteX2" fmla="*/ 336912 w 5580712"/>
                <a:gd name="connsiteY2" fmla="*/ 3627120 h 4048195"/>
                <a:gd name="connsiteX3" fmla="*/ 154032 w 5580712"/>
                <a:gd name="connsiteY3" fmla="*/ 3291840 h 4048195"/>
                <a:gd name="connsiteX4" fmla="*/ 52432 w 5580712"/>
                <a:gd name="connsiteY4" fmla="*/ 2915920 h 4048195"/>
                <a:gd name="connsiteX5" fmla="*/ 1632 w 5580712"/>
                <a:gd name="connsiteY5" fmla="*/ 2519680 h 4048195"/>
                <a:gd name="connsiteX6" fmla="*/ 21952 w 5580712"/>
                <a:gd name="connsiteY6" fmla="*/ 2204720 h 4048195"/>
                <a:gd name="connsiteX7" fmla="*/ 113392 w 5580712"/>
                <a:gd name="connsiteY7" fmla="*/ 1828800 h 4048195"/>
                <a:gd name="connsiteX8" fmla="*/ 296272 w 5580712"/>
                <a:gd name="connsiteY8" fmla="*/ 1391920 h 4048195"/>
                <a:gd name="connsiteX9" fmla="*/ 479152 w 5580712"/>
                <a:gd name="connsiteY9" fmla="*/ 1087120 h 4048195"/>
                <a:gd name="connsiteX10" fmla="*/ 814432 w 5580712"/>
                <a:gd name="connsiteY10" fmla="*/ 751840 h 4048195"/>
                <a:gd name="connsiteX11" fmla="*/ 1159872 w 5580712"/>
                <a:gd name="connsiteY11" fmla="*/ 477520 h 4048195"/>
                <a:gd name="connsiteX12" fmla="*/ 1545952 w 5580712"/>
                <a:gd name="connsiteY12" fmla="*/ 264160 h 4048195"/>
                <a:gd name="connsiteX13" fmla="*/ 1982832 w 5580712"/>
                <a:gd name="connsiteY13" fmla="*/ 121920 h 4048195"/>
                <a:gd name="connsiteX14" fmla="*/ 2307952 w 5580712"/>
                <a:gd name="connsiteY14" fmla="*/ 40640 h 4048195"/>
                <a:gd name="connsiteX15" fmla="*/ 2937872 w 5580712"/>
                <a:gd name="connsiteY15" fmla="*/ 0 h 4048195"/>
                <a:gd name="connsiteX16" fmla="*/ 3364592 w 5580712"/>
                <a:gd name="connsiteY16" fmla="*/ 40640 h 4048195"/>
                <a:gd name="connsiteX17" fmla="*/ 3882752 w 5580712"/>
                <a:gd name="connsiteY17" fmla="*/ 91440 h 4048195"/>
                <a:gd name="connsiteX18" fmla="*/ 4319632 w 5580712"/>
                <a:gd name="connsiteY18" fmla="*/ 162560 h 4048195"/>
                <a:gd name="connsiteX19" fmla="*/ 4634592 w 5580712"/>
                <a:gd name="connsiteY19" fmla="*/ 314960 h 4048195"/>
                <a:gd name="connsiteX20" fmla="*/ 4634592 w 5580712"/>
                <a:gd name="connsiteY20" fmla="*/ 314960 h 4048195"/>
                <a:gd name="connsiteX21" fmla="*/ 4868272 w 5580712"/>
                <a:gd name="connsiteY21" fmla="*/ 426720 h 4048195"/>
                <a:gd name="connsiteX22" fmla="*/ 5244192 w 5580712"/>
                <a:gd name="connsiteY22" fmla="*/ 609600 h 4048195"/>
                <a:gd name="connsiteX23" fmla="*/ 5427072 w 5580712"/>
                <a:gd name="connsiteY23" fmla="*/ 772160 h 4048195"/>
                <a:gd name="connsiteX24" fmla="*/ 5538832 w 5580712"/>
                <a:gd name="connsiteY24" fmla="*/ 914400 h 4048195"/>
                <a:gd name="connsiteX25" fmla="*/ 5579472 w 5580712"/>
                <a:gd name="connsiteY25" fmla="*/ 1107440 h 4048195"/>
                <a:gd name="connsiteX26" fmla="*/ 5498192 w 5580712"/>
                <a:gd name="connsiteY26" fmla="*/ 1300480 h 4048195"/>
                <a:gd name="connsiteX27" fmla="*/ 5315312 w 5580712"/>
                <a:gd name="connsiteY27" fmla="*/ 1422400 h 4048195"/>
                <a:gd name="connsiteX28" fmla="*/ 5091792 w 5580712"/>
                <a:gd name="connsiteY28" fmla="*/ 1452880 h 4048195"/>
                <a:gd name="connsiteX29" fmla="*/ 4868272 w 5580712"/>
                <a:gd name="connsiteY29" fmla="*/ 1513840 h 4048195"/>
                <a:gd name="connsiteX30" fmla="*/ 4685392 w 5580712"/>
                <a:gd name="connsiteY30" fmla="*/ 1513840 h 4048195"/>
                <a:gd name="connsiteX31" fmla="*/ 4482192 w 5580712"/>
                <a:gd name="connsiteY31" fmla="*/ 1513840 h 4048195"/>
                <a:gd name="connsiteX32" fmla="*/ 4258672 w 5580712"/>
                <a:gd name="connsiteY32" fmla="*/ 1554480 h 4048195"/>
                <a:gd name="connsiteX33" fmla="*/ 4065632 w 5580712"/>
                <a:gd name="connsiteY33" fmla="*/ 1645920 h 4048195"/>
                <a:gd name="connsiteX34" fmla="*/ 3903072 w 5580712"/>
                <a:gd name="connsiteY34" fmla="*/ 1818640 h 4048195"/>
                <a:gd name="connsiteX35" fmla="*/ 3699872 w 5580712"/>
                <a:gd name="connsiteY35" fmla="*/ 1899920 h 4048195"/>
                <a:gd name="connsiteX36" fmla="*/ 3456032 w 5580712"/>
                <a:gd name="connsiteY36" fmla="*/ 1991360 h 4048195"/>
                <a:gd name="connsiteX37" fmla="*/ 3273152 w 5580712"/>
                <a:gd name="connsiteY37" fmla="*/ 2021840 h 4048195"/>
                <a:gd name="connsiteX38" fmla="*/ 3059792 w 5580712"/>
                <a:gd name="connsiteY38" fmla="*/ 2072640 h 4048195"/>
                <a:gd name="connsiteX39" fmla="*/ 2897232 w 5580712"/>
                <a:gd name="connsiteY39" fmla="*/ 2042160 h 4048195"/>
                <a:gd name="connsiteX40" fmla="*/ 2775312 w 5580712"/>
                <a:gd name="connsiteY40" fmla="*/ 2001520 h 4048195"/>
                <a:gd name="connsiteX41" fmla="*/ 2937872 w 5580712"/>
                <a:gd name="connsiteY41" fmla="*/ 2113280 h 4048195"/>
                <a:gd name="connsiteX42" fmla="*/ 3008992 w 5580712"/>
                <a:gd name="connsiteY42" fmla="*/ 2184400 h 4048195"/>
                <a:gd name="connsiteX43" fmla="*/ 3008992 w 5580712"/>
                <a:gd name="connsiteY43" fmla="*/ 2306320 h 4048195"/>
                <a:gd name="connsiteX44" fmla="*/ 2927712 w 5580712"/>
                <a:gd name="connsiteY44" fmla="*/ 2458720 h 4048195"/>
                <a:gd name="connsiteX45" fmla="*/ 2815952 w 5580712"/>
                <a:gd name="connsiteY45" fmla="*/ 2570480 h 4048195"/>
                <a:gd name="connsiteX46" fmla="*/ 2683872 w 5580712"/>
                <a:gd name="connsiteY46" fmla="*/ 2600960 h 4048195"/>
                <a:gd name="connsiteX47" fmla="*/ 2409552 w 5580712"/>
                <a:gd name="connsiteY47" fmla="*/ 2672080 h 4048195"/>
                <a:gd name="connsiteX48" fmla="*/ 2257152 w 5580712"/>
                <a:gd name="connsiteY48" fmla="*/ 2682240 h 4048195"/>
                <a:gd name="connsiteX49" fmla="*/ 2175872 w 5580712"/>
                <a:gd name="connsiteY49" fmla="*/ 2794000 h 4048195"/>
                <a:gd name="connsiteX50" fmla="*/ 2186032 w 5580712"/>
                <a:gd name="connsiteY50" fmla="*/ 2966720 h 4048195"/>
                <a:gd name="connsiteX51" fmla="*/ 2186032 w 5580712"/>
                <a:gd name="connsiteY51" fmla="*/ 3180080 h 4048195"/>
                <a:gd name="connsiteX52" fmla="*/ 2175872 w 5580712"/>
                <a:gd name="connsiteY52" fmla="*/ 3393440 h 4048195"/>
                <a:gd name="connsiteX53" fmla="*/ 2125072 w 5580712"/>
                <a:gd name="connsiteY53" fmla="*/ 3576320 h 4048195"/>
                <a:gd name="connsiteX54" fmla="*/ 2043792 w 5580712"/>
                <a:gd name="connsiteY54" fmla="*/ 3759200 h 4048195"/>
                <a:gd name="connsiteX55" fmla="*/ 1871072 w 5580712"/>
                <a:gd name="connsiteY55" fmla="*/ 3881120 h 4048195"/>
                <a:gd name="connsiteX56" fmla="*/ 1708512 w 5580712"/>
                <a:gd name="connsiteY56" fmla="*/ 3982720 h 4048195"/>
                <a:gd name="connsiteX57" fmla="*/ 1474832 w 5580712"/>
                <a:gd name="connsiteY57" fmla="*/ 4043680 h 4048195"/>
                <a:gd name="connsiteX58" fmla="*/ 1220832 w 5580712"/>
                <a:gd name="connsiteY58" fmla="*/ 4043680 h 4048195"/>
                <a:gd name="connsiteX59" fmla="*/ 1088752 w 5580712"/>
                <a:gd name="connsiteY59" fmla="*/ 4043680 h 4048195"/>
                <a:gd name="connsiteX60" fmla="*/ 1037952 w 5580712"/>
                <a:gd name="connsiteY60" fmla="*/ 4043680 h 40481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</a:cxnLst>
              <a:rect l="l" t="t" r="r" b="b"/>
              <a:pathLst>
                <a:path w="5580712" h="4048195">
                  <a:moveTo>
                    <a:pt x="1037952" y="4043680"/>
                  </a:moveTo>
                  <a:cubicBezTo>
                    <a:pt x="862692" y="4017433"/>
                    <a:pt x="687432" y="3991187"/>
                    <a:pt x="570592" y="3921760"/>
                  </a:cubicBezTo>
                  <a:cubicBezTo>
                    <a:pt x="453752" y="3852333"/>
                    <a:pt x="406339" y="3732107"/>
                    <a:pt x="336912" y="3627120"/>
                  </a:cubicBezTo>
                  <a:cubicBezTo>
                    <a:pt x="267485" y="3522133"/>
                    <a:pt x="201445" y="3410373"/>
                    <a:pt x="154032" y="3291840"/>
                  </a:cubicBezTo>
                  <a:cubicBezTo>
                    <a:pt x="106619" y="3173307"/>
                    <a:pt x="77832" y="3044613"/>
                    <a:pt x="52432" y="2915920"/>
                  </a:cubicBezTo>
                  <a:cubicBezTo>
                    <a:pt x="27032" y="2787227"/>
                    <a:pt x="6712" y="2638213"/>
                    <a:pt x="1632" y="2519680"/>
                  </a:cubicBezTo>
                  <a:cubicBezTo>
                    <a:pt x="-3448" y="2401147"/>
                    <a:pt x="3325" y="2319867"/>
                    <a:pt x="21952" y="2204720"/>
                  </a:cubicBezTo>
                  <a:cubicBezTo>
                    <a:pt x="40579" y="2089573"/>
                    <a:pt x="67672" y="1964267"/>
                    <a:pt x="113392" y="1828800"/>
                  </a:cubicBezTo>
                  <a:cubicBezTo>
                    <a:pt x="159112" y="1693333"/>
                    <a:pt x="235312" y="1515533"/>
                    <a:pt x="296272" y="1391920"/>
                  </a:cubicBezTo>
                  <a:cubicBezTo>
                    <a:pt x="357232" y="1268307"/>
                    <a:pt x="392792" y="1193800"/>
                    <a:pt x="479152" y="1087120"/>
                  </a:cubicBezTo>
                  <a:cubicBezTo>
                    <a:pt x="565512" y="980440"/>
                    <a:pt x="700979" y="853440"/>
                    <a:pt x="814432" y="751840"/>
                  </a:cubicBezTo>
                  <a:cubicBezTo>
                    <a:pt x="927885" y="650240"/>
                    <a:pt x="1037952" y="558800"/>
                    <a:pt x="1159872" y="477520"/>
                  </a:cubicBezTo>
                  <a:cubicBezTo>
                    <a:pt x="1281792" y="396240"/>
                    <a:pt x="1408792" y="323427"/>
                    <a:pt x="1545952" y="264160"/>
                  </a:cubicBezTo>
                  <a:cubicBezTo>
                    <a:pt x="1683112" y="204893"/>
                    <a:pt x="1855832" y="159173"/>
                    <a:pt x="1982832" y="121920"/>
                  </a:cubicBezTo>
                  <a:cubicBezTo>
                    <a:pt x="2109832" y="84667"/>
                    <a:pt x="2148779" y="60960"/>
                    <a:pt x="2307952" y="40640"/>
                  </a:cubicBezTo>
                  <a:cubicBezTo>
                    <a:pt x="2467125" y="20320"/>
                    <a:pt x="2761765" y="0"/>
                    <a:pt x="2937872" y="0"/>
                  </a:cubicBezTo>
                  <a:cubicBezTo>
                    <a:pt x="3113979" y="0"/>
                    <a:pt x="3364592" y="40640"/>
                    <a:pt x="3364592" y="40640"/>
                  </a:cubicBezTo>
                  <a:cubicBezTo>
                    <a:pt x="3522072" y="55880"/>
                    <a:pt x="3723579" y="71120"/>
                    <a:pt x="3882752" y="91440"/>
                  </a:cubicBezTo>
                  <a:cubicBezTo>
                    <a:pt x="4041925" y="111760"/>
                    <a:pt x="4194325" y="125307"/>
                    <a:pt x="4319632" y="162560"/>
                  </a:cubicBezTo>
                  <a:cubicBezTo>
                    <a:pt x="4444939" y="199813"/>
                    <a:pt x="4634592" y="314960"/>
                    <a:pt x="4634592" y="314960"/>
                  </a:cubicBezTo>
                  <a:lnTo>
                    <a:pt x="4634592" y="314960"/>
                  </a:lnTo>
                  <a:lnTo>
                    <a:pt x="4868272" y="426720"/>
                  </a:lnTo>
                  <a:cubicBezTo>
                    <a:pt x="4969872" y="475827"/>
                    <a:pt x="5151059" y="552027"/>
                    <a:pt x="5244192" y="609600"/>
                  </a:cubicBezTo>
                  <a:cubicBezTo>
                    <a:pt x="5337325" y="667173"/>
                    <a:pt x="5377965" y="721360"/>
                    <a:pt x="5427072" y="772160"/>
                  </a:cubicBezTo>
                  <a:cubicBezTo>
                    <a:pt x="5476179" y="822960"/>
                    <a:pt x="5513432" y="858520"/>
                    <a:pt x="5538832" y="914400"/>
                  </a:cubicBezTo>
                  <a:cubicBezTo>
                    <a:pt x="5564232" y="970280"/>
                    <a:pt x="5586245" y="1043093"/>
                    <a:pt x="5579472" y="1107440"/>
                  </a:cubicBezTo>
                  <a:cubicBezTo>
                    <a:pt x="5572699" y="1171787"/>
                    <a:pt x="5542219" y="1247987"/>
                    <a:pt x="5498192" y="1300480"/>
                  </a:cubicBezTo>
                  <a:cubicBezTo>
                    <a:pt x="5454165" y="1352973"/>
                    <a:pt x="5383045" y="1397000"/>
                    <a:pt x="5315312" y="1422400"/>
                  </a:cubicBezTo>
                  <a:cubicBezTo>
                    <a:pt x="5247579" y="1447800"/>
                    <a:pt x="5166299" y="1437640"/>
                    <a:pt x="5091792" y="1452880"/>
                  </a:cubicBezTo>
                  <a:cubicBezTo>
                    <a:pt x="5017285" y="1468120"/>
                    <a:pt x="4936005" y="1503680"/>
                    <a:pt x="4868272" y="1513840"/>
                  </a:cubicBezTo>
                  <a:cubicBezTo>
                    <a:pt x="4800539" y="1524000"/>
                    <a:pt x="4685392" y="1513840"/>
                    <a:pt x="4685392" y="1513840"/>
                  </a:cubicBezTo>
                  <a:cubicBezTo>
                    <a:pt x="4621045" y="1513840"/>
                    <a:pt x="4553312" y="1507067"/>
                    <a:pt x="4482192" y="1513840"/>
                  </a:cubicBezTo>
                  <a:cubicBezTo>
                    <a:pt x="4411072" y="1520613"/>
                    <a:pt x="4328099" y="1532467"/>
                    <a:pt x="4258672" y="1554480"/>
                  </a:cubicBezTo>
                  <a:cubicBezTo>
                    <a:pt x="4189245" y="1576493"/>
                    <a:pt x="4124899" y="1601893"/>
                    <a:pt x="4065632" y="1645920"/>
                  </a:cubicBezTo>
                  <a:cubicBezTo>
                    <a:pt x="4006365" y="1689947"/>
                    <a:pt x="3964032" y="1776307"/>
                    <a:pt x="3903072" y="1818640"/>
                  </a:cubicBezTo>
                  <a:cubicBezTo>
                    <a:pt x="3842112" y="1860973"/>
                    <a:pt x="3699872" y="1899920"/>
                    <a:pt x="3699872" y="1899920"/>
                  </a:cubicBezTo>
                  <a:cubicBezTo>
                    <a:pt x="3625365" y="1928707"/>
                    <a:pt x="3527152" y="1971040"/>
                    <a:pt x="3456032" y="1991360"/>
                  </a:cubicBezTo>
                  <a:cubicBezTo>
                    <a:pt x="3384912" y="2011680"/>
                    <a:pt x="3339192" y="2008293"/>
                    <a:pt x="3273152" y="2021840"/>
                  </a:cubicBezTo>
                  <a:cubicBezTo>
                    <a:pt x="3207112" y="2035387"/>
                    <a:pt x="3122445" y="2069253"/>
                    <a:pt x="3059792" y="2072640"/>
                  </a:cubicBezTo>
                  <a:cubicBezTo>
                    <a:pt x="2997139" y="2076027"/>
                    <a:pt x="2944645" y="2054013"/>
                    <a:pt x="2897232" y="2042160"/>
                  </a:cubicBezTo>
                  <a:cubicBezTo>
                    <a:pt x="2849819" y="2030307"/>
                    <a:pt x="2768539" y="1989667"/>
                    <a:pt x="2775312" y="2001520"/>
                  </a:cubicBezTo>
                  <a:cubicBezTo>
                    <a:pt x="2782085" y="2013373"/>
                    <a:pt x="2898925" y="2082800"/>
                    <a:pt x="2937872" y="2113280"/>
                  </a:cubicBezTo>
                  <a:cubicBezTo>
                    <a:pt x="2976819" y="2143760"/>
                    <a:pt x="2997139" y="2152227"/>
                    <a:pt x="3008992" y="2184400"/>
                  </a:cubicBezTo>
                  <a:cubicBezTo>
                    <a:pt x="3020845" y="2216573"/>
                    <a:pt x="3022539" y="2260600"/>
                    <a:pt x="3008992" y="2306320"/>
                  </a:cubicBezTo>
                  <a:cubicBezTo>
                    <a:pt x="2995445" y="2352040"/>
                    <a:pt x="2959885" y="2414693"/>
                    <a:pt x="2927712" y="2458720"/>
                  </a:cubicBezTo>
                  <a:cubicBezTo>
                    <a:pt x="2895539" y="2502747"/>
                    <a:pt x="2856592" y="2546773"/>
                    <a:pt x="2815952" y="2570480"/>
                  </a:cubicBezTo>
                  <a:cubicBezTo>
                    <a:pt x="2775312" y="2594187"/>
                    <a:pt x="2683872" y="2600960"/>
                    <a:pt x="2683872" y="2600960"/>
                  </a:cubicBezTo>
                  <a:cubicBezTo>
                    <a:pt x="2616139" y="2617893"/>
                    <a:pt x="2480672" y="2658533"/>
                    <a:pt x="2409552" y="2672080"/>
                  </a:cubicBezTo>
                  <a:cubicBezTo>
                    <a:pt x="2338432" y="2685627"/>
                    <a:pt x="2296099" y="2661920"/>
                    <a:pt x="2257152" y="2682240"/>
                  </a:cubicBezTo>
                  <a:cubicBezTo>
                    <a:pt x="2218205" y="2702560"/>
                    <a:pt x="2187725" y="2746587"/>
                    <a:pt x="2175872" y="2794000"/>
                  </a:cubicBezTo>
                  <a:cubicBezTo>
                    <a:pt x="2164019" y="2841413"/>
                    <a:pt x="2184339" y="2902373"/>
                    <a:pt x="2186032" y="2966720"/>
                  </a:cubicBezTo>
                  <a:cubicBezTo>
                    <a:pt x="2187725" y="3031067"/>
                    <a:pt x="2187725" y="3108960"/>
                    <a:pt x="2186032" y="3180080"/>
                  </a:cubicBezTo>
                  <a:cubicBezTo>
                    <a:pt x="2184339" y="3251200"/>
                    <a:pt x="2186032" y="3327400"/>
                    <a:pt x="2175872" y="3393440"/>
                  </a:cubicBezTo>
                  <a:cubicBezTo>
                    <a:pt x="2165712" y="3459480"/>
                    <a:pt x="2147085" y="3515360"/>
                    <a:pt x="2125072" y="3576320"/>
                  </a:cubicBezTo>
                  <a:cubicBezTo>
                    <a:pt x="2103059" y="3637280"/>
                    <a:pt x="2086125" y="3708400"/>
                    <a:pt x="2043792" y="3759200"/>
                  </a:cubicBezTo>
                  <a:cubicBezTo>
                    <a:pt x="2001459" y="3810000"/>
                    <a:pt x="1926952" y="3843867"/>
                    <a:pt x="1871072" y="3881120"/>
                  </a:cubicBezTo>
                  <a:cubicBezTo>
                    <a:pt x="1815192" y="3918373"/>
                    <a:pt x="1774552" y="3955627"/>
                    <a:pt x="1708512" y="3982720"/>
                  </a:cubicBezTo>
                  <a:cubicBezTo>
                    <a:pt x="1642472" y="4009813"/>
                    <a:pt x="1556112" y="4033520"/>
                    <a:pt x="1474832" y="4043680"/>
                  </a:cubicBezTo>
                  <a:cubicBezTo>
                    <a:pt x="1393552" y="4053840"/>
                    <a:pt x="1220832" y="4043680"/>
                    <a:pt x="1220832" y="4043680"/>
                  </a:cubicBezTo>
                  <a:lnTo>
                    <a:pt x="1088752" y="4043680"/>
                  </a:lnTo>
                  <a:lnTo>
                    <a:pt x="1037952" y="4043680"/>
                  </a:ln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フリーフォーム: 図形 4">
              <a:extLst>
                <a:ext uri="{FF2B5EF4-FFF2-40B4-BE49-F238E27FC236}">
                  <a16:creationId xmlns:a16="http://schemas.microsoft.com/office/drawing/2014/main" id="{49140FE3-A928-AA63-B13D-56A14665B99B}"/>
                </a:ext>
              </a:extLst>
            </p:cNvPr>
            <p:cNvSpPr/>
            <p:nvPr/>
          </p:nvSpPr>
          <p:spPr>
            <a:xfrm rot="422949">
              <a:off x="2358699" y="3076956"/>
              <a:ext cx="524709" cy="569976"/>
            </a:xfrm>
            <a:custGeom>
              <a:avLst/>
              <a:gdLst>
                <a:gd name="connsiteX0" fmla="*/ 393752 w 1199329"/>
                <a:gd name="connsiteY0" fmla="*/ 1315155 h 1315775"/>
                <a:gd name="connsiteX1" fmla="*/ 190552 w 1199329"/>
                <a:gd name="connsiteY1" fmla="*/ 1223715 h 1315775"/>
                <a:gd name="connsiteX2" fmla="*/ 78792 w 1199329"/>
                <a:gd name="connsiteY2" fmla="*/ 1040835 h 1315775"/>
                <a:gd name="connsiteX3" fmla="*/ 7672 w 1199329"/>
                <a:gd name="connsiteY3" fmla="*/ 847795 h 1315775"/>
                <a:gd name="connsiteX4" fmla="*/ 7672 w 1199329"/>
                <a:gd name="connsiteY4" fmla="*/ 664915 h 1315775"/>
                <a:gd name="connsiteX5" fmla="*/ 58472 w 1199329"/>
                <a:gd name="connsiteY5" fmla="*/ 542995 h 1315775"/>
                <a:gd name="connsiteX6" fmla="*/ 58472 w 1199329"/>
                <a:gd name="connsiteY6" fmla="*/ 390595 h 1315775"/>
                <a:gd name="connsiteX7" fmla="*/ 58472 w 1199329"/>
                <a:gd name="connsiteY7" fmla="*/ 309315 h 1315775"/>
                <a:gd name="connsiteX8" fmla="*/ 149912 w 1199329"/>
                <a:gd name="connsiteY8" fmla="*/ 156915 h 1315775"/>
                <a:gd name="connsiteX9" fmla="*/ 210872 w 1199329"/>
                <a:gd name="connsiteY9" fmla="*/ 65475 h 1315775"/>
                <a:gd name="connsiteX10" fmla="*/ 332792 w 1199329"/>
                <a:gd name="connsiteY10" fmla="*/ 55315 h 1315775"/>
                <a:gd name="connsiteX11" fmla="*/ 485192 w 1199329"/>
                <a:gd name="connsiteY11" fmla="*/ 4515 h 1315775"/>
                <a:gd name="connsiteX12" fmla="*/ 617272 w 1199329"/>
                <a:gd name="connsiteY12" fmla="*/ 4515 h 1315775"/>
                <a:gd name="connsiteX13" fmla="*/ 698552 w 1199329"/>
                <a:gd name="connsiteY13" fmla="*/ 4515 h 1315775"/>
                <a:gd name="connsiteX14" fmla="*/ 850952 w 1199329"/>
                <a:gd name="connsiteY14" fmla="*/ 65475 h 1315775"/>
                <a:gd name="connsiteX15" fmla="*/ 962712 w 1199329"/>
                <a:gd name="connsiteY15" fmla="*/ 177235 h 1315775"/>
                <a:gd name="connsiteX16" fmla="*/ 1013512 w 1199329"/>
                <a:gd name="connsiteY16" fmla="*/ 278835 h 1315775"/>
                <a:gd name="connsiteX17" fmla="*/ 1115112 w 1199329"/>
                <a:gd name="connsiteY17" fmla="*/ 339795 h 1315775"/>
                <a:gd name="connsiteX18" fmla="*/ 1196392 w 1199329"/>
                <a:gd name="connsiteY18" fmla="*/ 482035 h 1315775"/>
                <a:gd name="connsiteX19" fmla="*/ 1155752 w 1199329"/>
                <a:gd name="connsiteY19" fmla="*/ 593795 h 1315775"/>
                <a:gd name="connsiteX20" fmla="*/ 1186232 w 1199329"/>
                <a:gd name="connsiteY20" fmla="*/ 705555 h 1315775"/>
                <a:gd name="connsiteX21" fmla="*/ 1196392 w 1199329"/>
                <a:gd name="connsiteY21" fmla="*/ 857955 h 1315775"/>
                <a:gd name="connsiteX22" fmla="*/ 1135432 w 1199329"/>
                <a:gd name="connsiteY22" fmla="*/ 1010355 h 1315775"/>
                <a:gd name="connsiteX23" fmla="*/ 1023672 w 1199329"/>
                <a:gd name="connsiteY23" fmla="*/ 1111955 h 1315775"/>
                <a:gd name="connsiteX24" fmla="*/ 891592 w 1199329"/>
                <a:gd name="connsiteY24" fmla="*/ 1193235 h 1315775"/>
                <a:gd name="connsiteX25" fmla="*/ 749352 w 1199329"/>
                <a:gd name="connsiteY25" fmla="*/ 1264355 h 1315775"/>
                <a:gd name="connsiteX26" fmla="*/ 556312 w 1199329"/>
                <a:gd name="connsiteY26" fmla="*/ 1264355 h 1315775"/>
                <a:gd name="connsiteX27" fmla="*/ 393752 w 1199329"/>
                <a:gd name="connsiteY27" fmla="*/ 1315155 h 13157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199329" h="1315775">
                  <a:moveTo>
                    <a:pt x="393752" y="1315155"/>
                  </a:moveTo>
                  <a:cubicBezTo>
                    <a:pt x="332792" y="1308382"/>
                    <a:pt x="243045" y="1269435"/>
                    <a:pt x="190552" y="1223715"/>
                  </a:cubicBezTo>
                  <a:cubicBezTo>
                    <a:pt x="138059" y="1177995"/>
                    <a:pt x="109272" y="1103488"/>
                    <a:pt x="78792" y="1040835"/>
                  </a:cubicBezTo>
                  <a:cubicBezTo>
                    <a:pt x="48312" y="978182"/>
                    <a:pt x="19525" y="910448"/>
                    <a:pt x="7672" y="847795"/>
                  </a:cubicBezTo>
                  <a:cubicBezTo>
                    <a:pt x="-4181" y="785142"/>
                    <a:pt x="-795" y="715715"/>
                    <a:pt x="7672" y="664915"/>
                  </a:cubicBezTo>
                  <a:cubicBezTo>
                    <a:pt x="16139" y="614115"/>
                    <a:pt x="50005" y="588715"/>
                    <a:pt x="58472" y="542995"/>
                  </a:cubicBezTo>
                  <a:cubicBezTo>
                    <a:pt x="66939" y="497275"/>
                    <a:pt x="58472" y="390595"/>
                    <a:pt x="58472" y="390595"/>
                  </a:cubicBezTo>
                  <a:cubicBezTo>
                    <a:pt x="58472" y="351648"/>
                    <a:pt x="43232" y="348262"/>
                    <a:pt x="58472" y="309315"/>
                  </a:cubicBezTo>
                  <a:cubicBezTo>
                    <a:pt x="73712" y="270368"/>
                    <a:pt x="124512" y="197555"/>
                    <a:pt x="149912" y="156915"/>
                  </a:cubicBezTo>
                  <a:cubicBezTo>
                    <a:pt x="175312" y="116275"/>
                    <a:pt x="180392" y="82408"/>
                    <a:pt x="210872" y="65475"/>
                  </a:cubicBezTo>
                  <a:cubicBezTo>
                    <a:pt x="241352" y="48542"/>
                    <a:pt x="287072" y="65475"/>
                    <a:pt x="332792" y="55315"/>
                  </a:cubicBezTo>
                  <a:cubicBezTo>
                    <a:pt x="378512" y="45155"/>
                    <a:pt x="437779" y="12982"/>
                    <a:pt x="485192" y="4515"/>
                  </a:cubicBezTo>
                  <a:cubicBezTo>
                    <a:pt x="532605" y="-3952"/>
                    <a:pt x="617272" y="4515"/>
                    <a:pt x="617272" y="4515"/>
                  </a:cubicBezTo>
                  <a:cubicBezTo>
                    <a:pt x="652832" y="4515"/>
                    <a:pt x="659605" y="-5645"/>
                    <a:pt x="698552" y="4515"/>
                  </a:cubicBezTo>
                  <a:cubicBezTo>
                    <a:pt x="737499" y="14675"/>
                    <a:pt x="806925" y="36688"/>
                    <a:pt x="850952" y="65475"/>
                  </a:cubicBezTo>
                  <a:cubicBezTo>
                    <a:pt x="894979" y="94262"/>
                    <a:pt x="935619" y="141675"/>
                    <a:pt x="962712" y="177235"/>
                  </a:cubicBezTo>
                  <a:cubicBezTo>
                    <a:pt x="989805" y="212795"/>
                    <a:pt x="988112" y="251742"/>
                    <a:pt x="1013512" y="278835"/>
                  </a:cubicBezTo>
                  <a:cubicBezTo>
                    <a:pt x="1038912" y="305928"/>
                    <a:pt x="1084632" y="305928"/>
                    <a:pt x="1115112" y="339795"/>
                  </a:cubicBezTo>
                  <a:cubicBezTo>
                    <a:pt x="1145592" y="373662"/>
                    <a:pt x="1189619" y="439702"/>
                    <a:pt x="1196392" y="482035"/>
                  </a:cubicBezTo>
                  <a:cubicBezTo>
                    <a:pt x="1203165" y="524368"/>
                    <a:pt x="1157445" y="556542"/>
                    <a:pt x="1155752" y="593795"/>
                  </a:cubicBezTo>
                  <a:cubicBezTo>
                    <a:pt x="1154059" y="631048"/>
                    <a:pt x="1179459" y="661528"/>
                    <a:pt x="1186232" y="705555"/>
                  </a:cubicBezTo>
                  <a:cubicBezTo>
                    <a:pt x="1193005" y="749582"/>
                    <a:pt x="1204859" y="807155"/>
                    <a:pt x="1196392" y="857955"/>
                  </a:cubicBezTo>
                  <a:cubicBezTo>
                    <a:pt x="1187925" y="908755"/>
                    <a:pt x="1164219" y="968022"/>
                    <a:pt x="1135432" y="1010355"/>
                  </a:cubicBezTo>
                  <a:cubicBezTo>
                    <a:pt x="1106645" y="1052688"/>
                    <a:pt x="1064312" y="1081475"/>
                    <a:pt x="1023672" y="1111955"/>
                  </a:cubicBezTo>
                  <a:cubicBezTo>
                    <a:pt x="983032" y="1142435"/>
                    <a:pt x="937312" y="1167835"/>
                    <a:pt x="891592" y="1193235"/>
                  </a:cubicBezTo>
                  <a:cubicBezTo>
                    <a:pt x="845872" y="1218635"/>
                    <a:pt x="805232" y="1252502"/>
                    <a:pt x="749352" y="1264355"/>
                  </a:cubicBezTo>
                  <a:cubicBezTo>
                    <a:pt x="693472" y="1276208"/>
                    <a:pt x="610499" y="1257582"/>
                    <a:pt x="556312" y="1264355"/>
                  </a:cubicBezTo>
                  <a:cubicBezTo>
                    <a:pt x="502125" y="1271128"/>
                    <a:pt x="454712" y="1321928"/>
                    <a:pt x="393752" y="1315155"/>
                  </a:cubicBezTo>
                  <a:close/>
                </a:path>
              </a:pathLst>
            </a:cu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151E6C2F-37D3-4E37-E42E-53F3412BDB14}"/>
              </a:ext>
            </a:extLst>
          </p:cNvPr>
          <p:cNvGrpSpPr/>
          <p:nvPr/>
        </p:nvGrpSpPr>
        <p:grpSpPr>
          <a:xfrm>
            <a:off x="4723231" y="1245569"/>
            <a:ext cx="2278753" cy="1746733"/>
            <a:chOff x="4965276" y="1481077"/>
            <a:chExt cx="2278753" cy="1746733"/>
          </a:xfrm>
        </p:grpSpPr>
        <p:sp>
          <p:nvSpPr>
            <p:cNvPr id="8" name="フリーフォーム: 図形 7">
              <a:extLst>
                <a:ext uri="{FF2B5EF4-FFF2-40B4-BE49-F238E27FC236}">
                  <a16:creationId xmlns:a16="http://schemas.microsoft.com/office/drawing/2014/main" id="{371BF296-DEF3-9FA9-FAE9-D89884FB1E4A}"/>
                </a:ext>
              </a:extLst>
            </p:cNvPr>
            <p:cNvSpPr/>
            <p:nvPr/>
          </p:nvSpPr>
          <p:spPr>
            <a:xfrm>
              <a:off x="4965276" y="1481077"/>
              <a:ext cx="2278753" cy="1746733"/>
            </a:xfrm>
            <a:custGeom>
              <a:avLst/>
              <a:gdLst>
                <a:gd name="connsiteX0" fmla="*/ 1037952 w 5580712"/>
                <a:gd name="connsiteY0" fmla="*/ 4043680 h 4048195"/>
                <a:gd name="connsiteX1" fmla="*/ 570592 w 5580712"/>
                <a:gd name="connsiteY1" fmla="*/ 3921760 h 4048195"/>
                <a:gd name="connsiteX2" fmla="*/ 336912 w 5580712"/>
                <a:gd name="connsiteY2" fmla="*/ 3627120 h 4048195"/>
                <a:gd name="connsiteX3" fmla="*/ 154032 w 5580712"/>
                <a:gd name="connsiteY3" fmla="*/ 3291840 h 4048195"/>
                <a:gd name="connsiteX4" fmla="*/ 52432 w 5580712"/>
                <a:gd name="connsiteY4" fmla="*/ 2915920 h 4048195"/>
                <a:gd name="connsiteX5" fmla="*/ 1632 w 5580712"/>
                <a:gd name="connsiteY5" fmla="*/ 2519680 h 4048195"/>
                <a:gd name="connsiteX6" fmla="*/ 21952 w 5580712"/>
                <a:gd name="connsiteY6" fmla="*/ 2204720 h 4048195"/>
                <a:gd name="connsiteX7" fmla="*/ 113392 w 5580712"/>
                <a:gd name="connsiteY7" fmla="*/ 1828800 h 4048195"/>
                <a:gd name="connsiteX8" fmla="*/ 296272 w 5580712"/>
                <a:gd name="connsiteY8" fmla="*/ 1391920 h 4048195"/>
                <a:gd name="connsiteX9" fmla="*/ 479152 w 5580712"/>
                <a:gd name="connsiteY9" fmla="*/ 1087120 h 4048195"/>
                <a:gd name="connsiteX10" fmla="*/ 814432 w 5580712"/>
                <a:gd name="connsiteY10" fmla="*/ 751840 h 4048195"/>
                <a:gd name="connsiteX11" fmla="*/ 1159872 w 5580712"/>
                <a:gd name="connsiteY11" fmla="*/ 477520 h 4048195"/>
                <a:gd name="connsiteX12" fmla="*/ 1545952 w 5580712"/>
                <a:gd name="connsiteY12" fmla="*/ 264160 h 4048195"/>
                <a:gd name="connsiteX13" fmla="*/ 1982832 w 5580712"/>
                <a:gd name="connsiteY13" fmla="*/ 121920 h 4048195"/>
                <a:gd name="connsiteX14" fmla="*/ 2307952 w 5580712"/>
                <a:gd name="connsiteY14" fmla="*/ 40640 h 4048195"/>
                <a:gd name="connsiteX15" fmla="*/ 2937872 w 5580712"/>
                <a:gd name="connsiteY15" fmla="*/ 0 h 4048195"/>
                <a:gd name="connsiteX16" fmla="*/ 3364592 w 5580712"/>
                <a:gd name="connsiteY16" fmla="*/ 40640 h 4048195"/>
                <a:gd name="connsiteX17" fmla="*/ 3882752 w 5580712"/>
                <a:gd name="connsiteY17" fmla="*/ 91440 h 4048195"/>
                <a:gd name="connsiteX18" fmla="*/ 4319632 w 5580712"/>
                <a:gd name="connsiteY18" fmla="*/ 162560 h 4048195"/>
                <a:gd name="connsiteX19" fmla="*/ 4634592 w 5580712"/>
                <a:gd name="connsiteY19" fmla="*/ 314960 h 4048195"/>
                <a:gd name="connsiteX20" fmla="*/ 4634592 w 5580712"/>
                <a:gd name="connsiteY20" fmla="*/ 314960 h 4048195"/>
                <a:gd name="connsiteX21" fmla="*/ 4868272 w 5580712"/>
                <a:gd name="connsiteY21" fmla="*/ 426720 h 4048195"/>
                <a:gd name="connsiteX22" fmla="*/ 5244192 w 5580712"/>
                <a:gd name="connsiteY22" fmla="*/ 609600 h 4048195"/>
                <a:gd name="connsiteX23" fmla="*/ 5427072 w 5580712"/>
                <a:gd name="connsiteY23" fmla="*/ 772160 h 4048195"/>
                <a:gd name="connsiteX24" fmla="*/ 5538832 w 5580712"/>
                <a:gd name="connsiteY24" fmla="*/ 914400 h 4048195"/>
                <a:gd name="connsiteX25" fmla="*/ 5579472 w 5580712"/>
                <a:gd name="connsiteY25" fmla="*/ 1107440 h 4048195"/>
                <a:gd name="connsiteX26" fmla="*/ 5498192 w 5580712"/>
                <a:gd name="connsiteY26" fmla="*/ 1300480 h 4048195"/>
                <a:gd name="connsiteX27" fmla="*/ 5315312 w 5580712"/>
                <a:gd name="connsiteY27" fmla="*/ 1422400 h 4048195"/>
                <a:gd name="connsiteX28" fmla="*/ 5091792 w 5580712"/>
                <a:gd name="connsiteY28" fmla="*/ 1452880 h 4048195"/>
                <a:gd name="connsiteX29" fmla="*/ 4868272 w 5580712"/>
                <a:gd name="connsiteY29" fmla="*/ 1513840 h 4048195"/>
                <a:gd name="connsiteX30" fmla="*/ 4685392 w 5580712"/>
                <a:gd name="connsiteY30" fmla="*/ 1513840 h 4048195"/>
                <a:gd name="connsiteX31" fmla="*/ 4482192 w 5580712"/>
                <a:gd name="connsiteY31" fmla="*/ 1513840 h 4048195"/>
                <a:gd name="connsiteX32" fmla="*/ 4258672 w 5580712"/>
                <a:gd name="connsiteY32" fmla="*/ 1554480 h 4048195"/>
                <a:gd name="connsiteX33" fmla="*/ 4065632 w 5580712"/>
                <a:gd name="connsiteY33" fmla="*/ 1645920 h 4048195"/>
                <a:gd name="connsiteX34" fmla="*/ 3903072 w 5580712"/>
                <a:gd name="connsiteY34" fmla="*/ 1818640 h 4048195"/>
                <a:gd name="connsiteX35" fmla="*/ 3699872 w 5580712"/>
                <a:gd name="connsiteY35" fmla="*/ 1899920 h 4048195"/>
                <a:gd name="connsiteX36" fmla="*/ 3456032 w 5580712"/>
                <a:gd name="connsiteY36" fmla="*/ 1991360 h 4048195"/>
                <a:gd name="connsiteX37" fmla="*/ 3273152 w 5580712"/>
                <a:gd name="connsiteY37" fmla="*/ 2021840 h 4048195"/>
                <a:gd name="connsiteX38" fmla="*/ 3059792 w 5580712"/>
                <a:gd name="connsiteY38" fmla="*/ 2072640 h 4048195"/>
                <a:gd name="connsiteX39" fmla="*/ 2897232 w 5580712"/>
                <a:gd name="connsiteY39" fmla="*/ 2042160 h 4048195"/>
                <a:gd name="connsiteX40" fmla="*/ 2775312 w 5580712"/>
                <a:gd name="connsiteY40" fmla="*/ 2001520 h 4048195"/>
                <a:gd name="connsiteX41" fmla="*/ 2937872 w 5580712"/>
                <a:gd name="connsiteY41" fmla="*/ 2113280 h 4048195"/>
                <a:gd name="connsiteX42" fmla="*/ 3008992 w 5580712"/>
                <a:gd name="connsiteY42" fmla="*/ 2184400 h 4048195"/>
                <a:gd name="connsiteX43" fmla="*/ 3008992 w 5580712"/>
                <a:gd name="connsiteY43" fmla="*/ 2306320 h 4048195"/>
                <a:gd name="connsiteX44" fmla="*/ 2927712 w 5580712"/>
                <a:gd name="connsiteY44" fmla="*/ 2458720 h 4048195"/>
                <a:gd name="connsiteX45" fmla="*/ 2815952 w 5580712"/>
                <a:gd name="connsiteY45" fmla="*/ 2570480 h 4048195"/>
                <a:gd name="connsiteX46" fmla="*/ 2683872 w 5580712"/>
                <a:gd name="connsiteY46" fmla="*/ 2600960 h 4048195"/>
                <a:gd name="connsiteX47" fmla="*/ 2409552 w 5580712"/>
                <a:gd name="connsiteY47" fmla="*/ 2672080 h 4048195"/>
                <a:gd name="connsiteX48" fmla="*/ 2257152 w 5580712"/>
                <a:gd name="connsiteY48" fmla="*/ 2682240 h 4048195"/>
                <a:gd name="connsiteX49" fmla="*/ 2175872 w 5580712"/>
                <a:gd name="connsiteY49" fmla="*/ 2794000 h 4048195"/>
                <a:gd name="connsiteX50" fmla="*/ 2186032 w 5580712"/>
                <a:gd name="connsiteY50" fmla="*/ 2966720 h 4048195"/>
                <a:gd name="connsiteX51" fmla="*/ 2186032 w 5580712"/>
                <a:gd name="connsiteY51" fmla="*/ 3180080 h 4048195"/>
                <a:gd name="connsiteX52" fmla="*/ 2175872 w 5580712"/>
                <a:gd name="connsiteY52" fmla="*/ 3393440 h 4048195"/>
                <a:gd name="connsiteX53" fmla="*/ 2125072 w 5580712"/>
                <a:gd name="connsiteY53" fmla="*/ 3576320 h 4048195"/>
                <a:gd name="connsiteX54" fmla="*/ 2043792 w 5580712"/>
                <a:gd name="connsiteY54" fmla="*/ 3759200 h 4048195"/>
                <a:gd name="connsiteX55" fmla="*/ 1871072 w 5580712"/>
                <a:gd name="connsiteY55" fmla="*/ 3881120 h 4048195"/>
                <a:gd name="connsiteX56" fmla="*/ 1708512 w 5580712"/>
                <a:gd name="connsiteY56" fmla="*/ 3982720 h 4048195"/>
                <a:gd name="connsiteX57" fmla="*/ 1474832 w 5580712"/>
                <a:gd name="connsiteY57" fmla="*/ 4043680 h 4048195"/>
                <a:gd name="connsiteX58" fmla="*/ 1220832 w 5580712"/>
                <a:gd name="connsiteY58" fmla="*/ 4043680 h 4048195"/>
                <a:gd name="connsiteX59" fmla="*/ 1088752 w 5580712"/>
                <a:gd name="connsiteY59" fmla="*/ 4043680 h 4048195"/>
                <a:gd name="connsiteX60" fmla="*/ 1037952 w 5580712"/>
                <a:gd name="connsiteY60" fmla="*/ 4043680 h 40481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</a:cxnLst>
              <a:rect l="l" t="t" r="r" b="b"/>
              <a:pathLst>
                <a:path w="5580712" h="4048195">
                  <a:moveTo>
                    <a:pt x="1037952" y="4043680"/>
                  </a:moveTo>
                  <a:cubicBezTo>
                    <a:pt x="862692" y="4017433"/>
                    <a:pt x="687432" y="3991187"/>
                    <a:pt x="570592" y="3921760"/>
                  </a:cubicBezTo>
                  <a:cubicBezTo>
                    <a:pt x="453752" y="3852333"/>
                    <a:pt x="406339" y="3732107"/>
                    <a:pt x="336912" y="3627120"/>
                  </a:cubicBezTo>
                  <a:cubicBezTo>
                    <a:pt x="267485" y="3522133"/>
                    <a:pt x="201445" y="3410373"/>
                    <a:pt x="154032" y="3291840"/>
                  </a:cubicBezTo>
                  <a:cubicBezTo>
                    <a:pt x="106619" y="3173307"/>
                    <a:pt x="77832" y="3044613"/>
                    <a:pt x="52432" y="2915920"/>
                  </a:cubicBezTo>
                  <a:cubicBezTo>
                    <a:pt x="27032" y="2787227"/>
                    <a:pt x="6712" y="2638213"/>
                    <a:pt x="1632" y="2519680"/>
                  </a:cubicBezTo>
                  <a:cubicBezTo>
                    <a:pt x="-3448" y="2401147"/>
                    <a:pt x="3325" y="2319867"/>
                    <a:pt x="21952" y="2204720"/>
                  </a:cubicBezTo>
                  <a:cubicBezTo>
                    <a:pt x="40579" y="2089573"/>
                    <a:pt x="67672" y="1964267"/>
                    <a:pt x="113392" y="1828800"/>
                  </a:cubicBezTo>
                  <a:cubicBezTo>
                    <a:pt x="159112" y="1693333"/>
                    <a:pt x="235312" y="1515533"/>
                    <a:pt x="296272" y="1391920"/>
                  </a:cubicBezTo>
                  <a:cubicBezTo>
                    <a:pt x="357232" y="1268307"/>
                    <a:pt x="392792" y="1193800"/>
                    <a:pt x="479152" y="1087120"/>
                  </a:cubicBezTo>
                  <a:cubicBezTo>
                    <a:pt x="565512" y="980440"/>
                    <a:pt x="700979" y="853440"/>
                    <a:pt x="814432" y="751840"/>
                  </a:cubicBezTo>
                  <a:cubicBezTo>
                    <a:pt x="927885" y="650240"/>
                    <a:pt x="1037952" y="558800"/>
                    <a:pt x="1159872" y="477520"/>
                  </a:cubicBezTo>
                  <a:cubicBezTo>
                    <a:pt x="1281792" y="396240"/>
                    <a:pt x="1408792" y="323427"/>
                    <a:pt x="1545952" y="264160"/>
                  </a:cubicBezTo>
                  <a:cubicBezTo>
                    <a:pt x="1683112" y="204893"/>
                    <a:pt x="1855832" y="159173"/>
                    <a:pt x="1982832" y="121920"/>
                  </a:cubicBezTo>
                  <a:cubicBezTo>
                    <a:pt x="2109832" y="84667"/>
                    <a:pt x="2148779" y="60960"/>
                    <a:pt x="2307952" y="40640"/>
                  </a:cubicBezTo>
                  <a:cubicBezTo>
                    <a:pt x="2467125" y="20320"/>
                    <a:pt x="2761765" y="0"/>
                    <a:pt x="2937872" y="0"/>
                  </a:cubicBezTo>
                  <a:cubicBezTo>
                    <a:pt x="3113979" y="0"/>
                    <a:pt x="3364592" y="40640"/>
                    <a:pt x="3364592" y="40640"/>
                  </a:cubicBezTo>
                  <a:cubicBezTo>
                    <a:pt x="3522072" y="55880"/>
                    <a:pt x="3723579" y="71120"/>
                    <a:pt x="3882752" y="91440"/>
                  </a:cubicBezTo>
                  <a:cubicBezTo>
                    <a:pt x="4041925" y="111760"/>
                    <a:pt x="4194325" y="125307"/>
                    <a:pt x="4319632" y="162560"/>
                  </a:cubicBezTo>
                  <a:cubicBezTo>
                    <a:pt x="4444939" y="199813"/>
                    <a:pt x="4634592" y="314960"/>
                    <a:pt x="4634592" y="314960"/>
                  </a:cubicBezTo>
                  <a:lnTo>
                    <a:pt x="4634592" y="314960"/>
                  </a:lnTo>
                  <a:lnTo>
                    <a:pt x="4868272" y="426720"/>
                  </a:lnTo>
                  <a:cubicBezTo>
                    <a:pt x="4969872" y="475827"/>
                    <a:pt x="5151059" y="552027"/>
                    <a:pt x="5244192" y="609600"/>
                  </a:cubicBezTo>
                  <a:cubicBezTo>
                    <a:pt x="5337325" y="667173"/>
                    <a:pt x="5377965" y="721360"/>
                    <a:pt x="5427072" y="772160"/>
                  </a:cubicBezTo>
                  <a:cubicBezTo>
                    <a:pt x="5476179" y="822960"/>
                    <a:pt x="5513432" y="858520"/>
                    <a:pt x="5538832" y="914400"/>
                  </a:cubicBezTo>
                  <a:cubicBezTo>
                    <a:pt x="5564232" y="970280"/>
                    <a:pt x="5586245" y="1043093"/>
                    <a:pt x="5579472" y="1107440"/>
                  </a:cubicBezTo>
                  <a:cubicBezTo>
                    <a:pt x="5572699" y="1171787"/>
                    <a:pt x="5542219" y="1247987"/>
                    <a:pt x="5498192" y="1300480"/>
                  </a:cubicBezTo>
                  <a:cubicBezTo>
                    <a:pt x="5454165" y="1352973"/>
                    <a:pt x="5383045" y="1397000"/>
                    <a:pt x="5315312" y="1422400"/>
                  </a:cubicBezTo>
                  <a:cubicBezTo>
                    <a:pt x="5247579" y="1447800"/>
                    <a:pt x="5166299" y="1437640"/>
                    <a:pt x="5091792" y="1452880"/>
                  </a:cubicBezTo>
                  <a:cubicBezTo>
                    <a:pt x="5017285" y="1468120"/>
                    <a:pt x="4936005" y="1503680"/>
                    <a:pt x="4868272" y="1513840"/>
                  </a:cubicBezTo>
                  <a:cubicBezTo>
                    <a:pt x="4800539" y="1524000"/>
                    <a:pt x="4685392" y="1513840"/>
                    <a:pt x="4685392" y="1513840"/>
                  </a:cubicBezTo>
                  <a:cubicBezTo>
                    <a:pt x="4621045" y="1513840"/>
                    <a:pt x="4553312" y="1507067"/>
                    <a:pt x="4482192" y="1513840"/>
                  </a:cubicBezTo>
                  <a:cubicBezTo>
                    <a:pt x="4411072" y="1520613"/>
                    <a:pt x="4328099" y="1532467"/>
                    <a:pt x="4258672" y="1554480"/>
                  </a:cubicBezTo>
                  <a:cubicBezTo>
                    <a:pt x="4189245" y="1576493"/>
                    <a:pt x="4124899" y="1601893"/>
                    <a:pt x="4065632" y="1645920"/>
                  </a:cubicBezTo>
                  <a:cubicBezTo>
                    <a:pt x="4006365" y="1689947"/>
                    <a:pt x="3964032" y="1776307"/>
                    <a:pt x="3903072" y="1818640"/>
                  </a:cubicBezTo>
                  <a:cubicBezTo>
                    <a:pt x="3842112" y="1860973"/>
                    <a:pt x="3699872" y="1899920"/>
                    <a:pt x="3699872" y="1899920"/>
                  </a:cubicBezTo>
                  <a:cubicBezTo>
                    <a:pt x="3625365" y="1928707"/>
                    <a:pt x="3527152" y="1971040"/>
                    <a:pt x="3456032" y="1991360"/>
                  </a:cubicBezTo>
                  <a:cubicBezTo>
                    <a:pt x="3384912" y="2011680"/>
                    <a:pt x="3339192" y="2008293"/>
                    <a:pt x="3273152" y="2021840"/>
                  </a:cubicBezTo>
                  <a:cubicBezTo>
                    <a:pt x="3207112" y="2035387"/>
                    <a:pt x="3122445" y="2069253"/>
                    <a:pt x="3059792" y="2072640"/>
                  </a:cubicBezTo>
                  <a:cubicBezTo>
                    <a:pt x="2997139" y="2076027"/>
                    <a:pt x="2944645" y="2054013"/>
                    <a:pt x="2897232" y="2042160"/>
                  </a:cubicBezTo>
                  <a:cubicBezTo>
                    <a:pt x="2849819" y="2030307"/>
                    <a:pt x="2768539" y="1989667"/>
                    <a:pt x="2775312" y="2001520"/>
                  </a:cubicBezTo>
                  <a:cubicBezTo>
                    <a:pt x="2782085" y="2013373"/>
                    <a:pt x="2898925" y="2082800"/>
                    <a:pt x="2937872" y="2113280"/>
                  </a:cubicBezTo>
                  <a:cubicBezTo>
                    <a:pt x="2976819" y="2143760"/>
                    <a:pt x="2997139" y="2152227"/>
                    <a:pt x="3008992" y="2184400"/>
                  </a:cubicBezTo>
                  <a:cubicBezTo>
                    <a:pt x="3020845" y="2216573"/>
                    <a:pt x="3022539" y="2260600"/>
                    <a:pt x="3008992" y="2306320"/>
                  </a:cubicBezTo>
                  <a:cubicBezTo>
                    <a:pt x="2995445" y="2352040"/>
                    <a:pt x="2959885" y="2414693"/>
                    <a:pt x="2927712" y="2458720"/>
                  </a:cubicBezTo>
                  <a:cubicBezTo>
                    <a:pt x="2895539" y="2502747"/>
                    <a:pt x="2856592" y="2546773"/>
                    <a:pt x="2815952" y="2570480"/>
                  </a:cubicBezTo>
                  <a:cubicBezTo>
                    <a:pt x="2775312" y="2594187"/>
                    <a:pt x="2683872" y="2600960"/>
                    <a:pt x="2683872" y="2600960"/>
                  </a:cubicBezTo>
                  <a:cubicBezTo>
                    <a:pt x="2616139" y="2617893"/>
                    <a:pt x="2480672" y="2658533"/>
                    <a:pt x="2409552" y="2672080"/>
                  </a:cubicBezTo>
                  <a:cubicBezTo>
                    <a:pt x="2338432" y="2685627"/>
                    <a:pt x="2296099" y="2661920"/>
                    <a:pt x="2257152" y="2682240"/>
                  </a:cubicBezTo>
                  <a:cubicBezTo>
                    <a:pt x="2218205" y="2702560"/>
                    <a:pt x="2187725" y="2746587"/>
                    <a:pt x="2175872" y="2794000"/>
                  </a:cubicBezTo>
                  <a:cubicBezTo>
                    <a:pt x="2164019" y="2841413"/>
                    <a:pt x="2184339" y="2902373"/>
                    <a:pt x="2186032" y="2966720"/>
                  </a:cubicBezTo>
                  <a:cubicBezTo>
                    <a:pt x="2187725" y="3031067"/>
                    <a:pt x="2187725" y="3108960"/>
                    <a:pt x="2186032" y="3180080"/>
                  </a:cubicBezTo>
                  <a:cubicBezTo>
                    <a:pt x="2184339" y="3251200"/>
                    <a:pt x="2186032" y="3327400"/>
                    <a:pt x="2175872" y="3393440"/>
                  </a:cubicBezTo>
                  <a:cubicBezTo>
                    <a:pt x="2165712" y="3459480"/>
                    <a:pt x="2147085" y="3515360"/>
                    <a:pt x="2125072" y="3576320"/>
                  </a:cubicBezTo>
                  <a:cubicBezTo>
                    <a:pt x="2103059" y="3637280"/>
                    <a:pt x="2086125" y="3708400"/>
                    <a:pt x="2043792" y="3759200"/>
                  </a:cubicBezTo>
                  <a:cubicBezTo>
                    <a:pt x="2001459" y="3810000"/>
                    <a:pt x="1926952" y="3843867"/>
                    <a:pt x="1871072" y="3881120"/>
                  </a:cubicBezTo>
                  <a:cubicBezTo>
                    <a:pt x="1815192" y="3918373"/>
                    <a:pt x="1774552" y="3955627"/>
                    <a:pt x="1708512" y="3982720"/>
                  </a:cubicBezTo>
                  <a:cubicBezTo>
                    <a:pt x="1642472" y="4009813"/>
                    <a:pt x="1556112" y="4033520"/>
                    <a:pt x="1474832" y="4043680"/>
                  </a:cubicBezTo>
                  <a:cubicBezTo>
                    <a:pt x="1393552" y="4053840"/>
                    <a:pt x="1220832" y="4043680"/>
                    <a:pt x="1220832" y="4043680"/>
                  </a:cubicBezTo>
                  <a:lnTo>
                    <a:pt x="1088752" y="4043680"/>
                  </a:lnTo>
                  <a:lnTo>
                    <a:pt x="1037952" y="4043680"/>
                  </a:ln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楕円 12">
              <a:extLst>
                <a:ext uri="{FF2B5EF4-FFF2-40B4-BE49-F238E27FC236}">
                  <a16:creationId xmlns:a16="http://schemas.microsoft.com/office/drawing/2014/main" id="{43A83E4E-70CA-87E2-F66B-4270BC4CE63D}"/>
                </a:ext>
              </a:extLst>
            </p:cNvPr>
            <p:cNvSpPr/>
            <p:nvPr/>
          </p:nvSpPr>
          <p:spPr>
            <a:xfrm>
              <a:off x="5009324" y="2113655"/>
              <a:ext cx="730369" cy="762001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12" name="フリーフォーム: 図形 11">
            <a:extLst>
              <a:ext uri="{FF2B5EF4-FFF2-40B4-BE49-F238E27FC236}">
                <a16:creationId xmlns:a16="http://schemas.microsoft.com/office/drawing/2014/main" id="{ECC7B64C-0E85-1577-147F-8DDE744032E5}"/>
              </a:ext>
            </a:extLst>
          </p:cNvPr>
          <p:cNvSpPr/>
          <p:nvPr/>
        </p:nvSpPr>
        <p:spPr>
          <a:xfrm rot="422949">
            <a:off x="4134404" y="4669493"/>
            <a:ext cx="524709" cy="569976"/>
          </a:xfrm>
          <a:custGeom>
            <a:avLst/>
            <a:gdLst>
              <a:gd name="connsiteX0" fmla="*/ 393752 w 1199329"/>
              <a:gd name="connsiteY0" fmla="*/ 1315155 h 1315775"/>
              <a:gd name="connsiteX1" fmla="*/ 190552 w 1199329"/>
              <a:gd name="connsiteY1" fmla="*/ 1223715 h 1315775"/>
              <a:gd name="connsiteX2" fmla="*/ 78792 w 1199329"/>
              <a:gd name="connsiteY2" fmla="*/ 1040835 h 1315775"/>
              <a:gd name="connsiteX3" fmla="*/ 7672 w 1199329"/>
              <a:gd name="connsiteY3" fmla="*/ 847795 h 1315775"/>
              <a:gd name="connsiteX4" fmla="*/ 7672 w 1199329"/>
              <a:gd name="connsiteY4" fmla="*/ 664915 h 1315775"/>
              <a:gd name="connsiteX5" fmla="*/ 58472 w 1199329"/>
              <a:gd name="connsiteY5" fmla="*/ 542995 h 1315775"/>
              <a:gd name="connsiteX6" fmla="*/ 58472 w 1199329"/>
              <a:gd name="connsiteY6" fmla="*/ 390595 h 1315775"/>
              <a:gd name="connsiteX7" fmla="*/ 58472 w 1199329"/>
              <a:gd name="connsiteY7" fmla="*/ 309315 h 1315775"/>
              <a:gd name="connsiteX8" fmla="*/ 149912 w 1199329"/>
              <a:gd name="connsiteY8" fmla="*/ 156915 h 1315775"/>
              <a:gd name="connsiteX9" fmla="*/ 210872 w 1199329"/>
              <a:gd name="connsiteY9" fmla="*/ 65475 h 1315775"/>
              <a:gd name="connsiteX10" fmla="*/ 332792 w 1199329"/>
              <a:gd name="connsiteY10" fmla="*/ 55315 h 1315775"/>
              <a:gd name="connsiteX11" fmla="*/ 485192 w 1199329"/>
              <a:gd name="connsiteY11" fmla="*/ 4515 h 1315775"/>
              <a:gd name="connsiteX12" fmla="*/ 617272 w 1199329"/>
              <a:gd name="connsiteY12" fmla="*/ 4515 h 1315775"/>
              <a:gd name="connsiteX13" fmla="*/ 698552 w 1199329"/>
              <a:gd name="connsiteY13" fmla="*/ 4515 h 1315775"/>
              <a:gd name="connsiteX14" fmla="*/ 850952 w 1199329"/>
              <a:gd name="connsiteY14" fmla="*/ 65475 h 1315775"/>
              <a:gd name="connsiteX15" fmla="*/ 962712 w 1199329"/>
              <a:gd name="connsiteY15" fmla="*/ 177235 h 1315775"/>
              <a:gd name="connsiteX16" fmla="*/ 1013512 w 1199329"/>
              <a:gd name="connsiteY16" fmla="*/ 278835 h 1315775"/>
              <a:gd name="connsiteX17" fmla="*/ 1115112 w 1199329"/>
              <a:gd name="connsiteY17" fmla="*/ 339795 h 1315775"/>
              <a:gd name="connsiteX18" fmla="*/ 1196392 w 1199329"/>
              <a:gd name="connsiteY18" fmla="*/ 482035 h 1315775"/>
              <a:gd name="connsiteX19" fmla="*/ 1155752 w 1199329"/>
              <a:gd name="connsiteY19" fmla="*/ 593795 h 1315775"/>
              <a:gd name="connsiteX20" fmla="*/ 1186232 w 1199329"/>
              <a:gd name="connsiteY20" fmla="*/ 705555 h 1315775"/>
              <a:gd name="connsiteX21" fmla="*/ 1196392 w 1199329"/>
              <a:gd name="connsiteY21" fmla="*/ 857955 h 1315775"/>
              <a:gd name="connsiteX22" fmla="*/ 1135432 w 1199329"/>
              <a:gd name="connsiteY22" fmla="*/ 1010355 h 1315775"/>
              <a:gd name="connsiteX23" fmla="*/ 1023672 w 1199329"/>
              <a:gd name="connsiteY23" fmla="*/ 1111955 h 1315775"/>
              <a:gd name="connsiteX24" fmla="*/ 891592 w 1199329"/>
              <a:gd name="connsiteY24" fmla="*/ 1193235 h 1315775"/>
              <a:gd name="connsiteX25" fmla="*/ 749352 w 1199329"/>
              <a:gd name="connsiteY25" fmla="*/ 1264355 h 1315775"/>
              <a:gd name="connsiteX26" fmla="*/ 556312 w 1199329"/>
              <a:gd name="connsiteY26" fmla="*/ 1264355 h 1315775"/>
              <a:gd name="connsiteX27" fmla="*/ 393752 w 1199329"/>
              <a:gd name="connsiteY27" fmla="*/ 1315155 h 131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</a:cxnLst>
            <a:rect l="l" t="t" r="r" b="b"/>
            <a:pathLst>
              <a:path w="1199329" h="1315775">
                <a:moveTo>
                  <a:pt x="393752" y="1315155"/>
                </a:moveTo>
                <a:cubicBezTo>
                  <a:pt x="332792" y="1308382"/>
                  <a:pt x="243045" y="1269435"/>
                  <a:pt x="190552" y="1223715"/>
                </a:cubicBezTo>
                <a:cubicBezTo>
                  <a:pt x="138059" y="1177995"/>
                  <a:pt x="109272" y="1103488"/>
                  <a:pt x="78792" y="1040835"/>
                </a:cubicBezTo>
                <a:cubicBezTo>
                  <a:pt x="48312" y="978182"/>
                  <a:pt x="19525" y="910448"/>
                  <a:pt x="7672" y="847795"/>
                </a:cubicBezTo>
                <a:cubicBezTo>
                  <a:pt x="-4181" y="785142"/>
                  <a:pt x="-795" y="715715"/>
                  <a:pt x="7672" y="664915"/>
                </a:cubicBezTo>
                <a:cubicBezTo>
                  <a:pt x="16139" y="614115"/>
                  <a:pt x="50005" y="588715"/>
                  <a:pt x="58472" y="542995"/>
                </a:cubicBezTo>
                <a:cubicBezTo>
                  <a:pt x="66939" y="497275"/>
                  <a:pt x="58472" y="390595"/>
                  <a:pt x="58472" y="390595"/>
                </a:cubicBezTo>
                <a:cubicBezTo>
                  <a:pt x="58472" y="351648"/>
                  <a:pt x="43232" y="348262"/>
                  <a:pt x="58472" y="309315"/>
                </a:cubicBezTo>
                <a:cubicBezTo>
                  <a:pt x="73712" y="270368"/>
                  <a:pt x="124512" y="197555"/>
                  <a:pt x="149912" y="156915"/>
                </a:cubicBezTo>
                <a:cubicBezTo>
                  <a:pt x="175312" y="116275"/>
                  <a:pt x="180392" y="82408"/>
                  <a:pt x="210872" y="65475"/>
                </a:cubicBezTo>
                <a:cubicBezTo>
                  <a:pt x="241352" y="48542"/>
                  <a:pt x="287072" y="65475"/>
                  <a:pt x="332792" y="55315"/>
                </a:cubicBezTo>
                <a:cubicBezTo>
                  <a:pt x="378512" y="45155"/>
                  <a:pt x="437779" y="12982"/>
                  <a:pt x="485192" y="4515"/>
                </a:cubicBezTo>
                <a:cubicBezTo>
                  <a:pt x="532605" y="-3952"/>
                  <a:pt x="617272" y="4515"/>
                  <a:pt x="617272" y="4515"/>
                </a:cubicBezTo>
                <a:cubicBezTo>
                  <a:pt x="652832" y="4515"/>
                  <a:pt x="659605" y="-5645"/>
                  <a:pt x="698552" y="4515"/>
                </a:cubicBezTo>
                <a:cubicBezTo>
                  <a:pt x="737499" y="14675"/>
                  <a:pt x="806925" y="36688"/>
                  <a:pt x="850952" y="65475"/>
                </a:cubicBezTo>
                <a:cubicBezTo>
                  <a:pt x="894979" y="94262"/>
                  <a:pt x="935619" y="141675"/>
                  <a:pt x="962712" y="177235"/>
                </a:cubicBezTo>
                <a:cubicBezTo>
                  <a:pt x="989805" y="212795"/>
                  <a:pt x="988112" y="251742"/>
                  <a:pt x="1013512" y="278835"/>
                </a:cubicBezTo>
                <a:cubicBezTo>
                  <a:pt x="1038912" y="305928"/>
                  <a:pt x="1084632" y="305928"/>
                  <a:pt x="1115112" y="339795"/>
                </a:cubicBezTo>
                <a:cubicBezTo>
                  <a:pt x="1145592" y="373662"/>
                  <a:pt x="1189619" y="439702"/>
                  <a:pt x="1196392" y="482035"/>
                </a:cubicBezTo>
                <a:cubicBezTo>
                  <a:pt x="1203165" y="524368"/>
                  <a:pt x="1157445" y="556542"/>
                  <a:pt x="1155752" y="593795"/>
                </a:cubicBezTo>
                <a:cubicBezTo>
                  <a:pt x="1154059" y="631048"/>
                  <a:pt x="1179459" y="661528"/>
                  <a:pt x="1186232" y="705555"/>
                </a:cubicBezTo>
                <a:cubicBezTo>
                  <a:pt x="1193005" y="749582"/>
                  <a:pt x="1204859" y="807155"/>
                  <a:pt x="1196392" y="857955"/>
                </a:cubicBezTo>
                <a:cubicBezTo>
                  <a:pt x="1187925" y="908755"/>
                  <a:pt x="1164219" y="968022"/>
                  <a:pt x="1135432" y="1010355"/>
                </a:cubicBezTo>
                <a:cubicBezTo>
                  <a:pt x="1106645" y="1052688"/>
                  <a:pt x="1064312" y="1081475"/>
                  <a:pt x="1023672" y="1111955"/>
                </a:cubicBezTo>
                <a:cubicBezTo>
                  <a:pt x="983032" y="1142435"/>
                  <a:pt x="937312" y="1167835"/>
                  <a:pt x="891592" y="1193235"/>
                </a:cubicBezTo>
                <a:cubicBezTo>
                  <a:pt x="845872" y="1218635"/>
                  <a:pt x="805232" y="1252502"/>
                  <a:pt x="749352" y="1264355"/>
                </a:cubicBezTo>
                <a:cubicBezTo>
                  <a:pt x="693472" y="1276208"/>
                  <a:pt x="610499" y="1257582"/>
                  <a:pt x="556312" y="1264355"/>
                </a:cubicBezTo>
                <a:cubicBezTo>
                  <a:pt x="502125" y="1271128"/>
                  <a:pt x="454712" y="1321928"/>
                  <a:pt x="393752" y="1315155"/>
                </a:cubicBezTo>
                <a:close/>
              </a:path>
            </a:pathLst>
          </a:cu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楕円 14">
            <a:extLst>
              <a:ext uri="{FF2B5EF4-FFF2-40B4-BE49-F238E27FC236}">
                <a16:creationId xmlns:a16="http://schemas.microsoft.com/office/drawing/2014/main" id="{1F85F3BD-CFB9-06DB-5707-0F02C50745E6}"/>
              </a:ext>
            </a:extLst>
          </p:cNvPr>
          <p:cNvSpPr/>
          <p:nvPr/>
        </p:nvSpPr>
        <p:spPr>
          <a:xfrm>
            <a:off x="3778351" y="4455636"/>
            <a:ext cx="944880" cy="946890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D98030EB-5EF2-346E-ADF0-172395956B28}"/>
              </a:ext>
            </a:extLst>
          </p:cNvPr>
          <p:cNvCxnSpPr/>
          <p:nvPr/>
        </p:nvCxnSpPr>
        <p:spPr>
          <a:xfrm flipV="1">
            <a:off x="4007836" y="2464396"/>
            <a:ext cx="491613" cy="351503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A0C2096A-F90C-1C5E-14C9-B63008B5C7AD}"/>
              </a:ext>
            </a:extLst>
          </p:cNvPr>
          <p:cNvCxnSpPr>
            <a:cxnSpLocks/>
          </p:cNvCxnSpPr>
          <p:nvPr/>
        </p:nvCxnSpPr>
        <p:spPr>
          <a:xfrm>
            <a:off x="4016861" y="4115229"/>
            <a:ext cx="491613" cy="391207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01E2118-ABAC-FAD1-9B4E-07FF4F10C64E}"/>
              </a:ext>
            </a:extLst>
          </p:cNvPr>
          <p:cNvSpPr txBox="1"/>
          <p:nvPr/>
        </p:nvSpPr>
        <p:spPr>
          <a:xfrm>
            <a:off x="5458275" y="698448"/>
            <a:ext cx="69487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2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CIRT</a:t>
            </a:r>
            <a:endParaRPr kumimoji="1" lang="ja-JP" altLang="en-US" sz="22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E8ED477-4D9E-6948-5D57-AD8DDEB385B1}"/>
              </a:ext>
            </a:extLst>
          </p:cNvPr>
          <p:cNvSpPr txBox="1"/>
          <p:nvPr/>
        </p:nvSpPr>
        <p:spPr>
          <a:xfrm>
            <a:off x="5064797" y="3627655"/>
            <a:ext cx="172271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200" dirty="0">
                <a:solidFill>
                  <a:srgbClr val="000000"/>
                </a:solidFill>
                <a:latin typeface="Calibri" panose="020F0502020204030204" pitchFamily="34" charset="0"/>
                <a:ea typeface="ＭＳ Ｐゴシック" panose="020B0600070205080204" pitchFamily="50" charset="-128"/>
              </a:rPr>
              <a:t>H</a:t>
            </a:r>
            <a:r>
              <a:rPr lang="en-US" altLang="ja-JP" sz="2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epatectomy</a:t>
            </a:r>
            <a:endParaRPr kumimoji="1" lang="ja-JP" altLang="en-US" sz="22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D8D29F3-96BC-EE64-5327-1E4EF66A8B7E}"/>
              </a:ext>
            </a:extLst>
          </p:cNvPr>
          <p:cNvSpPr txBox="1"/>
          <p:nvPr/>
        </p:nvSpPr>
        <p:spPr>
          <a:xfrm>
            <a:off x="1110528" y="1597200"/>
            <a:ext cx="282962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2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HCC measuring </a:t>
            </a:r>
            <a:r>
              <a:rPr lang="ja-JP" altLang="ja-JP" sz="2200" kern="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en-PH" altLang="ja-JP" sz="22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≥</a:t>
            </a:r>
            <a:r>
              <a:rPr lang="en-PH" altLang="ja-JP" sz="22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4 cm</a:t>
            </a:r>
            <a:r>
              <a:rPr lang="ja-JP" altLang="en-US" sz="22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</a:t>
            </a:r>
            <a:endParaRPr lang="en-US" altLang="ja-JP" sz="22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AD9AF7A9-B662-3020-4592-E5D4181490C5}"/>
              </a:ext>
            </a:extLst>
          </p:cNvPr>
          <p:cNvGrpSpPr/>
          <p:nvPr/>
        </p:nvGrpSpPr>
        <p:grpSpPr>
          <a:xfrm>
            <a:off x="8307100" y="1250484"/>
            <a:ext cx="2278753" cy="1746733"/>
            <a:chOff x="4965276" y="1481077"/>
            <a:chExt cx="2278753" cy="1746733"/>
          </a:xfrm>
        </p:grpSpPr>
        <p:sp>
          <p:nvSpPr>
            <p:cNvPr id="31" name="フリーフォーム: 図形 30">
              <a:extLst>
                <a:ext uri="{FF2B5EF4-FFF2-40B4-BE49-F238E27FC236}">
                  <a16:creationId xmlns:a16="http://schemas.microsoft.com/office/drawing/2014/main" id="{267F5C29-3A99-4967-17F4-5548A8BBEDE0}"/>
                </a:ext>
              </a:extLst>
            </p:cNvPr>
            <p:cNvSpPr/>
            <p:nvPr/>
          </p:nvSpPr>
          <p:spPr>
            <a:xfrm>
              <a:off x="4965276" y="1481077"/>
              <a:ext cx="2278753" cy="1746733"/>
            </a:xfrm>
            <a:custGeom>
              <a:avLst/>
              <a:gdLst>
                <a:gd name="connsiteX0" fmla="*/ 1037952 w 5580712"/>
                <a:gd name="connsiteY0" fmla="*/ 4043680 h 4048195"/>
                <a:gd name="connsiteX1" fmla="*/ 570592 w 5580712"/>
                <a:gd name="connsiteY1" fmla="*/ 3921760 h 4048195"/>
                <a:gd name="connsiteX2" fmla="*/ 336912 w 5580712"/>
                <a:gd name="connsiteY2" fmla="*/ 3627120 h 4048195"/>
                <a:gd name="connsiteX3" fmla="*/ 154032 w 5580712"/>
                <a:gd name="connsiteY3" fmla="*/ 3291840 h 4048195"/>
                <a:gd name="connsiteX4" fmla="*/ 52432 w 5580712"/>
                <a:gd name="connsiteY4" fmla="*/ 2915920 h 4048195"/>
                <a:gd name="connsiteX5" fmla="*/ 1632 w 5580712"/>
                <a:gd name="connsiteY5" fmla="*/ 2519680 h 4048195"/>
                <a:gd name="connsiteX6" fmla="*/ 21952 w 5580712"/>
                <a:gd name="connsiteY6" fmla="*/ 2204720 h 4048195"/>
                <a:gd name="connsiteX7" fmla="*/ 113392 w 5580712"/>
                <a:gd name="connsiteY7" fmla="*/ 1828800 h 4048195"/>
                <a:gd name="connsiteX8" fmla="*/ 296272 w 5580712"/>
                <a:gd name="connsiteY8" fmla="*/ 1391920 h 4048195"/>
                <a:gd name="connsiteX9" fmla="*/ 479152 w 5580712"/>
                <a:gd name="connsiteY9" fmla="*/ 1087120 h 4048195"/>
                <a:gd name="connsiteX10" fmla="*/ 814432 w 5580712"/>
                <a:gd name="connsiteY10" fmla="*/ 751840 h 4048195"/>
                <a:gd name="connsiteX11" fmla="*/ 1159872 w 5580712"/>
                <a:gd name="connsiteY11" fmla="*/ 477520 h 4048195"/>
                <a:gd name="connsiteX12" fmla="*/ 1545952 w 5580712"/>
                <a:gd name="connsiteY12" fmla="*/ 264160 h 4048195"/>
                <a:gd name="connsiteX13" fmla="*/ 1982832 w 5580712"/>
                <a:gd name="connsiteY13" fmla="*/ 121920 h 4048195"/>
                <a:gd name="connsiteX14" fmla="*/ 2307952 w 5580712"/>
                <a:gd name="connsiteY14" fmla="*/ 40640 h 4048195"/>
                <a:gd name="connsiteX15" fmla="*/ 2937872 w 5580712"/>
                <a:gd name="connsiteY15" fmla="*/ 0 h 4048195"/>
                <a:gd name="connsiteX16" fmla="*/ 3364592 w 5580712"/>
                <a:gd name="connsiteY16" fmla="*/ 40640 h 4048195"/>
                <a:gd name="connsiteX17" fmla="*/ 3882752 w 5580712"/>
                <a:gd name="connsiteY17" fmla="*/ 91440 h 4048195"/>
                <a:gd name="connsiteX18" fmla="*/ 4319632 w 5580712"/>
                <a:gd name="connsiteY18" fmla="*/ 162560 h 4048195"/>
                <a:gd name="connsiteX19" fmla="*/ 4634592 w 5580712"/>
                <a:gd name="connsiteY19" fmla="*/ 314960 h 4048195"/>
                <a:gd name="connsiteX20" fmla="*/ 4634592 w 5580712"/>
                <a:gd name="connsiteY20" fmla="*/ 314960 h 4048195"/>
                <a:gd name="connsiteX21" fmla="*/ 4868272 w 5580712"/>
                <a:gd name="connsiteY21" fmla="*/ 426720 h 4048195"/>
                <a:gd name="connsiteX22" fmla="*/ 5244192 w 5580712"/>
                <a:gd name="connsiteY22" fmla="*/ 609600 h 4048195"/>
                <a:gd name="connsiteX23" fmla="*/ 5427072 w 5580712"/>
                <a:gd name="connsiteY23" fmla="*/ 772160 h 4048195"/>
                <a:gd name="connsiteX24" fmla="*/ 5538832 w 5580712"/>
                <a:gd name="connsiteY24" fmla="*/ 914400 h 4048195"/>
                <a:gd name="connsiteX25" fmla="*/ 5579472 w 5580712"/>
                <a:gd name="connsiteY25" fmla="*/ 1107440 h 4048195"/>
                <a:gd name="connsiteX26" fmla="*/ 5498192 w 5580712"/>
                <a:gd name="connsiteY26" fmla="*/ 1300480 h 4048195"/>
                <a:gd name="connsiteX27" fmla="*/ 5315312 w 5580712"/>
                <a:gd name="connsiteY27" fmla="*/ 1422400 h 4048195"/>
                <a:gd name="connsiteX28" fmla="*/ 5091792 w 5580712"/>
                <a:gd name="connsiteY28" fmla="*/ 1452880 h 4048195"/>
                <a:gd name="connsiteX29" fmla="*/ 4868272 w 5580712"/>
                <a:gd name="connsiteY29" fmla="*/ 1513840 h 4048195"/>
                <a:gd name="connsiteX30" fmla="*/ 4685392 w 5580712"/>
                <a:gd name="connsiteY30" fmla="*/ 1513840 h 4048195"/>
                <a:gd name="connsiteX31" fmla="*/ 4482192 w 5580712"/>
                <a:gd name="connsiteY31" fmla="*/ 1513840 h 4048195"/>
                <a:gd name="connsiteX32" fmla="*/ 4258672 w 5580712"/>
                <a:gd name="connsiteY32" fmla="*/ 1554480 h 4048195"/>
                <a:gd name="connsiteX33" fmla="*/ 4065632 w 5580712"/>
                <a:gd name="connsiteY33" fmla="*/ 1645920 h 4048195"/>
                <a:gd name="connsiteX34" fmla="*/ 3903072 w 5580712"/>
                <a:gd name="connsiteY34" fmla="*/ 1818640 h 4048195"/>
                <a:gd name="connsiteX35" fmla="*/ 3699872 w 5580712"/>
                <a:gd name="connsiteY35" fmla="*/ 1899920 h 4048195"/>
                <a:gd name="connsiteX36" fmla="*/ 3456032 w 5580712"/>
                <a:gd name="connsiteY36" fmla="*/ 1991360 h 4048195"/>
                <a:gd name="connsiteX37" fmla="*/ 3273152 w 5580712"/>
                <a:gd name="connsiteY37" fmla="*/ 2021840 h 4048195"/>
                <a:gd name="connsiteX38" fmla="*/ 3059792 w 5580712"/>
                <a:gd name="connsiteY38" fmla="*/ 2072640 h 4048195"/>
                <a:gd name="connsiteX39" fmla="*/ 2897232 w 5580712"/>
                <a:gd name="connsiteY39" fmla="*/ 2042160 h 4048195"/>
                <a:gd name="connsiteX40" fmla="*/ 2775312 w 5580712"/>
                <a:gd name="connsiteY40" fmla="*/ 2001520 h 4048195"/>
                <a:gd name="connsiteX41" fmla="*/ 2937872 w 5580712"/>
                <a:gd name="connsiteY41" fmla="*/ 2113280 h 4048195"/>
                <a:gd name="connsiteX42" fmla="*/ 3008992 w 5580712"/>
                <a:gd name="connsiteY42" fmla="*/ 2184400 h 4048195"/>
                <a:gd name="connsiteX43" fmla="*/ 3008992 w 5580712"/>
                <a:gd name="connsiteY43" fmla="*/ 2306320 h 4048195"/>
                <a:gd name="connsiteX44" fmla="*/ 2927712 w 5580712"/>
                <a:gd name="connsiteY44" fmla="*/ 2458720 h 4048195"/>
                <a:gd name="connsiteX45" fmla="*/ 2815952 w 5580712"/>
                <a:gd name="connsiteY45" fmla="*/ 2570480 h 4048195"/>
                <a:gd name="connsiteX46" fmla="*/ 2683872 w 5580712"/>
                <a:gd name="connsiteY46" fmla="*/ 2600960 h 4048195"/>
                <a:gd name="connsiteX47" fmla="*/ 2409552 w 5580712"/>
                <a:gd name="connsiteY47" fmla="*/ 2672080 h 4048195"/>
                <a:gd name="connsiteX48" fmla="*/ 2257152 w 5580712"/>
                <a:gd name="connsiteY48" fmla="*/ 2682240 h 4048195"/>
                <a:gd name="connsiteX49" fmla="*/ 2175872 w 5580712"/>
                <a:gd name="connsiteY49" fmla="*/ 2794000 h 4048195"/>
                <a:gd name="connsiteX50" fmla="*/ 2186032 w 5580712"/>
                <a:gd name="connsiteY50" fmla="*/ 2966720 h 4048195"/>
                <a:gd name="connsiteX51" fmla="*/ 2186032 w 5580712"/>
                <a:gd name="connsiteY51" fmla="*/ 3180080 h 4048195"/>
                <a:gd name="connsiteX52" fmla="*/ 2175872 w 5580712"/>
                <a:gd name="connsiteY52" fmla="*/ 3393440 h 4048195"/>
                <a:gd name="connsiteX53" fmla="*/ 2125072 w 5580712"/>
                <a:gd name="connsiteY53" fmla="*/ 3576320 h 4048195"/>
                <a:gd name="connsiteX54" fmla="*/ 2043792 w 5580712"/>
                <a:gd name="connsiteY54" fmla="*/ 3759200 h 4048195"/>
                <a:gd name="connsiteX55" fmla="*/ 1871072 w 5580712"/>
                <a:gd name="connsiteY55" fmla="*/ 3881120 h 4048195"/>
                <a:gd name="connsiteX56" fmla="*/ 1708512 w 5580712"/>
                <a:gd name="connsiteY56" fmla="*/ 3982720 h 4048195"/>
                <a:gd name="connsiteX57" fmla="*/ 1474832 w 5580712"/>
                <a:gd name="connsiteY57" fmla="*/ 4043680 h 4048195"/>
                <a:gd name="connsiteX58" fmla="*/ 1220832 w 5580712"/>
                <a:gd name="connsiteY58" fmla="*/ 4043680 h 4048195"/>
                <a:gd name="connsiteX59" fmla="*/ 1088752 w 5580712"/>
                <a:gd name="connsiteY59" fmla="*/ 4043680 h 4048195"/>
                <a:gd name="connsiteX60" fmla="*/ 1037952 w 5580712"/>
                <a:gd name="connsiteY60" fmla="*/ 4043680 h 40481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</a:cxnLst>
              <a:rect l="l" t="t" r="r" b="b"/>
              <a:pathLst>
                <a:path w="5580712" h="4048195">
                  <a:moveTo>
                    <a:pt x="1037952" y="4043680"/>
                  </a:moveTo>
                  <a:cubicBezTo>
                    <a:pt x="862692" y="4017433"/>
                    <a:pt x="687432" y="3991187"/>
                    <a:pt x="570592" y="3921760"/>
                  </a:cubicBezTo>
                  <a:cubicBezTo>
                    <a:pt x="453752" y="3852333"/>
                    <a:pt x="406339" y="3732107"/>
                    <a:pt x="336912" y="3627120"/>
                  </a:cubicBezTo>
                  <a:cubicBezTo>
                    <a:pt x="267485" y="3522133"/>
                    <a:pt x="201445" y="3410373"/>
                    <a:pt x="154032" y="3291840"/>
                  </a:cubicBezTo>
                  <a:cubicBezTo>
                    <a:pt x="106619" y="3173307"/>
                    <a:pt x="77832" y="3044613"/>
                    <a:pt x="52432" y="2915920"/>
                  </a:cubicBezTo>
                  <a:cubicBezTo>
                    <a:pt x="27032" y="2787227"/>
                    <a:pt x="6712" y="2638213"/>
                    <a:pt x="1632" y="2519680"/>
                  </a:cubicBezTo>
                  <a:cubicBezTo>
                    <a:pt x="-3448" y="2401147"/>
                    <a:pt x="3325" y="2319867"/>
                    <a:pt x="21952" y="2204720"/>
                  </a:cubicBezTo>
                  <a:cubicBezTo>
                    <a:pt x="40579" y="2089573"/>
                    <a:pt x="67672" y="1964267"/>
                    <a:pt x="113392" y="1828800"/>
                  </a:cubicBezTo>
                  <a:cubicBezTo>
                    <a:pt x="159112" y="1693333"/>
                    <a:pt x="235312" y="1515533"/>
                    <a:pt x="296272" y="1391920"/>
                  </a:cubicBezTo>
                  <a:cubicBezTo>
                    <a:pt x="357232" y="1268307"/>
                    <a:pt x="392792" y="1193800"/>
                    <a:pt x="479152" y="1087120"/>
                  </a:cubicBezTo>
                  <a:cubicBezTo>
                    <a:pt x="565512" y="980440"/>
                    <a:pt x="700979" y="853440"/>
                    <a:pt x="814432" y="751840"/>
                  </a:cubicBezTo>
                  <a:cubicBezTo>
                    <a:pt x="927885" y="650240"/>
                    <a:pt x="1037952" y="558800"/>
                    <a:pt x="1159872" y="477520"/>
                  </a:cubicBezTo>
                  <a:cubicBezTo>
                    <a:pt x="1281792" y="396240"/>
                    <a:pt x="1408792" y="323427"/>
                    <a:pt x="1545952" y="264160"/>
                  </a:cubicBezTo>
                  <a:cubicBezTo>
                    <a:pt x="1683112" y="204893"/>
                    <a:pt x="1855832" y="159173"/>
                    <a:pt x="1982832" y="121920"/>
                  </a:cubicBezTo>
                  <a:cubicBezTo>
                    <a:pt x="2109832" y="84667"/>
                    <a:pt x="2148779" y="60960"/>
                    <a:pt x="2307952" y="40640"/>
                  </a:cubicBezTo>
                  <a:cubicBezTo>
                    <a:pt x="2467125" y="20320"/>
                    <a:pt x="2761765" y="0"/>
                    <a:pt x="2937872" y="0"/>
                  </a:cubicBezTo>
                  <a:cubicBezTo>
                    <a:pt x="3113979" y="0"/>
                    <a:pt x="3364592" y="40640"/>
                    <a:pt x="3364592" y="40640"/>
                  </a:cubicBezTo>
                  <a:cubicBezTo>
                    <a:pt x="3522072" y="55880"/>
                    <a:pt x="3723579" y="71120"/>
                    <a:pt x="3882752" y="91440"/>
                  </a:cubicBezTo>
                  <a:cubicBezTo>
                    <a:pt x="4041925" y="111760"/>
                    <a:pt x="4194325" y="125307"/>
                    <a:pt x="4319632" y="162560"/>
                  </a:cubicBezTo>
                  <a:cubicBezTo>
                    <a:pt x="4444939" y="199813"/>
                    <a:pt x="4634592" y="314960"/>
                    <a:pt x="4634592" y="314960"/>
                  </a:cubicBezTo>
                  <a:lnTo>
                    <a:pt x="4634592" y="314960"/>
                  </a:lnTo>
                  <a:lnTo>
                    <a:pt x="4868272" y="426720"/>
                  </a:lnTo>
                  <a:cubicBezTo>
                    <a:pt x="4969872" y="475827"/>
                    <a:pt x="5151059" y="552027"/>
                    <a:pt x="5244192" y="609600"/>
                  </a:cubicBezTo>
                  <a:cubicBezTo>
                    <a:pt x="5337325" y="667173"/>
                    <a:pt x="5377965" y="721360"/>
                    <a:pt x="5427072" y="772160"/>
                  </a:cubicBezTo>
                  <a:cubicBezTo>
                    <a:pt x="5476179" y="822960"/>
                    <a:pt x="5513432" y="858520"/>
                    <a:pt x="5538832" y="914400"/>
                  </a:cubicBezTo>
                  <a:cubicBezTo>
                    <a:pt x="5564232" y="970280"/>
                    <a:pt x="5586245" y="1043093"/>
                    <a:pt x="5579472" y="1107440"/>
                  </a:cubicBezTo>
                  <a:cubicBezTo>
                    <a:pt x="5572699" y="1171787"/>
                    <a:pt x="5542219" y="1247987"/>
                    <a:pt x="5498192" y="1300480"/>
                  </a:cubicBezTo>
                  <a:cubicBezTo>
                    <a:pt x="5454165" y="1352973"/>
                    <a:pt x="5383045" y="1397000"/>
                    <a:pt x="5315312" y="1422400"/>
                  </a:cubicBezTo>
                  <a:cubicBezTo>
                    <a:pt x="5247579" y="1447800"/>
                    <a:pt x="5166299" y="1437640"/>
                    <a:pt x="5091792" y="1452880"/>
                  </a:cubicBezTo>
                  <a:cubicBezTo>
                    <a:pt x="5017285" y="1468120"/>
                    <a:pt x="4936005" y="1503680"/>
                    <a:pt x="4868272" y="1513840"/>
                  </a:cubicBezTo>
                  <a:cubicBezTo>
                    <a:pt x="4800539" y="1524000"/>
                    <a:pt x="4685392" y="1513840"/>
                    <a:pt x="4685392" y="1513840"/>
                  </a:cubicBezTo>
                  <a:cubicBezTo>
                    <a:pt x="4621045" y="1513840"/>
                    <a:pt x="4553312" y="1507067"/>
                    <a:pt x="4482192" y="1513840"/>
                  </a:cubicBezTo>
                  <a:cubicBezTo>
                    <a:pt x="4411072" y="1520613"/>
                    <a:pt x="4328099" y="1532467"/>
                    <a:pt x="4258672" y="1554480"/>
                  </a:cubicBezTo>
                  <a:cubicBezTo>
                    <a:pt x="4189245" y="1576493"/>
                    <a:pt x="4124899" y="1601893"/>
                    <a:pt x="4065632" y="1645920"/>
                  </a:cubicBezTo>
                  <a:cubicBezTo>
                    <a:pt x="4006365" y="1689947"/>
                    <a:pt x="3964032" y="1776307"/>
                    <a:pt x="3903072" y="1818640"/>
                  </a:cubicBezTo>
                  <a:cubicBezTo>
                    <a:pt x="3842112" y="1860973"/>
                    <a:pt x="3699872" y="1899920"/>
                    <a:pt x="3699872" y="1899920"/>
                  </a:cubicBezTo>
                  <a:cubicBezTo>
                    <a:pt x="3625365" y="1928707"/>
                    <a:pt x="3527152" y="1971040"/>
                    <a:pt x="3456032" y="1991360"/>
                  </a:cubicBezTo>
                  <a:cubicBezTo>
                    <a:pt x="3384912" y="2011680"/>
                    <a:pt x="3339192" y="2008293"/>
                    <a:pt x="3273152" y="2021840"/>
                  </a:cubicBezTo>
                  <a:cubicBezTo>
                    <a:pt x="3207112" y="2035387"/>
                    <a:pt x="3122445" y="2069253"/>
                    <a:pt x="3059792" y="2072640"/>
                  </a:cubicBezTo>
                  <a:cubicBezTo>
                    <a:pt x="2997139" y="2076027"/>
                    <a:pt x="2944645" y="2054013"/>
                    <a:pt x="2897232" y="2042160"/>
                  </a:cubicBezTo>
                  <a:cubicBezTo>
                    <a:pt x="2849819" y="2030307"/>
                    <a:pt x="2768539" y="1989667"/>
                    <a:pt x="2775312" y="2001520"/>
                  </a:cubicBezTo>
                  <a:cubicBezTo>
                    <a:pt x="2782085" y="2013373"/>
                    <a:pt x="2898925" y="2082800"/>
                    <a:pt x="2937872" y="2113280"/>
                  </a:cubicBezTo>
                  <a:cubicBezTo>
                    <a:pt x="2976819" y="2143760"/>
                    <a:pt x="2997139" y="2152227"/>
                    <a:pt x="3008992" y="2184400"/>
                  </a:cubicBezTo>
                  <a:cubicBezTo>
                    <a:pt x="3020845" y="2216573"/>
                    <a:pt x="3022539" y="2260600"/>
                    <a:pt x="3008992" y="2306320"/>
                  </a:cubicBezTo>
                  <a:cubicBezTo>
                    <a:pt x="2995445" y="2352040"/>
                    <a:pt x="2959885" y="2414693"/>
                    <a:pt x="2927712" y="2458720"/>
                  </a:cubicBezTo>
                  <a:cubicBezTo>
                    <a:pt x="2895539" y="2502747"/>
                    <a:pt x="2856592" y="2546773"/>
                    <a:pt x="2815952" y="2570480"/>
                  </a:cubicBezTo>
                  <a:cubicBezTo>
                    <a:pt x="2775312" y="2594187"/>
                    <a:pt x="2683872" y="2600960"/>
                    <a:pt x="2683872" y="2600960"/>
                  </a:cubicBezTo>
                  <a:cubicBezTo>
                    <a:pt x="2616139" y="2617893"/>
                    <a:pt x="2480672" y="2658533"/>
                    <a:pt x="2409552" y="2672080"/>
                  </a:cubicBezTo>
                  <a:cubicBezTo>
                    <a:pt x="2338432" y="2685627"/>
                    <a:pt x="2296099" y="2661920"/>
                    <a:pt x="2257152" y="2682240"/>
                  </a:cubicBezTo>
                  <a:cubicBezTo>
                    <a:pt x="2218205" y="2702560"/>
                    <a:pt x="2187725" y="2746587"/>
                    <a:pt x="2175872" y="2794000"/>
                  </a:cubicBezTo>
                  <a:cubicBezTo>
                    <a:pt x="2164019" y="2841413"/>
                    <a:pt x="2184339" y="2902373"/>
                    <a:pt x="2186032" y="2966720"/>
                  </a:cubicBezTo>
                  <a:cubicBezTo>
                    <a:pt x="2187725" y="3031067"/>
                    <a:pt x="2187725" y="3108960"/>
                    <a:pt x="2186032" y="3180080"/>
                  </a:cubicBezTo>
                  <a:cubicBezTo>
                    <a:pt x="2184339" y="3251200"/>
                    <a:pt x="2186032" y="3327400"/>
                    <a:pt x="2175872" y="3393440"/>
                  </a:cubicBezTo>
                  <a:cubicBezTo>
                    <a:pt x="2165712" y="3459480"/>
                    <a:pt x="2147085" y="3515360"/>
                    <a:pt x="2125072" y="3576320"/>
                  </a:cubicBezTo>
                  <a:cubicBezTo>
                    <a:pt x="2103059" y="3637280"/>
                    <a:pt x="2086125" y="3708400"/>
                    <a:pt x="2043792" y="3759200"/>
                  </a:cubicBezTo>
                  <a:cubicBezTo>
                    <a:pt x="2001459" y="3810000"/>
                    <a:pt x="1926952" y="3843867"/>
                    <a:pt x="1871072" y="3881120"/>
                  </a:cubicBezTo>
                  <a:cubicBezTo>
                    <a:pt x="1815192" y="3918373"/>
                    <a:pt x="1774552" y="3955627"/>
                    <a:pt x="1708512" y="3982720"/>
                  </a:cubicBezTo>
                  <a:cubicBezTo>
                    <a:pt x="1642472" y="4009813"/>
                    <a:pt x="1556112" y="4033520"/>
                    <a:pt x="1474832" y="4043680"/>
                  </a:cubicBezTo>
                  <a:cubicBezTo>
                    <a:pt x="1393552" y="4053840"/>
                    <a:pt x="1220832" y="4043680"/>
                    <a:pt x="1220832" y="4043680"/>
                  </a:cubicBezTo>
                  <a:lnTo>
                    <a:pt x="1088752" y="4043680"/>
                  </a:lnTo>
                  <a:lnTo>
                    <a:pt x="1037952" y="4043680"/>
                  </a:ln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楕円 31">
              <a:extLst>
                <a:ext uri="{FF2B5EF4-FFF2-40B4-BE49-F238E27FC236}">
                  <a16:creationId xmlns:a16="http://schemas.microsoft.com/office/drawing/2014/main" id="{552147FB-F35B-0C5A-C788-508EEF537BA1}"/>
                </a:ext>
              </a:extLst>
            </p:cNvPr>
            <p:cNvSpPr/>
            <p:nvPr/>
          </p:nvSpPr>
          <p:spPr>
            <a:xfrm>
              <a:off x="5009324" y="2113655"/>
              <a:ext cx="730369" cy="762001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35" name="フリーフォーム: 図形 34">
            <a:extLst>
              <a:ext uri="{FF2B5EF4-FFF2-40B4-BE49-F238E27FC236}">
                <a16:creationId xmlns:a16="http://schemas.microsoft.com/office/drawing/2014/main" id="{EAA8EE4C-7CD8-9BDB-6BCE-2ADA5D0D4568}"/>
              </a:ext>
            </a:extLst>
          </p:cNvPr>
          <p:cNvSpPr/>
          <p:nvPr/>
        </p:nvSpPr>
        <p:spPr>
          <a:xfrm rot="422949">
            <a:off x="8935569" y="2022397"/>
            <a:ext cx="178825" cy="193073"/>
          </a:xfrm>
          <a:custGeom>
            <a:avLst/>
            <a:gdLst>
              <a:gd name="connsiteX0" fmla="*/ 393752 w 1199329"/>
              <a:gd name="connsiteY0" fmla="*/ 1315155 h 1315775"/>
              <a:gd name="connsiteX1" fmla="*/ 190552 w 1199329"/>
              <a:gd name="connsiteY1" fmla="*/ 1223715 h 1315775"/>
              <a:gd name="connsiteX2" fmla="*/ 78792 w 1199329"/>
              <a:gd name="connsiteY2" fmla="*/ 1040835 h 1315775"/>
              <a:gd name="connsiteX3" fmla="*/ 7672 w 1199329"/>
              <a:gd name="connsiteY3" fmla="*/ 847795 h 1315775"/>
              <a:gd name="connsiteX4" fmla="*/ 7672 w 1199329"/>
              <a:gd name="connsiteY4" fmla="*/ 664915 h 1315775"/>
              <a:gd name="connsiteX5" fmla="*/ 58472 w 1199329"/>
              <a:gd name="connsiteY5" fmla="*/ 542995 h 1315775"/>
              <a:gd name="connsiteX6" fmla="*/ 58472 w 1199329"/>
              <a:gd name="connsiteY6" fmla="*/ 390595 h 1315775"/>
              <a:gd name="connsiteX7" fmla="*/ 58472 w 1199329"/>
              <a:gd name="connsiteY7" fmla="*/ 309315 h 1315775"/>
              <a:gd name="connsiteX8" fmla="*/ 149912 w 1199329"/>
              <a:gd name="connsiteY8" fmla="*/ 156915 h 1315775"/>
              <a:gd name="connsiteX9" fmla="*/ 210872 w 1199329"/>
              <a:gd name="connsiteY9" fmla="*/ 65475 h 1315775"/>
              <a:gd name="connsiteX10" fmla="*/ 332792 w 1199329"/>
              <a:gd name="connsiteY10" fmla="*/ 55315 h 1315775"/>
              <a:gd name="connsiteX11" fmla="*/ 485192 w 1199329"/>
              <a:gd name="connsiteY11" fmla="*/ 4515 h 1315775"/>
              <a:gd name="connsiteX12" fmla="*/ 617272 w 1199329"/>
              <a:gd name="connsiteY12" fmla="*/ 4515 h 1315775"/>
              <a:gd name="connsiteX13" fmla="*/ 698552 w 1199329"/>
              <a:gd name="connsiteY13" fmla="*/ 4515 h 1315775"/>
              <a:gd name="connsiteX14" fmla="*/ 850952 w 1199329"/>
              <a:gd name="connsiteY14" fmla="*/ 65475 h 1315775"/>
              <a:gd name="connsiteX15" fmla="*/ 962712 w 1199329"/>
              <a:gd name="connsiteY15" fmla="*/ 177235 h 1315775"/>
              <a:gd name="connsiteX16" fmla="*/ 1013512 w 1199329"/>
              <a:gd name="connsiteY16" fmla="*/ 278835 h 1315775"/>
              <a:gd name="connsiteX17" fmla="*/ 1115112 w 1199329"/>
              <a:gd name="connsiteY17" fmla="*/ 339795 h 1315775"/>
              <a:gd name="connsiteX18" fmla="*/ 1196392 w 1199329"/>
              <a:gd name="connsiteY18" fmla="*/ 482035 h 1315775"/>
              <a:gd name="connsiteX19" fmla="*/ 1155752 w 1199329"/>
              <a:gd name="connsiteY19" fmla="*/ 593795 h 1315775"/>
              <a:gd name="connsiteX20" fmla="*/ 1186232 w 1199329"/>
              <a:gd name="connsiteY20" fmla="*/ 705555 h 1315775"/>
              <a:gd name="connsiteX21" fmla="*/ 1196392 w 1199329"/>
              <a:gd name="connsiteY21" fmla="*/ 857955 h 1315775"/>
              <a:gd name="connsiteX22" fmla="*/ 1135432 w 1199329"/>
              <a:gd name="connsiteY22" fmla="*/ 1010355 h 1315775"/>
              <a:gd name="connsiteX23" fmla="*/ 1023672 w 1199329"/>
              <a:gd name="connsiteY23" fmla="*/ 1111955 h 1315775"/>
              <a:gd name="connsiteX24" fmla="*/ 891592 w 1199329"/>
              <a:gd name="connsiteY24" fmla="*/ 1193235 h 1315775"/>
              <a:gd name="connsiteX25" fmla="*/ 749352 w 1199329"/>
              <a:gd name="connsiteY25" fmla="*/ 1264355 h 1315775"/>
              <a:gd name="connsiteX26" fmla="*/ 556312 w 1199329"/>
              <a:gd name="connsiteY26" fmla="*/ 1264355 h 1315775"/>
              <a:gd name="connsiteX27" fmla="*/ 393752 w 1199329"/>
              <a:gd name="connsiteY27" fmla="*/ 1315155 h 131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</a:cxnLst>
            <a:rect l="l" t="t" r="r" b="b"/>
            <a:pathLst>
              <a:path w="1199329" h="1315775">
                <a:moveTo>
                  <a:pt x="393752" y="1315155"/>
                </a:moveTo>
                <a:cubicBezTo>
                  <a:pt x="332792" y="1308382"/>
                  <a:pt x="243045" y="1269435"/>
                  <a:pt x="190552" y="1223715"/>
                </a:cubicBezTo>
                <a:cubicBezTo>
                  <a:pt x="138059" y="1177995"/>
                  <a:pt x="109272" y="1103488"/>
                  <a:pt x="78792" y="1040835"/>
                </a:cubicBezTo>
                <a:cubicBezTo>
                  <a:pt x="48312" y="978182"/>
                  <a:pt x="19525" y="910448"/>
                  <a:pt x="7672" y="847795"/>
                </a:cubicBezTo>
                <a:cubicBezTo>
                  <a:pt x="-4181" y="785142"/>
                  <a:pt x="-795" y="715715"/>
                  <a:pt x="7672" y="664915"/>
                </a:cubicBezTo>
                <a:cubicBezTo>
                  <a:pt x="16139" y="614115"/>
                  <a:pt x="50005" y="588715"/>
                  <a:pt x="58472" y="542995"/>
                </a:cubicBezTo>
                <a:cubicBezTo>
                  <a:pt x="66939" y="497275"/>
                  <a:pt x="58472" y="390595"/>
                  <a:pt x="58472" y="390595"/>
                </a:cubicBezTo>
                <a:cubicBezTo>
                  <a:pt x="58472" y="351648"/>
                  <a:pt x="43232" y="348262"/>
                  <a:pt x="58472" y="309315"/>
                </a:cubicBezTo>
                <a:cubicBezTo>
                  <a:pt x="73712" y="270368"/>
                  <a:pt x="124512" y="197555"/>
                  <a:pt x="149912" y="156915"/>
                </a:cubicBezTo>
                <a:cubicBezTo>
                  <a:pt x="175312" y="116275"/>
                  <a:pt x="180392" y="82408"/>
                  <a:pt x="210872" y="65475"/>
                </a:cubicBezTo>
                <a:cubicBezTo>
                  <a:pt x="241352" y="48542"/>
                  <a:pt x="287072" y="65475"/>
                  <a:pt x="332792" y="55315"/>
                </a:cubicBezTo>
                <a:cubicBezTo>
                  <a:pt x="378512" y="45155"/>
                  <a:pt x="437779" y="12982"/>
                  <a:pt x="485192" y="4515"/>
                </a:cubicBezTo>
                <a:cubicBezTo>
                  <a:pt x="532605" y="-3952"/>
                  <a:pt x="617272" y="4515"/>
                  <a:pt x="617272" y="4515"/>
                </a:cubicBezTo>
                <a:cubicBezTo>
                  <a:pt x="652832" y="4515"/>
                  <a:pt x="659605" y="-5645"/>
                  <a:pt x="698552" y="4515"/>
                </a:cubicBezTo>
                <a:cubicBezTo>
                  <a:pt x="737499" y="14675"/>
                  <a:pt x="806925" y="36688"/>
                  <a:pt x="850952" y="65475"/>
                </a:cubicBezTo>
                <a:cubicBezTo>
                  <a:pt x="894979" y="94262"/>
                  <a:pt x="935619" y="141675"/>
                  <a:pt x="962712" y="177235"/>
                </a:cubicBezTo>
                <a:cubicBezTo>
                  <a:pt x="989805" y="212795"/>
                  <a:pt x="988112" y="251742"/>
                  <a:pt x="1013512" y="278835"/>
                </a:cubicBezTo>
                <a:cubicBezTo>
                  <a:pt x="1038912" y="305928"/>
                  <a:pt x="1084632" y="305928"/>
                  <a:pt x="1115112" y="339795"/>
                </a:cubicBezTo>
                <a:cubicBezTo>
                  <a:pt x="1145592" y="373662"/>
                  <a:pt x="1189619" y="439702"/>
                  <a:pt x="1196392" y="482035"/>
                </a:cubicBezTo>
                <a:cubicBezTo>
                  <a:pt x="1203165" y="524368"/>
                  <a:pt x="1157445" y="556542"/>
                  <a:pt x="1155752" y="593795"/>
                </a:cubicBezTo>
                <a:cubicBezTo>
                  <a:pt x="1154059" y="631048"/>
                  <a:pt x="1179459" y="661528"/>
                  <a:pt x="1186232" y="705555"/>
                </a:cubicBezTo>
                <a:cubicBezTo>
                  <a:pt x="1193005" y="749582"/>
                  <a:pt x="1204859" y="807155"/>
                  <a:pt x="1196392" y="857955"/>
                </a:cubicBezTo>
                <a:cubicBezTo>
                  <a:pt x="1187925" y="908755"/>
                  <a:pt x="1164219" y="968022"/>
                  <a:pt x="1135432" y="1010355"/>
                </a:cubicBezTo>
                <a:cubicBezTo>
                  <a:pt x="1106645" y="1052688"/>
                  <a:pt x="1064312" y="1081475"/>
                  <a:pt x="1023672" y="1111955"/>
                </a:cubicBezTo>
                <a:cubicBezTo>
                  <a:pt x="983032" y="1142435"/>
                  <a:pt x="937312" y="1167835"/>
                  <a:pt x="891592" y="1193235"/>
                </a:cubicBezTo>
                <a:cubicBezTo>
                  <a:pt x="845872" y="1218635"/>
                  <a:pt x="805232" y="1252502"/>
                  <a:pt x="749352" y="1264355"/>
                </a:cubicBezTo>
                <a:cubicBezTo>
                  <a:pt x="693472" y="1276208"/>
                  <a:pt x="610499" y="1257582"/>
                  <a:pt x="556312" y="1264355"/>
                </a:cubicBezTo>
                <a:cubicBezTo>
                  <a:pt x="502125" y="1271128"/>
                  <a:pt x="454712" y="1321928"/>
                  <a:pt x="393752" y="1315155"/>
                </a:cubicBezTo>
                <a:close/>
              </a:path>
            </a:pathLst>
          </a:cu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8" name="フリーフォーム: 図形 37">
            <a:extLst>
              <a:ext uri="{FF2B5EF4-FFF2-40B4-BE49-F238E27FC236}">
                <a16:creationId xmlns:a16="http://schemas.microsoft.com/office/drawing/2014/main" id="{2B2D2654-C03C-098B-A220-44EBC284A164}"/>
              </a:ext>
            </a:extLst>
          </p:cNvPr>
          <p:cNvSpPr/>
          <p:nvPr/>
        </p:nvSpPr>
        <p:spPr>
          <a:xfrm rot="422949">
            <a:off x="9890677" y="1619150"/>
            <a:ext cx="178825" cy="193073"/>
          </a:xfrm>
          <a:custGeom>
            <a:avLst/>
            <a:gdLst>
              <a:gd name="connsiteX0" fmla="*/ 393752 w 1199329"/>
              <a:gd name="connsiteY0" fmla="*/ 1315155 h 1315775"/>
              <a:gd name="connsiteX1" fmla="*/ 190552 w 1199329"/>
              <a:gd name="connsiteY1" fmla="*/ 1223715 h 1315775"/>
              <a:gd name="connsiteX2" fmla="*/ 78792 w 1199329"/>
              <a:gd name="connsiteY2" fmla="*/ 1040835 h 1315775"/>
              <a:gd name="connsiteX3" fmla="*/ 7672 w 1199329"/>
              <a:gd name="connsiteY3" fmla="*/ 847795 h 1315775"/>
              <a:gd name="connsiteX4" fmla="*/ 7672 w 1199329"/>
              <a:gd name="connsiteY4" fmla="*/ 664915 h 1315775"/>
              <a:gd name="connsiteX5" fmla="*/ 58472 w 1199329"/>
              <a:gd name="connsiteY5" fmla="*/ 542995 h 1315775"/>
              <a:gd name="connsiteX6" fmla="*/ 58472 w 1199329"/>
              <a:gd name="connsiteY6" fmla="*/ 390595 h 1315775"/>
              <a:gd name="connsiteX7" fmla="*/ 58472 w 1199329"/>
              <a:gd name="connsiteY7" fmla="*/ 309315 h 1315775"/>
              <a:gd name="connsiteX8" fmla="*/ 149912 w 1199329"/>
              <a:gd name="connsiteY8" fmla="*/ 156915 h 1315775"/>
              <a:gd name="connsiteX9" fmla="*/ 210872 w 1199329"/>
              <a:gd name="connsiteY9" fmla="*/ 65475 h 1315775"/>
              <a:gd name="connsiteX10" fmla="*/ 332792 w 1199329"/>
              <a:gd name="connsiteY10" fmla="*/ 55315 h 1315775"/>
              <a:gd name="connsiteX11" fmla="*/ 485192 w 1199329"/>
              <a:gd name="connsiteY11" fmla="*/ 4515 h 1315775"/>
              <a:gd name="connsiteX12" fmla="*/ 617272 w 1199329"/>
              <a:gd name="connsiteY12" fmla="*/ 4515 h 1315775"/>
              <a:gd name="connsiteX13" fmla="*/ 698552 w 1199329"/>
              <a:gd name="connsiteY13" fmla="*/ 4515 h 1315775"/>
              <a:gd name="connsiteX14" fmla="*/ 850952 w 1199329"/>
              <a:gd name="connsiteY14" fmla="*/ 65475 h 1315775"/>
              <a:gd name="connsiteX15" fmla="*/ 962712 w 1199329"/>
              <a:gd name="connsiteY15" fmla="*/ 177235 h 1315775"/>
              <a:gd name="connsiteX16" fmla="*/ 1013512 w 1199329"/>
              <a:gd name="connsiteY16" fmla="*/ 278835 h 1315775"/>
              <a:gd name="connsiteX17" fmla="*/ 1115112 w 1199329"/>
              <a:gd name="connsiteY17" fmla="*/ 339795 h 1315775"/>
              <a:gd name="connsiteX18" fmla="*/ 1196392 w 1199329"/>
              <a:gd name="connsiteY18" fmla="*/ 482035 h 1315775"/>
              <a:gd name="connsiteX19" fmla="*/ 1155752 w 1199329"/>
              <a:gd name="connsiteY19" fmla="*/ 593795 h 1315775"/>
              <a:gd name="connsiteX20" fmla="*/ 1186232 w 1199329"/>
              <a:gd name="connsiteY20" fmla="*/ 705555 h 1315775"/>
              <a:gd name="connsiteX21" fmla="*/ 1196392 w 1199329"/>
              <a:gd name="connsiteY21" fmla="*/ 857955 h 1315775"/>
              <a:gd name="connsiteX22" fmla="*/ 1135432 w 1199329"/>
              <a:gd name="connsiteY22" fmla="*/ 1010355 h 1315775"/>
              <a:gd name="connsiteX23" fmla="*/ 1023672 w 1199329"/>
              <a:gd name="connsiteY23" fmla="*/ 1111955 h 1315775"/>
              <a:gd name="connsiteX24" fmla="*/ 891592 w 1199329"/>
              <a:gd name="connsiteY24" fmla="*/ 1193235 h 1315775"/>
              <a:gd name="connsiteX25" fmla="*/ 749352 w 1199329"/>
              <a:gd name="connsiteY25" fmla="*/ 1264355 h 1315775"/>
              <a:gd name="connsiteX26" fmla="*/ 556312 w 1199329"/>
              <a:gd name="connsiteY26" fmla="*/ 1264355 h 1315775"/>
              <a:gd name="connsiteX27" fmla="*/ 393752 w 1199329"/>
              <a:gd name="connsiteY27" fmla="*/ 1315155 h 131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</a:cxnLst>
            <a:rect l="l" t="t" r="r" b="b"/>
            <a:pathLst>
              <a:path w="1199329" h="1315775">
                <a:moveTo>
                  <a:pt x="393752" y="1315155"/>
                </a:moveTo>
                <a:cubicBezTo>
                  <a:pt x="332792" y="1308382"/>
                  <a:pt x="243045" y="1269435"/>
                  <a:pt x="190552" y="1223715"/>
                </a:cubicBezTo>
                <a:cubicBezTo>
                  <a:pt x="138059" y="1177995"/>
                  <a:pt x="109272" y="1103488"/>
                  <a:pt x="78792" y="1040835"/>
                </a:cubicBezTo>
                <a:cubicBezTo>
                  <a:pt x="48312" y="978182"/>
                  <a:pt x="19525" y="910448"/>
                  <a:pt x="7672" y="847795"/>
                </a:cubicBezTo>
                <a:cubicBezTo>
                  <a:pt x="-4181" y="785142"/>
                  <a:pt x="-795" y="715715"/>
                  <a:pt x="7672" y="664915"/>
                </a:cubicBezTo>
                <a:cubicBezTo>
                  <a:pt x="16139" y="614115"/>
                  <a:pt x="50005" y="588715"/>
                  <a:pt x="58472" y="542995"/>
                </a:cubicBezTo>
                <a:cubicBezTo>
                  <a:pt x="66939" y="497275"/>
                  <a:pt x="58472" y="390595"/>
                  <a:pt x="58472" y="390595"/>
                </a:cubicBezTo>
                <a:cubicBezTo>
                  <a:pt x="58472" y="351648"/>
                  <a:pt x="43232" y="348262"/>
                  <a:pt x="58472" y="309315"/>
                </a:cubicBezTo>
                <a:cubicBezTo>
                  <a:pt x="73712" y="270368"/>
                  <a:pt x="124512" y="197555"/>
                  <a:pt x="149912" y="156915"/>
                </a:cubicBezTo>
                <a:cubicBezTo>
                  <a:pt x="175312" y="116275"/>
                  <a:pt x="180392" y="82408"/>
                  <a:pt x="210872" y="65475"/>
                </a:cubicBezTo>
                <a:cubicBezTo>
                  <a:pt x="241352" y="48542"/>
                  <a:pt x="287072" y="65475"/>
                  <a:pt x="332792" y="55315"/>
                </a:cubicBezTo>
                <a:cubicBezTo>
                  <a:pt x="378512" y="45155"/>
                  <a:pt x="437779" y="12982"/>
                  <a:pt x="485192" y="4515"/>
                </a:cubicBezTo>
                <a:cubicBezTo>
                  <a:pt x="532605" y="-3952"/>
                  <a:pt x="617272" y="4515"/>
                  <a:pt x="617272" y="4515"/>
                </a:cubicBezTo>
                <a:cubicBezTo>
                  <a:pt x="652832" y="4515"/>
                  <a:pt x="659605" y="-5645"/>
                  <a:pt x="698552" y="4515"/>
                </a:cubicBezTo>
                <a:cubicBezTo>
                  <a:pt x="737499" y="14675"/>
                  <a:pt x="806925" y="36688"/>
                  <a:pt x="850952" y="65475"/>
                </a:cubicBezTo>
                <a:cubicBezTo>
                  <a:pt x="894979" y="94262"/>
                  <a:pt x="935619" y="141675"/>
                  <a:pt x="962712" y="177235"/>
                </a:cubicBezTo>
                <a:cubicBezTo>
                  <a:pt x="989805" y="212795"/>
                  <a:pt x="988112" y="251742"/>
                  <a:pt x="1013512" y="278835"/>
                </a:cubicBezTo>
                <a:cubicBezTo>
                  <a:pt x="1038912" y="305928"/>
                  <a:pt x="1084632" y="305928"/>
                  <a:pt x="1115112" y="339795"/>
                </a:cubicBezTo>
                <a:cubicBezTo>
                  <a:pt x="1145592" y="373662"/>
                  <a:pt x="1189619" y="439702"/>
                  <a:pt x="1196392" y="482035"/>
                </a:cubicBezTo>
                <a:cubicBezTo>
                  <a:pt x="1203165" y="524368"/>
                  <a:pt x="1157445" y="556542"/>
                  <a:pt x="1155752" y="593795"/>
                </a:cubicBezTo>
                <a:cubicBezTo>
                  <a:pt x="1154059" y="631048"/>
                  <a:pt x="1179459" y="661528"/>
                  <a:pt x="1186232" y="705555"/>
                </a:cubicBezTo>
                <a:cubicBezTo>
                  <a:pt x="1193005" y="749582"/>
                  <a:pt x="1204859" y="807155"/>
                  <a:pt x="1196392" y="857955"/>
                </a:cubicBezTo>
                <a:cubicBezTo>
                  <a:pt x="1187925" y="908755"/>
                  <a:pt x="1164219" y="968022"/>
                  <a:pt x="1135432" y="1010355"/>
                </a:cubicBezTo>
                <a:cubicBezTo>
                  <a:pt x="1106645" y="1052688"/>
                  <a:pt x="1064312" y="1081475"/>
                  <a:pt x="1023672" y="1111955"/>
                </a:cubicBezTo>
                <a:cubicBezTo>
                  <a:pt x="983032" y="1142435"/>
                  <a:pt x="937312" y="1167835"/>
                  <a:pt x="891592" y="1193235"/>
                </a:cubicBezTo>
                <a:cubicBezTo>
                  <a:pt x="845872" y="1218635"/>
                  <a:pt x="805232" y="1252502"/>
                  <a:pt x="749352" y="1264355"/>
                </a:cubicBezTo>
                <a:cubicBezTo>
                  <a:pt x="693472" y="1276208"/>
                  <a:pt x="610499" y="1257582"/>
                  <a:pt x="556312" y="1264355"/>
                </a:cubicBezTo>
                <a:cubicBezTo>
                  <a:pt x="502125" y="1271128"/>
                  <a:pt x="454712" y="1321928"/>
                  <a:pt x="393752" y="1315155"/>
                </a:cubicBezTo>
                <a:close/>
              </a:path>
            </a:pathLst>
          </a:cu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AB9949C-BF3F-8ABD-9344-8AFB1B251C0C}"/>
              </a:ext>
            </a:extLst>
          </p:cNvPr>
          <p:cNvSpPr txBox="1"/>
          <p:nvPr/>
        </p:nvSpPr>
        <p:spPr>
          <a:xfrm>
            <a:off x="7377245" y="3243306"/>
            <a:ext cx="207281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ocal recurrence</a:t>
            </a:r>
            <a:endParaRPr kumimoji="1" lang="ja-JP" altLang="en-US" sz="2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7154F02-C024-8E64-4468-9EA0D267A98F}"/>
              </a:ext>
            </a:extLst>
          </p:cNvPr>
          <p:cNvSpPr txBox="1"/>
          <p:nvPr/>
        </p:nvSpPr>
        <p:spPr>
          <a:xfrm>
            <a:off x="9645996" y="2867958"/>
            <a:ext cx="227434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kumimoji="1" lang="en-US" altLang="ja-JP" sz="2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trahepatic </a:t>
            </a:r>
          </a:p>
          <a:p>
            <a:pPr algn="ctr"/>
            <a:r>
              <a:rPr kumimoji="1" lang="en-US" altLang="ja-JP" sz="2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stant recurrence</a:t>
            </a:r>
            <a:endParaRPr kumimoji="1" lang="ja-JP" altLang="en-US" sz="2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AAC7E74E-33FF-A587-098A-19E0AC591D3B}"/>
              </a:ext>
            </a:extLst>
          </p:cNvPr>
          <p:cNvCxnSpPr>
            <a:cxnSpLocks/>
          </p:cNvCxnSpPr>
          <p:nvPr/>
        </p:nvCxnSpPr>
        <p:spPr>
          <a:xfrm>
            <a:off x="7255298" y="2055249"/>
            <a:ext cx="818188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F79E7009-3D66-D7A4-B2CF-88ECCE95C867}"/>
              </a:ext>
            </a:extLst>
          </p:cNvPr>
          <p:cNvCxnSpPr>
            <a:cxnSpLocks/>
          </p:cNvCxnSpPr>
          <p:nvPr/>
        </p:nvCxnSpPr>
        <p:spPr>
          <a:xfrm flipV="1">
            <a:off x="8503039" y="2306805"/>
            <a:ext cx="421358" cy="938633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6600922E-FD63-E79D-E0C9-49886C5FCCE9}"/>
              </a:ext>
            </a:extLst>
          </p:cNvPr>
          <p:cNvCxnSpPr>
            <a:cxnSpLocks/>
          </p:cNvCxnSpPr>
          <p:nvPr/>
        </p:nvCxnSpPr>
        <p:spPr>
          <a:xfrm>
            <a:off x="8473304" y="3685869"/>
            <a:ext cx="670001" cy="782467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2F14CCD3-9B2C-016B-0758-5259344EE6E6}"/>
              </a:ext>
            </a:extLst>
          </p:cNvPr>
          <p:cNvCxnSpPr>
            <a:cxnSpLocks/>
          </p:cNvCxnSpPr>
          <p:nvPr/>
        </p:nvCxnSpPr>
        <p:spPr>
          <a:xfrm flipH="1" flipV="1">
            <a:off x="10026397" y="1995079"/>
            <a:ext cx="360236" cy="82082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4B3DCF-74F7-61B2-FD0F-C727F83EF2FC}"/>
              </a:ext>
            </a:extLst>
          </p:cNvPr>
          <p:cNvSpPr txBox="1"/>
          <p:nvPr/>
        </p:nvSpPr>
        <p:spPr>
          <a:xfrm>
            <a:off x="226340" y="80022"/>
            <a:ext cx="2550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kern="0" spc="-1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en-US" altLang="ja-JP" sz="1800" b="1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</a:t>
            </a:r>
            <a:endParaRPr kumimoji="1" lang="ja-JP" altLang="en-US" b="1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77DE60FB-FA55-34BA-4636-6B313B06931B}"/>
              </a:ext>
            </a:extLst>
          </p:cNvPr>
          <p:cNvCxnSpPr>
            <a:cxnSpLocks/>
          </p:cNvCxnSpPr>
          <p:nvPr/>
        </p:nvCxnSpPr>
        <p:spPr>
          <a:xfrm>
            <a:off x="7170664" y="5514913"/>
            <a:ext cx="818188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F6F623AB-D007-CA88-969F-9E34878E48A4}"/>
              </a:ext>
            </a:extLst>
          </p:cNvPr>
          <p:cNvGrpSpPr/>
          <p:nvPr/>
        </p:nvGrpSpPr>
        <p:grpSpPr>
          <a:xfrm>
            <a:off x="4710236" y="4172921"/>
            <a:ext cx="2291944" cy="1749039"/>
            <a:chOff x="803910" y="3821249"/>
            <a:chExt cx="2291944" cy="1749039"/>
          </a:xfrm>
        </p:grpSpPr>
        <p:sp>
          <p:nvSpPr>
            <p:cNvPr id="42" name="フリーフォーム: 図形 41">
              <a:extLst>
                <a:ext uri="{FF2B5EF4-FFF2-40B4-BE49-F238E27FC236}">
                  <a16:creationId xmlns:a16="http://schemas.microsoft.com/office/drawing/2014/main" id="{793A4E47-2A22-2E93-DC0D-6A8B4D7F4F8F}"/>
                </a:ext>
              </a:extLst>
            </p:cNvPr>
            <p:cNvSpPr/>
            <p:nvPr/>
          </p:nvSpPr>
          <p:spPr>
            <a:xfrm>
              <a:off x="803910" y="3839152"/>
              <a:ext cx="1002549" cy="1731136"/>
            </a:xfrm>
            <a:custGeom>
              <a:avLst/>
              <a:gdLst>
                <a:gd name="connsiteX0" fmla="*/ 476250 w 1002549"/>
                <a:gd name="connsiteY0" fmla="*/ 188018 h 1731136"/>
                <a:gd name="connsiteX1" fmla="*/ 563880 w 1002549"/>
                <a:gd name="connsiteY1" fmla="*/ 127058 h 1731136"/>
                <a:gd name="connsiteX2" fmla="*/ 674370 w 1002549"/>
                <a:gd name="connsiteY2" fmla="*/ 73718 h 1731136"/>
                <a:gd name="connsiteX3" fmla="*/ 788670 w 1002549"/>
                <a:gd name="connsiteY3" fmla="*/ 31808 h 1731136"/>
                <a:gd name="connsiteX4" fmla="*/ 857250 w 1002549"/>
                <a:gd name="connsiteY4" fmla="*/ 16568 h 1731136"/>
                <a:gd name="connsiteX5" fmla="*/ 891540 w 1002549"/>
                <a:gd name="connsiteY5" fmla="*/ 8948 h 1731136"/>
                <a:gd name="connsiteX6" fmla="*/ 960120 w 1002549"/>
                <a:gd name="connsiteY6" fmla="*/ 5138 h 1731136"/>
                <a:gd name="connsiteX7" fmla="*/ 990600 w 1002549"/>
                <a:gd name="connsiteY7" fmla="*/ 85148 h 1731136"/>
                <a:gd name="connsiteX8" fmla="*/ 998220 w 1002549"/>
                <a:gd name="connsiteY8" fmla="*/ 290888 h 1731136"/>
                <a:gd name="connsiteX9" fmla="*/ 1002030 w 1002549"/>
                <a:gd name="connsiteY9" fmla="*/ 549968 h 1731136"/>
                <a:gd name="connsiteX10" fmla="*/ 986790 w 1002549"/>
                <a:gd name="connsiteY10" fmla="*/ 725228 h 1731136"/>
                <a:gd name="connsiteX11" fmla="*/ 979170 w 1002549"/>
                <a:gd name="connsiteY11" fmla="*/ 915728 h 1731136"/>
                <a:gd name="connsiteX12" fmla="*/ 982980 w 1002549"/>
                <a:gd name="connsiteY12" fmla="*/ 1014788 h 1731136"/>
                <a:gd name="connsiteX13" fmla="*/ 956310 w 1002549"/>
                <a:gd name="connsiteY13" fmla="*/ 1083368 h 1731136"/>
                <a:gd name="connsiteX14" fmla="*/ 941070 w 1002549"/>
                <a:gd name="connsiteY14" fmla="*/ 1121468 h 1731136"/>
                <a:gd name="connsiteX15" fmla="*/ 906780 w 1002549"/>
                <a:gd name="connsiteY15" fmla="*/ 1140518 h 1731136"/>
                <a:gd name="connsiteX16" fmla="*/ 883920 w 1002549"/>
                <a:gd name="connsiteY16" fmla="*/ 1190048 h 1731136"/>
                <a:gd name="connsiteX17" fmla="*/ 887730 w 1002549"/>
                <a:gd name="connsiteY17" fmla="*/ 1300538 h 1731136"/>
                <a:gd name="connsiteX18" fmla="*/ 883920 w 1002549"/>
                <a:gd name="connsiteY18" fmla="*/ 1414838 h 1731136"/>
                <a:gd name="connsiteX19" fmla="*/ 864870 w 1002549"/>
                <a:gd name="connsiteY19" fmla="*/ 1544378 h 1731136"/>
                <a:gd name="connsiteX20" fmla="*/ 803910 w 1002549"/>
                <a:gd name="connsiteY20" fmla="*/ 1632008 h 1731136"/>
                <a:gd name="connsiteX21" fmla="*/ 739140 w 1002549"/>
                <a:gd name="connsiteY21" fmla="*/ 1681538 h 1731136"/>
                <a:gd name="connsiteX22" fmla="*/ 624840 w 1002549"/>
                <a:gd name="connsiteY22" fmla="*/ 1719638 h 1731136"/>
                <a:gd name="connsiteX23" fmla="*/ 506730 w 1002549"/>
                <a:gd name="connsiteY23" fmla="*/ 1731068 h 1731136"/>
                <a:gd name="connsiteX24" fmla="*/ 346710 w 1002549"/>
                <a:gd name="connsiteY24" fmla="*/ 1715828 h 1731136"/>
                <a:gd name="connsiteX25" fmla="*/ 201930 w 1002549"/>
                <a:gd name="connsiteY25" fmla="*/ 1647248 h 1731136"/>
                <a:gd name="connsiteX26" fmla="*/ 91440 w 1002549"/>
                <a:gd name="connsiteY26" fmla="*/ 1487228 h 1731136"/>
                <a:gd name="connsiteX27" fmla="*/ 26670 w 1002549"/>
                <a:gd name="connsiteY27" fmla="*/ 1319588 h 1731136"/>
                <a:gd name="connsiteX28" fmla="*/ 0 w 1002549"/>
                <a:gd name="connsiteY28" fmla="*/ 1094798 h 1731136"/>
                <a:gd name="connsiteX29" fmla="*/ 26670 w 1002549"/>
                <a:gd name="connsiteY29" fmla="*/ 816668 h 1731136"/>
                <a:gd name="connsiteX30" fmla="*/ 118110 w 1002549"/>
                <a:gd name="connsiteY30" fmla="*/ 569018 h 1731136"/>
                <a:gd name="connsiteX31" fmla="*/ 247650 w 1002549"/>
                <a:gd name="connsiteY31" fmla="*/ 378518 h 1731136"/>
                <a:gd name="connsiteX32" fmla="*/ 361950 w 1002549"/>
                <a:gd name="connsiteY32" fmla="*/ 275648 h 1731136"/>
                <a:gd name="connsiteX33" fmla="*/ 476250 w 1002549"/>
                <a:gd name="connsiteY33" fmla="*/ 188018 h 1731136"/>
                <a:gd name="connsiteX0" fmla="*/ 476250 w 1002549"/>
                <a:gd name="connsiteY0" fmla="*/ 188018 h 1731136"/>
                <a:gd name="connsiteX1" fmla="*/ 563880 w 1002549"/>
                <a:gd name="connsiteY1" fmla="*/ 127058 h 1731136"/>
                <a:gd name="connsiteX2" fmla="*/ 674370 w 1002549"/>
                <a:gd name="connsiteY2" fmla="*/ 73718 h 1731136"/>
                <a:gd name="connsiteX3" fmla="*/ 788670 w 1002549"/>
                <a:gd name="connsiteY3" fmla="*/ 31808 h 1731136"/>
                <a:gd name="connsiteX4" fmla="*/ 857250 w 1002549"/>
                <a:gd name="connsiteY4" fmla="*/ 16568 h 1731136"/>
                <a:gd name="connsiteX5" fmla="*/ 891540 w 1002549"/>
                <a:gd name="connsiteY5" fmla="*/ 8948 h 1731136"/>
                <a:gd name="connsiteX6" fmla="*/ 960120 w 1002549"/>
                <a:gd name="connsiteY6" fmla="*/ 5138 h 1731136"/>
                <a:gd name="connsiteX7" fmla="*/ 990600 w 1002549"/>
                <a:gd name="connsiteY7" fmla="*/ 85148 h 1731136"/>
                <a:gd name="connsiteX8" fmla="*/ 998220 w 1002549"/>
                <a:gd name="connsiteY8" fmla="*/ 290888 h 1731136"/>
                <a:gd name="connsiteX9" fmla="*/ 1002030 w 1002549"/>
                <a:gd name="connsiteY9" fmla="*/ 549968 h 1731136"/>
                <a:gd name="connsiteX10" fmla="*/ 986790 w 1002549"/>
                <a:gd name="connsiteY10" fmla="*/ 725228 h 1731136"/>
                <a:gd name="connsiteX11" fmla="*/ 979170 w 1002549"/>
                <a:gd name="connsiteY11" fmla="*/ 915728 h 1731136"/>
                <a:gd name="connsiteX12" fmla="*/ 982980 w 1002549"/>
                <a:gd name="connsiteY12" fmla="*/ 1014788 h 1731136"/>
                <a:gd name="connsiteX13" fmla="*/ 956310 w 1002549"/>
                <a:gd name="connsiteY13" fmla="*/ 1083368 h 1731136"/>
                <a:gd name="connsiteX14" fmla="*/ 941070 w 1002549"/>
                <a:gd name="connsiteY14" fmla="*/ 1121468 h 1731136"/>
                <a:gd name="connsiteX15" fmla="*/ 916305 w 1002549"/>
                <a:gd name="connsiteY15" fmla="*/ 1153853 h 1731136"/>
                <a:gd name="connsiteX16" fmla="*/ 883920 w 1002549"/>
                <a:gd name="connsiteY16" fmla="*/ 1190048 h 1731136"/>
                <a:gd name="connsiteX17" fmla="*/ 887730 w 1002549"/>
                <a:gd name="connsiteY17" fmla="*/ 1300538 h 1731136"/>
                <a:gd name="connsiteX18" fmla="*/ 883920 w 1002549"/>
                <a:gd name="connsiteY18" fmla="*/ 1414838 h 1731136"/>
                <a:gd name="connsiteX19" fmla="*/ 864870 w 1002549"/>
                <a:gd name="connsiteY19" fmla="*/ 1544378 h 1731136"/>
                <a:gd name="connsiteX20" fmla="*/ 803910 w 1002549"/>
                <a:gd name="connsiteY20" fmla="*/ 1632008 h 1731136"/>
                <a:gd name="connsiteX21" fmla="*/ 739140 w 1002549"/>
                <a:gd name="connsiteY21" fmla="*/ 1681538 h 1731136"/>
                <a:gd name="connsiteX22" fmla="*/ 624840 w 1002549"/>
                <a:gd name="connsiteY22" fmla="*/ 1719638 h 1731136"/>
                <a:gd name="connsiteX23" fmla="*/ 506730 w 1002549"/>
                <a:gd name="connsiteY23" fmla="*/ 1731068 h 1731136"/>
                <a:gd name="connsiteX24" fmla="*/ 346710 w 1002549"/>
                <a:gd name="connsiteY24" fmla="*/ 1715828 h 1731136"/>
                <a:gd name="connsiteX25" fmla="*/ 201930 w 1002549"/>
                <a:gd name="connsiteY25" fmla="*/ 1647248 h 1731136"/>
                <a:gd name="connsiteX26" fmla="*/ 91440 w 1002549"/>
                <a:gd name="connsiteY26" fmla="*/ 1487228 h 1731136"/>
                <a:gd name="connsiteX27" fmla="*/ 26670 w 1002549"/>
                <a:gd name="connsiteY27" fmla="*/ 1319588 h 1731136"/>
                <a:gd name="connsiteX28" fmla="*/ 0 w 1002549"/>
                <a:gd name="connsiteY28" fmla="*/ 1094798 h 1731136"/>
                <a:gd name="connsiteX29" fmla="*/ 26670 w 1002549"/>
                <a:gd name="connsiteY29" fmla="*/ 816668 h 1731136"/>
                <a:gd name="connsiteX30" fmla="*/ 118110 w 1002549"/>
                <a:gd name="connsiteY30" fmla="*/ 569018 h 1731136"/>
                <a:gd name="connsiteX31" fmla="*/ 247650 w 1002549"/>
                <a:gd name="connsiteY31" fmla="*/ 378518 h 1731136"/>
                <a:gd name="connsiteX32" fmla="*/ 361950 w 1002549"/>
                <a:gd name="connsiteY32" fmla="*/ 275648 h 1731136"/>
                <a:gd name="connsiteX33" fmla="*/ 476250 w 1002549"/>
                <a:gd name="connsiteY33" fmla="*/ 188018 h 1731136"/>
                <a:gd name="connsiteX0" fmla="*/ 476250 w 1002549"/>
                <a:gd name="connsiteY0" fmla="*/ 188018 h 1731136"/>
                <a:gd name="connsiteX1" fmla="*/ 563880 w 1002549"/>
                <a:gd name="connsiteY1" fmla="*/ 127058 h 1731136"/>
                <a:gd name="connsiteX2" fmla="*/ 674370 w 1002549"/>
                <a:gd name="connsiteY2" fmla="*/ 73718 h 1731136"/>
                <a:gd name="connsiteX3" fmla="*/ 788670 w 1002549"/>
                <a:gd name="connsiteY3" fmla="*/ 31808 h 1731136"/>
                <a:gd name="connsiteX4" fmla="*/ 857250 w 1002549"/>
                <a:gd name="connsiteY4" fmla="*/ 16568 h 1731136"/>
                <a:gd name="connsiteX5" fmla="*/ 891540 w 1002549"/>
                <a:gd name="connsiteY5" fmla="*/ 8948 h 1731136"/>
                <a:gd name="connsiteX6" fmla="*/ 960120 w 1002549"/>
                <a:gd name="connsiteY6" fmla="*/ 5138 h 1731136"/>
                <a:gd name="connsiteX7" fmla="*/ 990600 w 1002549"/>
                <a:gd name="connsiteY7" fmla="*/ 85148 h 1731136"/>
                <a:gd name="connsiteX8" fmla="*/ 998220 w 1002549"/>
                <a:gd name="connsiteY8" fmla="*/ 290888 h 1731136"/>
                <a:gd name="connsiteX9" fmla="*/ 1002030 w 1002549"/>
                <a:gd name="connsiteY9" fmla="*/ 549968 h 1731136"/>
                <a:gd name="connsiteX10" fmla="*/ 986790 w 1002549"/>
                <a:gd name="connsiteY10" fmla="*/ 725228 h 1731136"/>
                <a:gd name="connsiteX11" fmla="*/ 979170 w 1002549"/>
                <a:gd name="connsiteY11" fmla="*/ 915728 h 1731136"/>
                <a:gd name="connsiteX12" fmla="*/ 982980 w 1002549"/>
                <a:gd name="connsiteY12" fmla="*/ 1014788 h 1731136"/>
                <a:gd name="connsiteX13" fmla="*/ 956310 w 1002549"/>
                <a:gd name="connsiteY13" fmla="*/ 1083368 h 1731136"/>
                <a:gd name="connsiteX14" fmla="*/ 941070 w 1002549"/>
                <a:gd name="connsiteY14" fmla="*/ 1121468 h 1731136"/>
                <a:gd name="connsiteX15" fmla="*/ 916305 w 1002549"/>
                <a:gd name="connsiteY15" fmla="*/ 1153853 h 1731136"/>
                <a:gd name="connsiteX16" fmla="*/ 895350 w 1002549"/>
                <a:gd name="connsiteY16" fmla="*/ 1199573 h 1731136"/>
                <a:gd name="connsiteX17" fmla="*/ 887730 w 1002549"/>
                <a:gd name="connsiteY17" fmla="*/ 1300538 h 1731136"/>
                <a:gd name="connsiteX18" fmla="*/ 883920 w 1002549"/>
                <a:gd name="connsiteY18" fmla="*/ 1414838 h 1731136"/>
                <a:gd name="connsiteX19" fmla="*/ 864870 w 1002549"/>
                <a:gd name="connsiteY19" fmla="*/ 1544378 h 1731136"/>
                <a:gd name="connsiteX20" fmla="*/ 803910 w 1002549"/>
                <a:gd name="connsiteY20" fmla="*/ 1632008 h 1731136"/>
                <a:gd name="connsiteX21" fmla="*/ 739140 w 1002549"/>
                <a:gd name="connsiteY21" fmla="*/ 1681538 h 1731136"/>
                <a:gd name="connsiteX22" fmla="*/ 624840 w 1002549"/>
                <a:gd name="connsiteY22" fmla="*/ 1719638 h 1731136"/>
                <a:gd name="connsiteX23" fmla="*/ 506730 w 1002549"/>
                <a:gd name="connsiteY23" fmla="*/ 1731068 h 1731136"/>
                <a:gd name="connsiteX24" fmla="*/ 346710 w 1002549"/>
                <a:gd name="connsiteY24" fmla="*/ 1715828 h 1731136"/>
                <a:gd name="connsiteX25" fmla="*/ 201930 w 1002549"/>
                <a:gd name="connsiteY25" fmla="*/ 1647248 h 1731136"/>
                <a:gd name="connsiteX26" fmla="*/ 91440 w 1002549"/>
                <a:gd name="connsiteY26" fmla="*/ 1487228 h 1731136"/>
                <a:gd name="connsiteX27" fmla="*/ 26670 w 1002549"/>
                <a:gd name="connsiteY27" fmla="*/ 1319588 h 1731136"/>
                <a:gd name="connsiteX28" fmla="*/ 0 w 1002549"/>
                <a:gd name="connsiteY28" fmla="*/ 1094798 h 1731136"/>
                <a:gd name="connsiteX29" fmla="*/ 26670 w 1002549"/>
                <a:gd name="connsiteY29" fmla="*/ 816668 h 1731136"/>
                <a:gd name="connsiteX30" fmla="*/ 118110 w 1002549"/>
                <a:gd name="connsiteY30" fmla="*/ 569018 h 1731136"/>
                <a:gd name="connsiteX31" fmla="*/ 247650 w 1002549"/>
                <a:gd name="connsiteY31" fmla="*/ 378518 h 1731136"/>
                <a:gd name="connsiteX32" fmla="*/ 361950 w 1002549"/>
                <a:gd name="connsiteY32" fmla="*/ 275648 h 1731136"/>
                <a:gd name="connsiteX33" fmla="*/ 476250 w 1002549"/>
                <a:gd name="connsiteY33" fmla="*/ 188018 h 17311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</a:cxnLst>
              <a:rect l="l" t="t" r="r" b="b"/>
              <a:pathLst>
                <a:path w="1002549" h="1731136">
                  <a:moveTo>
                    <a:pt x="476250" y="188018"/>
                  </a:moveTo>
                  <a:cubicBezTo>
                    <a:pt x="509905" y="163253"/>
                    <a:pt x="530860" y="146108"/>
                    <a:pt x="563880" y="127058"/>
                  </a:cubicBezTo>
                  <a:cubicBezTo>
                    <a:pt x="596900" y="108008"/>
                    <a:pt x="636905" y="89593"/>
                    <a:pt x="674370" y="73718"/>
                  </a:cubicBezTo>
                  <a:cubicBezTo>
                    <a:pt x="711835" y="57843"/>
                    <a:pt x="758190" y="41333"/>
                    <a:pt x="788670" y="31808"/>
                  </a:cubicBezTo>
                  <a:cubicBezTo>
                    <a:pt x="819150" y="22283"/>
                    <a:pt x="840105" y="20378"/>
                    <a:pt x="857250" y="16568"/>
                  </a:cubicBezTo>
                  <a:cubicBezTo>
                    <a:pt x="874395" y="12758"/>
                    <a:pt x="874395" y="10853"/>
                    <a:pt x="891540" y="8948"/>
                  </a:cubicBezTo>
                  <a:cubicBezTo>
                    <a:pt x="908685" y="7043"/>
                    <a:pt x="943610" y="-7562"/>
                    <a:pt x="960120" y="5138"/>
                  </a:cubicBezTo>
                  <a:cubicBezTo>
                    <a:pt x="976630" y="17838"/>
                    <a:pt x="984250" y="37523"/>
                    <a:pt x="990600" y="85148"/>
                  </a:cubicBezTo>
                  <a:cubicBezTo>
                    <a:pt x="996950" y="132773"/>
                    <a:pt x="996315" y="213418"/>
                    <a:pt x="998220" y="290888"/>
                  </a:cubicBezTo>
                  <a:cubicBezTo>
                    <a:pt x="1000125" y="368358"/>
                    <a:pt x="1003935" y="477578"/>
                    <a:pt x="1002030" y="549968"/>
                  </a:cubicBezTo>
                  <a:cubicBezTo>
                    <a:pt x="1000125" y="622358"/>
                    <a:pt x="990600" y="664268"/>
                    <a:pt x="986790" y="725228"/>
                  </a:cubicBezTo>
                  <a:cubicBezTo>
                    <a:pt x="982980" y="786188"/>
                    <a:pt x="979805" y="867468"/>
                    <a:pt x="979170" y="915728"/>
                  </a:cubicBezTo>
                  <a:cubicBezTo>
                    <a:pt x="978535" y="963988"/>
                    <a:pt x="986790" y="986848"/>
                    <a:pt x="982980" y="1014788"/>
                  </a:cubicBezTo>
                  <a:cubicBezTo>
                    <a:pt x="979170" y="1042728"/>
                    <a:pt x="963295" y="1065588"/>
                    <a:pt x="956310" y="1083368"/>
                  </a:cubicBezTo>
                  <a:cubicBezTo>
                    <a:pt x="949325" y="1101148"/>
                    <a:pt x="947738" y="1109721"/>
                    <a:pt x="941070" y="1121468"/>
                  </a:cubicBezTo>
                  <a:cubicBezTo>
                    <a:pt x="934403" y="1133216"/>
                    <a:pt x="923925" y="1140836"/>
                    <a:pt x="916305" y="1153853"/>
                  </a:cubicBezTo>
                  <a:cubicBezTo>
                    <a:pt x="908685" y="1166870"/>
                    <a:pt x="900112" y="1175126"/>
                    <a:pt x="895350" y="1199573"/>
                  </a:cubicBezTo>
                  <a:cubicBezTo>
                    <a:pt x="890588" y="1224020"/>
                    <a:pt x="889635" y="1264661"/>
                    <a:pt x="887730" y="1300538"/>
                  </a:cubicBezTo>
                  <a:cubicBezTo>
                    <a:pt x="885825" y="1336415"/>
                    <a:pt x="887730" y="1374198"/>
                    <a:pt x="883920" y="1414838"/>
                  </a:cubicBezTo>
                  <a:cubicBezTo>
                    <a:pt x="880110" y="1455478"/>
                    <a:pt x="878205" y="1508183"/>
                    <a:pt x="864870" y="1544378"/>
                  </a:cubicBezTo>
                  <a:cubicBezTo>
                    <a:pt x="851535" y="1580573"/>
                    <a:pt x="824865" y="1609148"/>
                    <a:pt x="803910" y="1632008"/>
                  </a:cubicBezTo>
                  <a:cubicBezTo>
                    <a:pt x="782955" y="1654868"/>
                    <a:pt x="768985" y="1666933"/>
                    <a:pt x="739140" y="1681538"/>
                  </a:cubicBezTo>
                  <a:cubicBezTo>
                    <a:pt x="709295" y="1696143"/>
                    <a:pt x="663575" y="1711383"/>
                    <a:pt x="624840" y="1719638"/>
                  </a:cubicBezTo>
                  <a:cubicBezTo>
                    <a:pt x="586105" y="1727893"/>
                    <a:pt x="553085" y="1731703"/>
                    <a:pt x="506730" y="1731068"/>
                  </a:cubicBezTo>
                  <a:cubicBezTo>
                    <a:pt x="460375" y="1730433"/>
                    <a:pt x="397510" y="1729798"/>
                    <a:pt x="346710" y="1715828"/>
                  </a:cubicBezTo>
                  <a:cubicBezTo>
                    <a:pt x="295910" y="1701858"/>
                    <a:pt x="244475" y="1685348"/>
                    <a:pt x="201930" y="1647248"/>
                  </a:cubicBezTo>
                  <a:cubicBezTo>
                    <a:pt x="159385" y="1609148"/>
                    <a:pt x="120650" y="1541838"/>
                    <a:pt x="91440" y="1487228"/>
                  </a:cubicBezTo>
                  <a:cubicBezTo>
                    <a:pt x="62230" y="1432618"/>
                    <a:pt x="41910" y="1384993"/>
                    <a:pt x="26670" y="1319588"/>
                  </a:cubicBezTo>
                  <a:cubicBezTo>
                    <a:pt x="11430" y="1254183"/>
                    <a:pt x="0" y="1178618"/>
                    <a:pt x="0" y="1094798"/>
                  </a:cubicBezTo>
                  <a:cubicBezTo>
                    <a:pt x="0" y="1010978"/>
                    <a:pt x="6985" y="904298"/>
                    <a:pt x="26670" y="816668"/>
                  </a:cubicBezTo>
                  <a:cubicBezTo>
                    <a:pt x="46355" y="729038"/>
                    <a:pt x="81280" y="642043"/>
                    <a:pt x="118110" y="569018"/>
                  </a:cubicBezTo>
                  <a:cubicBezTo>
                    <a:pt x="154940" y="495993"/>
                    <a:pt x="207010" y="427413"/>
                    <a:pt x="247650" y="378518"/>
                  </a:cubicBezTo>
                  <a:cubicBezTo>
                    <a:pt x="288290" y="329623"/>
                    <a:pt x="329565" y="302953"/>
                    <a:pt x="361950" y="275648"/>
                  </a:cubicBezTo>
                  <a:cubicBezTo>
                    <a:pt x="394335" y="248343"/>
                    <a:pt x="442595" y="212783"/>
                    <a:pt x="476250" y="188018"/>
                  </a:cubicBezTo>
                  <a:close/>
                </a:path>
              </a:pathLst>
            </a:custGeom>
            <a:noFill/>
            <a:ln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" name="フリーフォーム: 図形 43">
              <a:extLst>
                <a:ext uri="{FF2B5EF4-FFF2-40B4-BE49-F238E27FC236}">
                  <a16:creationId xmlns:a16="http://schemas.microsoft.com/office/drawing/2014/main" id="{0B38E8AB-F02D-6C03-73E6-4B3DEC75A24B}"/>
                </a:ext>
              </a:extLst>
            </p:cNvPr>
            <p:cNvSpPr/>
            <p:nvPr/>
          </p:nvSpPr>
          <p:spPr>
            <a:xfrm>
              <a:off x="1710192" y="3821249"/>
              <a:ext cx="1385662" cy="1167768"/>
            </a:xfrm>
            <a:custGeom>
              <a:avLst/>
              <a:gdLst>
                <a:gd name="connsiteX0" fmla="*/ 187821 w 1385662"/>
                <a:gd name="connsiteY0" fmla="*/ 1132046 h 1168093"/>
                <a:gd name="connsiteX1" fmla="*/ 88761 w 1385662"/>
                <a:gd name="connsiteY1" fmla="*/ 1158716 h 1168093"/>
                <a:gd name="connsiteX2" fmla="*/ 27801 w 1385662"/>
                <a:gd name="connsiteY2" fmla="*/ 1166336 h 1168093"/>
                <a:gd name="connsiteX3" fmla="*/ 1131 w 1385662"/>
                <a:gd name="connsiteY3" fmla="*/ 1128236 h 1168093"/>
                <a:gd name="connsiteX4" fmla="*/ 4941 w 1385662"/>
                <a:gd name="connsiteY4" fmla="*/ 987266 h 1168093"/>
                <a:gd name="connsiteX5" fmla="*/ 4941 w 1385662"/>
                <a:gd name="connsiteY5" fmla="*/ 701516 h 1168093"/>
                <a:gd name="connsiteX6" fmla="*/ 1131 w 1385662"/>
                <a:gd name="connsiteY6" fmla="*/ 423386 h 1168093"/>
                <a:gd name="connsiteX7" fmla="*/ 1131 w 1385662"/>
                <a:gd name="connsiteY7" fmla="*/ 217646 h 1168093"/>
                <a:gd name="connsiteX8" fmla="*/ 1131 w 1385662"/>
                <a:gd name="connsiteY8" fmla="*/ 99536 h 1168093"/>
                <a:gd name="connsiteX9" fmla="*/ 8751 w 1385662"/>
                <a:gd name="connsiteY9" fmla="*/ 27146 h 1168093"/>
                <a:gd name="connsiteX10" fmla="*/ 58281 w 1385662"/>
                <a:gd name="connsiteY10" fmla="*/ 11906 h 1168093"/>
                <a:gd name="connsiteX11" fmla="*/ 130671 w 1385662"/>
                <a:gd name="connsiteY11" fmla="*/ 476 h 1168093"/>
                <a:gd name="connsiteX12" fmla="*/ 332601 w 1385662"/>
                <a:gd name="connsiteY12" fmla="*/ 4286 h 1168093"/>
                <a:gd name="connsiteX13" fmla="*/ 507861 w 1385662"/>
                <a:gd name="connsiteY13" fmla="*/ 23336 h 1168093"/>
                <a:gd name="connsiteX14" fmla="*/ 725031 w 1385662"/>
                <a:gd name="connsiteY14" fmla="*/ 53816 h 1168093"/>
                <a:gd name="connsiteX15" fmla="*/ 885051 w 1385662"/>
                <a:gd name="connsiteY15" fmla="*/ 91916 h 1168093"/>
                <a:gd name="connsiteX16" fmla="*/ 1056501 w 1385662"/>
                <a:gd name="connsiteY16" fmla="*/ 168116 h 1168093"/>
                <a:gd name="connsiteX17" fmla="*/ 1224141 w 1385662"/>
                <a:gd name="connsiteY17" fmla="*/ 259556 h 1168093"/>
                <a:gd name="connsiteX18" fmla="*/ 1357491 w 1385662"/>
                <a:gd name="connsiteY18" fmla="*/ 377666 h 1168093"/>
                <a:gd name="connsiteX19" fmla="*/ 1384161 w 1385662"/>
                <a:gd name="connsiteY19" fmla="*/ 476726 h 1168093"/>
                <a:gd name="connsiteX20" fmla="*/ 1330821 w 1385662"/>
                <a:gd name="connsiteY20" fmla="*/ 606266 h 1168093"/>
                <a:gd name="connsiteX21" fmla="*/ 1197471 w 1385662"/>
                <a:gd name="connsiteY21" fmla="*/ 640556 h 1168093"/>
                <a:gd name="connsiteX22" fmla="*/ 1117461 w 1385662"/>
                <a:gd name="connsiteY22" fmla="*/ 659606 h 1168093"/>
                <a:gd name="connsiteX23" fmla="*/ 965061 w 1385662"/>
                <a:gd name="connsiteY23" fmla="*/ 655796 h 1168093"/>
                <a:gd name="connsiteX24" fmla="*/ 812661 w 1385662"/>
                <a:gd name="connsiteY24" fmla="*/ 697706 h 1168093"/>
                <a:gd name="connsiteX25" fmla="*/ 747891 w 1385662"/>
                <a:gd name="connsiteY25" fmla="*/ 762476 h 1168093"/>
                <a:gd name="connsiteX26" fmla="*/ 683121 w 1385662"/>
                <a:gd name="connsiteY26" fmla="*/ 812006 h 1168093"/>
                <a:gd name="connsiteX27" fmla="*/ 538341 w 1385662"/>
                <a:gd name="connsiteY27" fmla="*/ 865346 h 1168093"/>
                <a:gd name="connsiteX28" fmla="*/ 389751 w 1385662"/>
                <a:gd name="connsiteY28" fmla="*/ 892016 h 1168093"/>
                <a:gd name="connsiteX29" fmla="*/ 340221 w 1385662"/>
                <a:gd name="connsiteY29" fmla="*/ 899636 h 1168093"/>
                <a:gd name="connsiteX30" fmla="*/ 256401 w 1385662"/>
                <a:gd name="connsiteY30" fmla="*/ 876776 h 1168093"/>
                <a:gd name="connsiteX31" fmla="*/ 225921 w 1385662"/>
                <a:gd name="connsiteY31" fmla="*/ 869156 h 1168093"/>
                <a:gd name="connsiteX32" fmla="*/ 313551 w 1385662"/>
                <a:gd name="connsiteY32" fmla="*/ 926306 h 1168093"/>
                <a:gd name="connsiteX33" fmla="*/ 344031 w 1385662"/>
                <a:gd name="connsiteY33" fmla="*/ 968216 h 1168093"/>
                <a:gd name="connsiteX34" fmla="*/ 317361 w 1385662"/>
                <a:gd name="connsiteY34" fmla="*/ 1059656 h 1168093"/>
                <a:gd name="connsiteX35" fmla="*/ 252591 w 1385662"/>
                <a:gd name="connsiteY35" fmla="*/ 1128236 h 1168093"/>
                <a:gd name="connsiteX36" fmla="*/ 138291 w 1385662"/>
                <a:gd name="connsiteY36" fmla="*/ 1139666 h 1168093"/>
                <a:gd name="connsiteX37" fmla="*/ 187821 w 1385662"/>
                <a:gd name="connsiteY37" fmla="*/ 1132046 h 1168093"/>
                <a:gd name="connsiteX0" fmla="*/ 138291 w 1385662"/>
                <a:gd name="connsiteY0" fmla="*/ 1139666 h 1167935"/>
                <a:gd name="connsiteX1" fmla="*/ 88761 w 1385662"/>
                <a:gd name="connsiteY1" fmla="*/ 1158716 h 1167935"/>
                <a:gd name="connsiteX2" fmla="*/ 27801 w 1385662"/>
                <a:gd name="connsiteY2" fmla="*/ 1166336 h 1167935"/>
                <a:gd name="connsiteX3" fmla="*/ 1131 w 1385662"/>
                <a:gd name="connsiteY3" fmla="*/ 1128236 h 1167935"/>
                <a:gd name="connsiteX4" fmla="*/ 4941 w 1385662"/>
                <a:gd name="connsiteY4" fmla="*/ 987266 h 1167935"/>
                <a:gd name="connsiteX5" fmla="*/ 4941 w 1385662"/>
                <a:gd name="connsiteY5" fmla="*/ 701516 h 1167935"/>
                <a:gd name="connsiteX6" fmla="*/ 1131 w 1385662"/>
                <a:gd name="connsiteY6" fmla="*/ 423386 h 1167935"/>
                <a:gd name="connsiteX7" fmla="*/ 1131 w 1385662"/>
                <a:gd name="connsiteY7" fmla="*/ 217646 h 1167935"/>
                <a:gd name="connsiteX8" fmla="*/ 1131 w 1385662"/>
                <a:gd name="connsiteY8" fmla="*/ 99536 h 1167935"/>
                <a:gd name="connsiteX9" fmla="*/ 8751 w 1385662"/>
                <a:gd name="connsiteY9" fmla="*/ 27146 h 1167935"/>
                <a:gd name="connsiteX10" fmla="*/ 58281 w 1385662"/>
                <a:gd name="connsiteY10" fmla="*/ 11906 h 1167935"/>
                <a:gd name="connsiteX11" fmla="*/ 130671 w 1385662"/>
                <a:gd name="connsiteY11" fmla="*/ 476 h 1167935"/>
                <a:gd name="connsiteX12" fmla="*/ 332601 w 1385662"/>
                <a:gd name="connsiteY12" fmla="*/ 4286 h 1167935"/>
                <a:gd name="connsiteX13" fmla="*/ 507861 w 1385662"/>
                <a:gd name="connsiteY13" fmla="*/ 23336 h 1167935"/>
                <a:gd name="connsiteX14" fmla="*/ 725031 w 1385662"/>
                <a:gd name="connsiteY14" fmla="*/ 53816 h 1167935"/>
                <a:gd name="connsiteX15" fmla="*/ 885051 w 1385662"/>
                <a:gd name="connsiteY15" fmla="*/ 91916 h 1167935"/>
                <a:gd name="connsiteX16" fmla="*/ 1056501 w 1385662"/>
                <a:gd name="connsiteY16" fmla="*/ 168116 h 1167935"/>
                <a:gd name="connsiteX17" fmla="*/ 1224141 w 1385662"/>
                <a:gd name="connsiteY17" fmla="*/ 259556 h 1167935"/>
                <a:gd name="connsiteX18" fmla="*/ 1357491 w 1385662"/>
                <a:gd name="connsiteY18" fmla="*/ 377666 h 1167935"/>
                <a:gd name="connsiteX19" fmla="*/ 1384161 w 1385662"/>
                <a:gd name="connsiteY19" fmla="*/ 476726 h 1167935"/>
                <a:gd name="connsiteX20" fmla="*/ 1330821 w 1385662"/>
                <a:gd name="connsiteY20" fmla="*/ 606266 h 1167935"/>
                <a:gd name="connsiteX21" fmla="*/ 1197471 w 1385662"/>
                <a:gd name="connsiteY21" fmla="*/ 640556 h 1167935"/>
                <a:gd name="connsiteX22" fmla="*/ 1117461 w 1385662"/>
                <a:gd name="connsiteY22" fmla="*/ 659606 h 1167935"/>
                <a:gd name="connsiteX23" fmla="*/ 965061 w 1385662"/>
                <a:gd name="connsiteY23" fmla="*/ 655796 h 1167935"/>
                <a:gd name="connsiteX24" fmla="*/ 812661 w 1385662"/>
                <a:gd name="connsiteY24" fmla="*/ 697706 h 1167935"/>
                <a:gd name="connsiteX25" fmla="*/ 747891 w 1385662"/>
                <a:gd name="connsiteY25" fmla="*/ 762476 h 1167935"/>
                <a:gd name="connsiteX26" fmla="*/ 683121 w 1385662"/>
                <a:gd name="connsiteY26" fmla="*/ 812006 h 1167935"/>
                <a:gd name="connsiteX27" fmla="*/ 538341 w 1385662"/>
                <a:gd name="connsiteY27" fmla="*/ 865346 h 1167935"/>
                <a:gd name="connsiteX28" fmla="*/ 389751 w 1385662"/>
                <a:gd name="connsiteY28" fmla="*/ 892016 h 1167935"/>
                <a:gd name="connsiteX29" fmla="*/ 340221 w 1385662"/>
                <a:gd name="connsiteY29" fmla="*/ 899636 h 1167935"/>
                <a:gd name="connsiteX30" fmla="*/ 256401 w 1385662"/>
                <a:gd name="connsiteY30" fmla="*/ 876776 h 1167935"/>
                <a:gd name="connsiteX31" fmla="*/ 225921 w 1385662"/>
                <a:gd name="connsiteY31" fmla="*/ 869156 h 1167935"/>
                <a:gd name="connsiteX32" fmla="*/ 313551 w 1385662"/>
                <a:gd name="connsiteY32" fmla="*/ 926306 h 1167935"/>
                <a:gd name="connsiteX33" fmla="*/ 344031 w 1385662"/>
                <a:gd name="connsiteY33" fmla="*/ 968216 h 1167935"/>
                <a:gd name="connsiteX34" fmla="*/ 317361 w 1385662"/>
                <a:gd name="connsiteY34" fmla="*/ 1059656 h 1167935"/>
                <a:gd name="connsiteX35" fmla="*/ 252591 w 1385662"/>
                <a:gd name="connsiteY35" fmla="*/ 1128236 h 1167935"/>
                <a:gd name="connsiteX36" fmla="*/ 138291 w 1385662"/>
                <a:gd name="connsiteY36" fmla="*/ 1139666 h 1167935"/>
                <a:gd name="connsiteX0" fmla="*/ 157341 w 1385662"/>
                <a:gd name="connsiteY0" fmla="*/ 1149191 h 1167768"/>
                <a:gd name="connsiteX1" fmla="*/ 88761 w 1385662"/>
                <a:gd name="connsiteY1" fmla="*/ 1158716 h 1167768"/>
                <a:gd name="connsiteX2" fmla="*/ 27801 w 1385662"/>
                <a:gd name="connsiteY2" fmla="*/ 1166336 h 1167768"/>
                <a:gd name="connsiteX3" fmla="*/ 1131 w 1385662"/>
                <a:gd name="connsiteY3" fmla="*/ 1128236 h 1167768"/>
                <a:gd name="connsiteX4" fmla="*/ 4941 w 1385662"/>
                <a:gd name="connsiteY4" fmla="*/ 987266 h 1167768"/>
                <a:gd name="connsiteX5" fmla="*/ 4941 w 1385662"/>
                <a:gd name="connsiteY5" fmla="*/ 701516 h 1167768"/>
                <a:gd name="connsiteX6" fmla="*/ 1131 w 1385662"/>
                <a:gd name="connsiteY6" fmla="*/ 423386 h 1167768"/>
                <a:gd name="connsiteX7" fmla="*/ 1131 w 1385662"/>
                <a:gd name="connsiteY7" fmla="*/ 217646 h 1167768"/>
                <a:gd name="connsiteX8" fmla="*/ 1131 w 1385662"/>
                <a:gd name="connsiteY8" fmla="*/ 99536 h 1167768"/>
                <a:gd name="connsiteX9" fmla="*/ 8751 w 1385662"/>
                <a:gd name="connsiteY9" fmla="*/ 27146 h 1167768"/>
                <a:gd name="connsiteX10" fmla="*/ 58281 w 1385662"/>
                <a:gd name="connsiteY10" fmla="*/ 11906 h 1167768"/>
                <a:gd name="connsiteX11" fmla="*/ 130671 w 1385662"/>
                <a:gd name="connsiteY11" fmla="*/ 476 h 1167768"/>
                <a:gd name="connsiteX12" fmla="*/ 332601 w 1385662"/>
                <a:gd name="connsiteY12" fmla="*/ 4286 h 1167768"/>
                <a:gd name="connsiteX13" fmla="*/ 507861 w 1385662"/>
                <a:gd name="connsiteY13" fmla="*/ 23336 h 1167768"/>
                <a:gd name="connsiteX14" fmla="*/ 725031 w 1385662"/>
                <a:gd name="connsiteY14" fmla="*/ 53816 h 1167768"/>
                <a:gd name="connsiteX15" fmla="*/ 885051 w 1385662"/>
                <a:gd name="connsiteY15" fmla="*/ 91916 h 1167768"/>
                <a:gd name="connsiteX16" fmla="*/ 1056501 w 1385662"/>
                <a:gd name="connsiteY16" fmla="*/ 168116 h 1167768"/>
                <a:gd name="connsiteX17" fmla="*/ 1224141 w 1385662"/>
                <a:gd name="connsiteY17" fmla="*/ 259556 h 1167768"/>
                <a:gd name="connsiteX18" fmla="*/ 1357491 w 1385662"/>
                <a:gd name="connsiteY18" fmla="*/ 377666 h 1167768"/>
                <a:gd name="connsiteX19" fmla="*/ 1384161 w 1385662"/>
                <a:gd name="connsiteY19" fmla="*/ 476726 h 1167768"/>
                <a:gd name="connsiteX20" fmla="*/ 1330821 w 1385662"/>
                <a:gd name="connsiteY20" fmla="*/ 606266 h 1167768"/>
                <a:gd name="connsiteX21" fmla="*/ 1197471 w 1385662"/>
                <a:gd name="connsiteY21" fmla="*/ 640556 h 1167768"/>
                <a:gd name="connsiteX22" fmla="*/ 1117461 w 1385662"/>
                <a:gd name="connsiteY22" fmla="*/ 659606 h 1167768"/>
                <a:gd name="connsiteX23" fmla="*/ 965061 w 1385662"/>
                <a:gd name="connsiteY23" fmla="*/ 655796 h 1167768"/>
                <a:gd name="connsiteX24" fmla="*/ 812661 w 1385662"/>
                <a:gd name="connsiteY24" fmla="*/ 697706 h 1167768"/>
                <a:gd name="connsiteX25" fmla="*/ 747891 w 1385662"/>
                <a:gd name="connsiteY25" fmla="*/ 762476 h 1167768"/>
                <a:gd name="connsiteX26" fmla="*/ 683121 w 1385662"/>
                <a:gd name="connsiteY26" fmla="*/ 812006 h 1167768"/>
                <a:gd name="connsiteX27" fmla="*/ 538341 w 1385662"/>
                <a:gd name="connsiteY27" fmla="*/ 865346 h 1167768"/>
                <a:gd name="connsiteX28" fmla="*/ 389751 w 1385662"/>
                <a:gd name="connsiteY28" fmla="*/ 892016 h 1167768"/>
                <a:gd name="connsiteX29" fmla="*/ 340221 w 1385662"/>
                <a:gd name="connsiteY29" fmla="*/ 899636 h 1167768"/>
                <a:gd name="connsiteX30" fmla="*/ 256401 w 1385662"/>
                <a:gd name="connsiteY30" fmla="*/ 876776 h 1167768"/>
                <a:gd name="connsiteX31" fmla="*/ 225921 w 1385662"/>
                <a:gd name="connsiteY31" fmla="*/ 869156 h 1167768"/>
                <a:gd name="connsiteX32" fmla="*/ 313551 w 1385662"/>
                <a:gd name="connsiteY32" fmla="*/ 926306 h 1167768"/>
                <a:gd name="connsiteX33" fmla="*/ 344031 w 1385662"/>
                <a:gd name="connsiteY33" fmla="*/ 968216 h 1167768"/>
                <a:gd name="connsiteX34" fmla="*/ 317361 w 1385662"/>
                <a:gd name="connsiteY34" fmla="*/ 1059656 h 1167768"/>
                <a:gd name="connsiteX35" fmla="*/ 252591 w 1385662"/>
                <a:gd name="connsiteY35" fmla="*/ 1128236 h 1167768"/>
                <a:gd name="connsiteX36" fmla="*/ 157341 w 1385662"/>
                <a:gd name="connsiteY36" fmla="*/ 1149191 h 11677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</a:cxnLst>
              <a:rect l="l" t="t" r="r" b="b"/>
              <a:pathLst>
                <a:path w="1385662" h="1167768">
                  <a:moveTo>
                    <a:pt x="157341" y="1149191"/>
                  </a:moveTo>
                  <a:cubicBezTo>
                    <a:pt x="130036" y="1154271"/>
                    <a:pt x="110351" y="1155859"/>
                    <a:pt x="88761" y="1158716"/>
                  </a:cubicBezTo>
                  <a:cubicBezTo>
                    <a:pt x="67171" y="1161574"/>
                    <a:pt x="42406" y="1171416"/>
                    <a:pt x="27801" y="1166336"/>
                  </a:cubicBezTo>
                  <a:cubicBezTo>
                    <a:pt x="13196" y="1161256"/>
                    <a:pt x="4941" y="1158081"/>
                    <a:pt x="1131" y="1128236"/>
                  </a:cubicBezTo>
                  <a:cubicBezTo>
                    <a:pt x="-2679" y="1098391"/>
                    <a:pt x="4306" y="1058386"/>
                    <a:pt x="4941" y="987266"/>
                  </a:cubicBezTo>
                  <a:cubicBezTo>
                    <a:pt x="5576" y="916146"/>
                    <a:pt x="5576" y="795496"/>
                    <a:pt x="4941" y="701516"/>
                  </a:cubicBezTo>
                  <a:cubicBezTo>
                    <a:pt x="4306" y="607536"/>
                    <a:pt x="1766" y="504031"/>
                    <a:pt x="1131" y="423386"/>
                  </a:cubicBezTo>
                  <a:cubicBezTo>
                    <a:pt x="496" y="342741"/>
                    <a:pt x="1131" y="217646"/>
                    <a:pt x="1131" y="217646"/>
                  </a:cubicBezTo>
                  <a:cubicBezTo>
                    <a:pt x="1131" y="163671"/>
                    <a:pt x="-139" y="131286"/>
                    <a:pt x="1131" y="99536"/>
                  </a:cubicBezTo>
                  <a:cubicBezTo>
                    <a:pt x="2401" y="67786"/>
                    <a:pt x="-774" y="41751"/>
                    <a:pt x="8751" y="27146"/>
                  </a:cubicBezTo>
                  <a:cubicBezTo>
                    <a:pt x="18276" y="12541"/>
                    <a:pt x="37961" y="16351"/>
                    <a:pt x="58281" y="11906"/>
                  </a:cubicBezTo>
                  <a:cubicBezTo>
                    <a:pt x="78601" y="7461"/>
                    <a:pt x="130671" y="476"/>
                    <a:pt x="130671" y="476"/>
                  </a:cubicBezTo>
                  <a:cubicBezTo>
                    <a:pt x="176391" y="-794"/>
                    <a:pt x="269736" y="476"/>
                    <a:pt x="332601" y="4286"/>
                  </a:cubicBezTo>
                  <a:cubicBezTo>
                    <a:pt x="395466" y="8096"/>
                    <a:pt x="507861" y="23336"/>
                    <a:pt x="507861" y="23336"/>
                  </a:cubicBezTo>
                  <a:cubicBezTo>
                    <a:pt x="573266" y="31591"/>
                    <a:pt x="662166" y="42386"/>
                    <a:pt x="725031" y="53816"/>
                  </a:cubicBezTo>
                  <a:cubicBezTo>
                    <a:pt x="787896" y="65246"/>
                    <a:pt x="829806" y="72866"/>
                    <a:pt x="885051" y="91916"/>
                  </a:cubicBezTo>
                  <a:cubicBezTo>
                    <a:pt x="940296" y="110966"/>
                    <a:pt x="999986" y="140176"/>
                    <a:pt x="1056501" y="168116"/>
                  </a:cubicBezTo>
                  <a:cubicBezTo>
                    <a:pt x="1113016" y="196056"/>
                    <a:pt x="1173976" y="224631"/>
                    <a:pt x="1224141" y="259556"/>
                  </a:cubicBezTo>
                  <a:cubicBezTo>
                    <a:pt x="1274306" y="294481"/>
                    <a:pt x="1330821" y="341471"/>
                    <a:pt x="1357491" y="377666"/>
                  </a:cubicBezTo>
                  <a:cubicBezTo>
                    <a:pt x="1384161" y="413861"/>
                    <a:pt x="1388606" y="438626"/>
                    <a:pt x="1384161" y="476726"/>
                  </a:cubicBezTo>
                  <a:cubicBezTo>
                    <a:pt x="1379716" y="514826"/>
                    <a:pt x="1361936" y="578961"/>
                    <a:pt x="1330821" y="606266"/>
                  </a:cubicBezTo>
                  <a:cubicBezTo>
                    <a:pt x="1299706" y="633571"/>
                    <a:pt x="1233031" y="631666"/>
                    <a:pt x="1197471" y="640556"/>
                  </a:cubicBezTo>
                  <a:cubicBezTo>
                    <a:pt x="1161911" y="649446"/>
                    <a:pt x="1156196" y="657066"/>
                    <a:pt x="1117461" y="659606"/>
                  </a:cubicBezTo>
                  <a:cubicBezTo>
                    <a:pt x="1078726" y="662146"/>
                    <a:pt x="1015861" y="649446"/>
                    <a:pt x="965061" y="655796"/>
                  </a:cubicBezTo>
                  <a:cubicBezTo>
                    <a:pt x="914261" y="662146"/>
                    <a:pt x="848856" y="679926"/>
                    <a:pt x="812661" y="697706"/>
                  </a:cubicBezTo>
                  <a:cubicBezTo>
                    <a:pt x="776466" y="715486"/>
                    <a:pt x="769481" y="743426"/>
                    <a:pt x="747891" y="762476"/>
                  </a:cubicBezTo>
                  <a:cubicBezTo>
                    <a:pt x="726301" y="781526"/>
                    <a:pt x="718046" y="794861"/>
                    <a:pt x="683121" y="812006"/>
                  </a:cubicBezTo>
                  <a:cubicBezTo>
                    <a:pt x="648196" y="829151"/>
                    <a:pt x="587236" y="852011"/>
                    <a:pt x="538341" y="865346"/>
                  </a:cubicBezTo>
                  <a:cubicBezTo>
                    <a:pt x="489446" y="878681"/>
                    <a:pt x="389751" y="892016"/>
                    <a:pt x="389751" y="892016"/>
                  </a:cubicBezTo>
                  <a:cubicBezTo>
                    <a:pt x="356731" y="897731"/>
                    <a:pt x="362446" y="902176"/>
                    <a:pt x="340221" y="899636"/>
                  </a:cubicBezTo>
                  <a:cubicBezTo>
                    <a:pt x="317996" y="897096"/>
                    <a:pt x="256401" y="876776"/>
                    <a:pt x="256401" y="876776"/>
                  </a:cubicBezTo>
                  <a:cubicBezTo>
                    <a:pt x="237351" y="871696"/>
                    <a:pt x="216396" y="860901"/>
                    <a:pt x="225921" y="869156"/>
                  </a:cubicBezTo>
                  <a:cubicBezTo>
                    <a:pt x="235446" y="877411"/>
                    <a:pt x="293866" y="909796"/>
                    <a:pt x="313551" y="926306"/>
                  </a:cubicBezTo>
                  <a:cubicBezTo>
                    <a:pt x="333236" y="942816"/>
                    <a:pt x="343396" y="945991"/>
                    <a:pt x="344031" y="968216"/>
                  </a:cubicBezTo>
                  <a:cubicBezTo>
                    <a:pt x="344666" y="990441"/>
                    <a:pt x="332601" y="1032986"/>
                    <a:pt x="317361" y="1059656"/>
                  </a:cubicBezTo>
                  <a:cubicBezTo>
                    <a:pt x="302121" y="1086326"/>
                    <a:pt x="282436" y="1114901"/>
                    <a:pt x="252591" y="1128236"/>
                  </a:cubicBezTo>
                  <a:cubicBezTo>
                    <a:pt x="222746" y="1141571"/>
                    <a:pt x="184646" y="1144111"/>
                    <a:pt x="157341" y="1149191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9BDD03DF-1051-73F7-7249-6037894244D9}"/>
              </a:ext>
            </a:extLst>
          </p:cNvPr>
          <p:cNvGrpSpPr/>
          <p:nvPr/>
        </p:nvGrpSpPr>
        <p:grpSpPr>
          <a:xfrm>
            <a:off x="8314035" y="4182248"/>
            <a:ext cx="2291944" cy="1749039"/>
            <a:chOff x="8230056" y="4639450"/>
            <a:chExt cx="2291944" cy="1749039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849C6E2C-067C-750E-1E0A-1B6ECB24214A}"/>
                </a:ext>
              </a:extLst>
            </p:cNvPr>
            <p:cNvGrpSpPr/>
            <p:nvPr/>
          </p:nvGrpSpPr>
          <p:grpSpPr>
            <a:xfrm>
              <a:off x="8230056" y="4639450"/>
              <a:ext cx="2291944" cy="1749039"/>
              <a:chOff x="803910" y="3821249"/>
              <a:chExt cx="2291944" cy="1749039"/>
            </a:xfrm>
          </p:grpSpPr>
          <p:sp>
            <p:nvSpPr>
              <p:cNvPr id="6" name="フリーフォーム: 図形 5">
                <a:extLst>
                  <a:ext uri="{FF2B5EF4-FFF2-40B4-BE49-F238E27FC236}">
                    <a16:creationId xmlns:a16="http://schemas.microsoft.com/office/drawing/2014/main" id="{FDD2BD54-FAEF-622F-3F32-A96A70E797FB}"/>
                  </a:ext>
                </a:extLst>
              </p:cNvPr>
              <p:cNvSpPr/>
              <p:nvPr/>
            </p:nvSpPr>
            <p:spPr>
              <a:xfrm>
                <a:off x="803910" y="3839152"/>
                <a:ext cx="1002549" cy="1731136"/>
              </a:xfrm>
              <a:custGeom>
                <a:avLst/>
                <a:gdLst>
                  <a:gd name="connsiteX0" fmla="*/ 476250 w 1002549"/>
                  <a:gd name="connsiteY0" fmla="*/ 188018 h 1731136"/>
                  <a:gd name="connsiteX1" fmla="*/ 563880 w 1002549"/>
                  <a:gd name="connsiteY1" fmla="*/ 127058 h 1731136"/>
                  <a:gd name="connsiteX2" fmla="*/ 674370 w 1002549"/>
                  <a:gd name="connsiteY2" fmla="*/ 73718 h 1731136"/>
                  <a:gd name="connsiteX3" fmla="*/ 788670 w 1002549"/>
                  <a:gd name="connsiteY3" fmla="*/ 31808 h 1731136"/>
                  <a:gd name="connsiteX4" fmla="*/ 857250 w 1002549"/>
                  <a:gd name="connsiteY4" fmla="*/ 16568 h 1731136"/>
                  <a:gd name="connsiteX5" fmla="*/ 891540 w 1002549"/>
                  <a:gd name="connsiteY5" fmla="*/ 8948 h 1731136"/>
                  <a:gd name="connsiteX6" fmla="*/ 960120 w 1002549"/>
                  <a:gd name="connsiteY6" fmla="*/ 5138 h 1731136"/>
                  <a:gd name="connsiteX7" fmla="*/ 990600 w 1002549"/>
                  <a:gd name="connsiteY7" fmla="*/ 85148 h 1731136"/>
                  <a:gd name="connsiteX8" fmla="*/ 998220 w 1002549"/>
                  <a:gd name="connsiteY8" fmla="*/ 290888 h 1731136"/>
                  <a:gd name="connsiteX9" fmla="*/ 1002030 w 1002549"/>
                  <a:gd name="connsiteY9" fmla="*/ 549968 h 1731136"/>
                  <a:gd name="connsiteX10" fmla="*/ 986790 w 1002549"/>
                  <a:gd name="connsiteY10" fmla="*/ 725228 h 1731136"/>
                  <a:gd name="connsiteX11" fmla="*/ 979170 w 1002549"/>
                  <a:gd name="connsiteY11" fmla="*/ 915728 h 1731136"/>
                  <a:gd name="connsiteX12" fmla="*/ 982980 w 1002549"/>
                  <a:gd name="connsiteY12" fmla="*/ 1014788 h 1731136"/>
                  <a:gd name="connsiteX13" fmla="*/ 956310 w 1002549"/>
                  <a:gd name="connsiteY13" fmla="*/ 1083368 h 1731136"/>
                  <a:gd name="connsiteX14" fmla="*/ 941070 w 1002549"/>
                  <a:gd name="connsiteY14" fmla="*/ 1121468 h 1731136"/>
                  <a:gd name="connsiteX15" fmla="*/ 906780 w 1002549"/>
                  <a:gd name="connsiteY15" fmla="*/ 1140518 h 1731136"/>
                  <a:gd name="connsiteX16" fmla="*/ 883920 w 1002549"/>
                  <a:gd name="connsiteY16" fmla="*/ 1190048 h 1731136"/>
                  <a:gd name="connsiteX17" fmla="*/ 887730 w 1002549"/>
                  <a:gd name="connsiteY17" fmla="*/ 1300538 h 1731136"/>
                  <a:gd name="connsiteX18" fmla="*/ 883920 w 1002549"/>
                  <a:gd name="connsiteY18" fmla="*/ 1414838 h 1731136"/>
                  <a:gd name="connsiteX19" fmla="*/ 864870 w 1002549"/>
                  <a:gd name="connsiteY19" fmla="*/ 1544378 h 1731136"/>
                  <a:gd name="connsiteX20" fmla="*/ 803910 w 1002549"/>
                  <a:gd name="connsiteY20" fmla="*/ 1632008 h 1731136"/>
                  <a:gd name="connsiteX21" fmla="*/ 739140 w 1002549"/>
                  <a:gd name="connsiteY21" fmla="*/ 1681538 h 1731136"/>
                  <a:gd name="connsiteX22" fmla="*/ 624840 w 1002549"/>
                  <a:gd name="connsiteY22" fmla="*/ 1719638 h 1731136"/>
                  <a:gd name="connsiteX23" fmla="*/ 506730 w 1002549"/>
                  <a:gd name="connsiteY23" fmla="*/ 1731068 h 1731136"/>
                  <a:gd name="connsiteX24" fmla="*/ 346710 w 1002549"/>
                  <a:gd name="connsiteY24" fmla="*/ 1715828 h 1731136"/>
                  <a:gd name="connsiteX25" fmla="*/ 201930 w 1002549"/>
                  <a:gd name="connsiteY25" fmla="*/ 1647248 h 1731136"/>
                  <a:gd name="connsiteX26" fmla="*/ 91440 w 1002549"/>
                  <a:gd name="connsiteY26" fmla="*/ 1487228 h 1731136"/>
                  <a:gd name="connsiteX27" fmla="*/ 26670 w 1002549"/>
                  <a:gd name="connsiteY27" fmla="*/ 1319588 h 1731136"/>
                  <a:gd name="connsiteX28" fmla="*/ 0 w 1002549"/>
                  <a:gd name="connsiteY28" fmla="*/ 1094798 h 1731136"/>
                  <a:gd name="connsiteX29" fmla="*/ 26670 w 1002549"/>
                  <a:gd name="connsiteY29" fmla="*/ 816668 h 1731136"/>
                  <a:gd name="connsiteX30" fmla="*/ 118110 w 1002549"/>
                  <a:gd name="connsiteY30" fmla="*/ 569018 h 1731136"/>
                  <a:gd name="connsiteX31" fmla="*/ 247650 w 1002549"/>
                  <a:gd name="connsiteY31" fmla="*/ 378518 h 1731136"/>
                  <a:gd name="connsiteX32" fmla="*/ 361950 w 1002549"/>
                  <a:gd name="connsiteY32" fmla="*/ 275648 h 1731136"/>
                  <a:gd name="connsiteX33" fmla="*/ 476250 w 1002549"/>
                  <a:gd name="connsiteY33" fmla="*/ 188018 h 1731136"/>
                  <a:gd name="connsiteX0" fmla="*/ 476250 w 1002549"/>
                  <a:gd name="connsiteY0" fmla="*/ 188018 h 1731136"/>
                  <a:gd name="connsiteX1" fmla="*/ 563880 w 1002549"/>
                  <a:gd name="connsiteY1" fmla="*/ 127058 h 1731136"/>
                  <a:gd name="connsiteX2" fmla="*/ 674370 w 1002549"/>
                  <a:gd name="connsiteY2" fmla="*/ 73718 h 1731136"/>
                  <a:gd name="connsiteX3" fmla="*/ 788670 w 1002549"/>
                  <a:gd name="connsiteY3" fmla="*/ 31808 h 1731136"/>
                  <a:gd name="connsiteX4" fmla="*/ 857250 w 1002549"/>
                  <a:gd name="connsiteY4" fmla="*/ 16568 h 1731136"/>
                  <a:gd name="connsiteX5" fmla="*/ 891540 w 1002549"/>
                  <a:gd name="connsiteY5" fmla="*/ 8948 h 1731136"/>
                  <a:gd name="connsiteX6" fmla="*/ 960120 w 1002549"/>
                  <a:gd name="connsiteY6" fmla="*/ 5138 h 1731136"/>
                  <a:gd name="connsiteX7" fmla="*/ 990600 w 1002549"/>
                  <a:gd name="connsiteY7" fmla="*/ 85148 h 1731136"/>
                  <a:gd name="connsiteX8" fmla="*/ 998220 w 1002549"/>
                  <a:gd name="connsiteY8" fmla="*/ 290888 h 1731136"/>
                  <a:gd name="connsiteX9" fmla="*/ 1002030 w 1002549"/>
                  <a:gd name="connsiteY9" fmla="*/ 549968 h 1731136"/>
                  <a:gd name="connsiteX10" fmla="*/ 986790 w 1002549"/>
                  <a:gd name="connsiteY10" fmla="*/ 725228 h 1731136"/>
                  <a:gd name="connsiteX11" fmla="*/ 979170 w 1002549"/>
                  <a:gd name="connsiteY11" fmla="*/ 915728 h 1731136"/>
                  <a:gd name="connsiteX12" fmla="*/ 982980 w 1002549"/>
                  <a:gd name="connsiteY12" fmla="*/ 1014788 h 1731136"/>
                  <a:gd name="connsiteX13" fmla="*/ 956310 w 1002549"/>
                  <a:gd name="connsiteY13" fmla="*/ 1083368 h 1731136"/>
                  <a:gd name="connsiteX14" fmla="*/ 941070 w 1002549"/>
                  <a:gd name="connsiteY14" fmla="*/ 1121468 h 1731136"/>
                  <a:gd name="connsiteX15" fmla="*/ 916305 w 1002549"/>
                  <a:gd name="connsiteY15" fmla="*/ 1153853 h 1731136"/>
                  <a:gd name="connsiteX16" fmla="*/ 883920 w 1002549"/>
                  <a:gd name="connsiteY16" fmla="*/ 1190048 h 1731136"/>
                  <a:gd name="connsiteX17" fmla="*/ 887730 w 1002549"/>
                  <a:gd name="connsiteY17" fmla="*/ 1300538 h 1731136"/>
                  <a:gd name="connsiteX18" fmla="*/ 883920 w 1002549"/>
                  <a:gd name="connsiteY18" fmla="*/ 1414838 h 1731136"/>
                  <a:gd name="connsiteX19" fmla="*/ 864870 w 1002549"/>
                  <a:gd name="connsiteY19" fmla="*/ 1544378 h 1731136"/>
                  <a:gd name="connsiteX20" fmla="*/ 803910 w 1002549"/>
                  <a:gd name="connsiteY20" fmla="*/ 1632008 h 1731136"/>
                  <a:gd name="connsiteX21" fmla="*/ 739140 w 1002549"/>
                  <a:gd name="connsiteY21" fmla="*/ 1681538 h 1731136"/>
                  <a:gd name="connsiteX22" fmla="*/ 624840 w 1002549"/>
                  <a:gd name="connsiteY22" fmla="*/ 1719638 h 1731136"/>
                  <a:gd name="connsiteX23" fmla="*/ 506730 w 1002549"/>
                  <a:gd name="connsiteY23" fmla="*/ 1731068 h 1731136"/>
                  <a:gd name="connsiteX24" fmla="*/ 346710 w 1002549"/>
                  <a:gd name="connsiteY24" fmla="*/ 1715828 h 1731136"/>
                  <a:gd name="connsiteX25" fmla="*/ 201930 w 1002549"/>
                  <a:gd name="connsiteY25" fmla="*/ 1647248 h 1731136"/>
                  <a:gd name="connsiteX26" fmla="*/ 91440 w 1002549"/>
                  <a:gd name="connsiteY26" fmla="*/ 1487228 h 1731136"/>
                  <a:gd name="connsiteX27" fmla="*/ 26670 w 1002549"/>
                  <a:gd name="connsiteY27" fmla="*/ 1319588 h 1731136"/>
                  <a:gd name="connsiteX28" fmla="*/ 0 w 1002549"/>
                  <a:gd name="connsiteY28" fmla="*/ 1094798 h 1731136"/>
                  <a:gd name="connsiteX29" fmla="*/ 26670 w 1002549"/>
                  <a:gd name="connsiteY29" fmla="*/ 816668 h 1731136"/>
                  <a:gd name="connsiteX30" fmla="*/ 118110 w 1002549"/>
                  <a:gd name="connsiteY30" fmla="*/ 569018 h 1731136"/>
                  <a:gd name="connsiteX31" fmla="*/ 247650 w 1002549"/>
                  <a:gd name="connsiteY31" fmla="*/ 378518 h 1731136"/>
                  <a:gd name="connsiteX32" fmla="*/ 361950 w 1002549"/>
                  <a:gd name="connsiteY32" fmla="*/ 275648 h 1731136"/>
                  <a:gd name="connsiteX33" fmla="*/ 476250 w 1002549"/>
                  <a:gd name="connsiteY33" fmla="*/ 188018 h 1731136"/>
                  <a:gd name="connsiteX0" fmla="*/ 476250 w 1002549"/>
                  <a:gd name="connsiteY0" fmla="*/ 188018 h 1731136"/>
                  <a:gd name="connsiteX1" fmla="*/ 563880 w 1002549"/>
                  <a:gd name="connsiteY1" fmla="*/ 127058 h 1731136"/>
                  <a:gd name="connsiteX2" fmla="*/ 674370 w 1002549"/>
                  <a:gd name="connsiteY2" fmla="*/ 73718 h 1731136"/>
                  <a:gd name="connsiteX3" fmla="*/ 788670 w 1002549"/>
                  <a:gd name="connsiteY3" fmla="*/ 31808 h 1731136"/>
                  <a:gd name="connsiteX4" fmla="*/ 857250 w 1002549"/>
                  <a:gd name="connsiteY4" fmla="*/ 16568 h 1731136"/>
                  <a:gd name="connsiteX5" fmla="*/ 891540 w 1002549"/>
                  <a:gd name="connsiteY5" fmla="*/ 8948 h 1731136"/>
                  <a:gd name="connsiteX6" fmla="*/ 960120 w 1002549"/>
                  <a:gd name="connsiteY6" fmla="*/ 5138 h 1731136"/>
                  <a:gd name="connsiteX7" fmla="*/ 990600 w 1002549"/>
                  <a:gd name="connsiteY7" fmla="*/ 85148 h 1731136"/>
                  <a:gd name="connsiteX8" fmla="*/ 998220 w 1002549"/>
                  <a:gd name="connsiteY8" fmla="*/ 290888 h 1731136"/>
                  <a:gd name="connsiteX9" fmla="*/ 1002030 w 1002549"/>
                  <a:gd name="connsiteY9" fmla="*/ 549968 h 1731136"/>
                  <a:gd name="connsiteX10" fmla="*/ 986790 w 1002549"/>
                  <a:gd name="connsiteY10" fmla="*/ 725228 h 1731136"/>
                  <a:gd name="connsiteX11" fmla="*/ 979170 w 1002549"/>
                  <a:gd name="connsiteY11" fmla="*/ 915728 h 1731136"/>
                  <a:gd name="connsiteX12" fmla="*/ 982980 w 1002549"/>
                  <a:gd name="connsiteY12" fmla="*/ 1014788 h 1731136"/>
                  <a:gd name="connsiteX13" fmla="*/ 956310 w 1002549"/>
                  <a:gd name="connsiteY13" fmla="*/ 1083368 h 1731136"/>
                  <a:gd name="connsiteX14" fmla="*/ 941070 w 1002549"/>
                  <a:gd name="connsiteY14" fmla="*/ 1121468 h 1731136"/>
                  <a:gd name="connsiteX15" fmla="*/ 916305 w 1002549"/>
                  <a:gd name="connsiteY15" fmla="*/ 1153853 h 1731136"/>
                  <a:gd name="connsiteX16" fmla="*/ 895350 w 1002549"/>
                  <a:gd name="connsiteY16" fmla="*/ 1199573 h 1731136"/>
                  <a:gd name="connsiteX17" fmla="*/ 887730 w 1002549"/>
                  <a:gd name="connsiteY17" fmla="*/ 1300538 h 1731136"/>
                  <a:gd name="connsiteX18" fmla="*/ 883920 w 1002549"/>
                  <a:gd name="connsiteY18" fmla="*/ 1414838 h 1731136"/>
                  <a:gd name="connsiteX19" fmla="*/ 864870 w 1002549"/>
                  <a:gd name="connsiteY19" fmla="*/ 1544378 h 1731136"/>
                  <a:gd name="connsiteX20" fmla="*/ 803910 w 1002549"/>
                  <a:gd name="connsiteY20" fmla="*/ 1632008 h 1731136"/>
                  <a:gd name="connsiteX21" fmla="*/ 739140 w 1002549"/>
                  <a:gd name="connsiteY21" fmla="*/ 1681538 h 1731136"/>
                  <a:gd name="connsiteX22" fmla="*/ 624840 w 1002549"/>
                  <a:gd name="connsiteY22" fmla="*/ 1719638 h 1731136"/>
                  <a:gd name="connsiteX23" fmla="*/ 506730 w 1002549"/>
                  <a:gd name="connsiteY23" fmla="*/ 1731068 h 1731136"/>
                  <a:gd name="connsiteX24" fmla="*/ 346710 w 1002549"/>
                  <a:gd name="connsiteY24" fmla="*/ 1715828 h 1731136"/>
                  <a:gd name="connsiteX25" fmla="*/ 201930 w 1002549"/>
                  <a:gd name="connsiteY25" fmla="*/ 1647248 h 1731136"/>
                  <a:gd name="connsiteX26" fmla="*/ 91440 w 1002549"/>
                  <a:gd name="connsiteY26" fmla="*/ 1487228 h 1731136"/>
                  <a:gd name="connsiteX27" fmla="*/ 26670 w 1002549"/>
                  <a:gd name="connsiteY27" fmla="*/ 1319588 h 1731136"/>
                  <a:gd name="connsiteX28" fmla="*/ 0 w 1002549"/>
                  <a:gd name="connsiteY28" fmla="*/ 1094798 h 1731136"/>
                  <a:gd name="connsiteX29" fmla="*/ 26670 w 1002549"/>
                  <a:gd name="connsiteY29" fmla="*/ 816668 h 1731136"/>
                  <a:gd name="connsiteX30" fmla="*/ 118110 w 1002549"/>
                  <a:gd name="connsiteY30" fmla="*/ 569018 h 1731136"/>
                  <a:gd name="connsiteX31" fmla="*/ 247650 w 1002549"/>
                  <a:gd name="connsiteY31" fmla="*/ 378518 h 1731136"/>
                  <a:gd name="connsiteX32" fmla="*/ 361950 w 1002549"/>
                  <a:gd name="connsiteY32" fmla="*/ 275648 h 1731136"/>
                  <a:gd name="connsiteX33" fmla="*/ 476250 w 1002549"/>
                  <a:gd name="connsiteY33" fmla="*/ 188018 h 17311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</a:cxnLst>
                <a:rect l="l" t="t" r="r" b="b"/>
                <a:pathLst>
                  <a:path w="1002549" h="1731136">
                    <a:moveTo>
                      <a:pt x="476250" y="188018"/>
                    </a:moveTo>
                    <a:cubicBezTo>
                      <a:pt x="509905" y="163253"/>
                      <a:pt x="530860" y="146108"/>
                      <a:pt x="563880" y="127058"/>
                    </a:cubicBezTo>
                    <a:cubicBezTo>
                      <a:pt x="596900" y="108008"/>
                      <a:pt x="636905" y="89593"/>
                      <a:pt x="674370" y="73718"/>
                    </a:cubicBezTo>
                    <a:cubicBezTo>
                      <a:pt x="711835" y="57843"/>
                      <a:pt x="758190" y="41333"/>
                      <a:pt x="788670" y="31808"/>
                    </a:cubicBezTo>
                    <a:cubicBezTo>
                      <a:pt x="819150" y="22283"/>
                      <a:pt x="840105" y="20378"/>
                      <a:pt x="857250" y="16568"/>
                    </a:cubicBezTo>
                    <a:cubicBezTo>
                      <a:pt x="874395" y="12758"/>
                      <a:pt x="874395" y="10853"/>
                      <a:pt x="891540" y="8948"/>
                    </a:cubicBezTo>
                    <a:cubicBezTo>
                      <a:pt x="908685" y="7043"/>
                      <a:pt x="943610" y="-7562"/>
                      <a:pt x="960120" y="5138"/>
                    </a:cubicBezTo>
                    <a:cubicBezTo>
                      <a:pt x="976630" y="17838"/>
                      <a:pt x="984250" y="37523"/>
                      <a:pt x="990600" y="85148"/>
                    </a:cubicBezTo>
                    <a:cubicBezTo>
                      <a:pt x="996950" y="132773"/>
                      <a:pt x="996315" y="213418"/>
                      <a:pt x="998220" y="290888"/>
                    </a:cubicBezTo>
                    <a:cubicBezTo>
                      <a:pt x="1000125" y="368358"/>
                      <a:pt x="1003935" y="477578"/>
                      <a:pt x="1002030" y="549968"/>
                    </a:cubicBezTo>
                    <a:cubicBezTo>
                      <a:pt x="1000125" y="622358"/>
                      <a:pt x="990600" y="664268"/>
                      <a:pt x="986790" y="725228"/>
                    </a:cubicBezTo>
                    <a:cubicBezTo>
                      <a:pt x="982980" y="786188"/>
                      <a:pt x="979805" y="867468"/>
                      <a:pt x="979170" y="915728"/>
                    </a:cubicBezTo>
                    <a:cubicBezTo>
                      <a:pt x="978535" y="963988"/>
                      <a:pt x="986790" y="986848"/>
                      <a:pt x="982980" y="1014788"/>
                    </a:cubicBezTo>
                    <a:cubicBezTo>
                      <a:pt x="979170" y="1042728"/>
                      <a:pt x="963295" y="1065588"/>
                      <a:pt x="956310" y="1083368"/>
                    </a:cubicBezTo>
                    <a:cubicBezTo>
                      <a:pt x="949325" y="1101148"/>
                      <a:pt x="947738" y="1109721"/>
                      <a:pt x="941070" y="1121468"/>
                    </a:cubicBezTo>
                    <a:cubicBezTo>
                      <a:pt x="934403" y="1133216"/>
                      <a:pt x="923925" y="1140836"/>
                      <a:pt x="916305" y="1153853"/>
                    </a:cubicBezTo>
                    <a:cubicBezTo>
                      <a:pt x="908685" y="1166870"/>
                      <a:pt x="900112" y="1175126"/>
                      <a:pt x="895350" y="1199573"/>
                    </a:cubicBezTo>
                    <a:cubicBezTo>
                      <a:pt x="890588" y="1224020"/>
                      <a:pt x="889635" y="1264661"/>
                      <a:pt x="887730" y="1300538"/>
                    </a:cubicBezTo>
                    <a:cubicBezTo>
                      <a:pt x="885825" y="1336415"/>
                      <a:pt x="887730" y="1374198"/>
                      <a:pt x="883920" y="1414838"/>
                    </a:cubicBezTo>
                    <a:cubicBezTo>
                      <a:pt x="880110" y="1455478"/>
                      <a:pt x="878205" y="1508183"/>
                      <a:pt x="864870" y="1544378"/>
                    </a:cubicBezTo>
                    <a:cubicBezTo>
                      <a:pt x="851535" y="1580573"/>
                      <a:pt x="824865" y="1609148"/>
                      <a:pt x="803910" y="1632008"/>
                    </a:cubicBezTo>
                    <a:cubicBezTo>
                      <a:pt x="782955" y="1654868"/>
                      <a:pt x="768985" y="1666933"/>
                      <a:pt x="739140" y="1681538"/>
                    </a:cubicBezTo>
                    <a:cubicBezTo>
                      <a:pt x="709295" y="1696143"/>
                      <a:pt x="663575" y="1711383"/>
                      <a:pt x="624840" y="1719638"/>
                    </a:cubicBezTo>
                    <a:cubicBezTo>
                      <a:pt x="586105" y="1727893"/>
                      <a:pt x="553085" y="1731703"/>
                      <a:pt x="506730" y="1731068"/>
                    </a:cubicBezTo>
                    <a:cubicBezTo>
                      <a:pt x="460375" y="1730433"/>
                      <a:pt x="397510" y="1729798"/>
                      <a:pt x="346710" y="1715828"/>
                    </a:cubicBezTo>
                    <a:cubicBezTo>
                      <a:pt x="295910" y="1701858"/>
                      <a:pt x="244475" y="1685348"/>
                      <a:pt x="201930" y="1647248"/>
                    </a:cubicBezTo>
                    <a:cubicBezTo>
                      <a:pt x="159385" y="1609148"/>
                      <a:pt x="120650" y="1541838"/>
                      <a:pt x="91440" y="1487228"/>
                    </a:cubicBezTo>
                    <a:cubicBezTo>
                      <a:pt x="62230" y="1432618"/>
                      <a:pt x="41910" y="1384993"/>
                      <a:pt x="26670" y="1319588"/>
                    </a:cubicBezTo>
                    <a:cubicBezTo>
                      <a:pt x="11430" y="1254183"/>
                      <a:pt x="0" y="1178618"/>
                      <a:pt x="0" y="1094798"/>
                    </a:cubicBezTo>
                    <a:cubicBezTo>
                      <a:pt x="0" y="1010978"/>
                      <a:pt x="6985" y="904298"/>
                      <a:pt x="26670" y="816668"/>
                    </a:cubicBezTo>
                    <a:cubicBezTo>
                      <a:pt x="46355" y="729038"/>
                      <a:pt x="81280" y="642043"/>
                      <a:pt x="118110" y="569018"/>
                    </a:cubicBezTo>
                    <a:cubicBezTo>
                      <a:pt x="154940" y="495993"/>
                      <a:pt x="207010" y="427413"/>
                      <a:pt x="247650" y="378518"/>
                    </a:cubicBezTo>
                    <a:cubicBezTo>
                      <a:pt x="288290" y="329623"/>
                      <a:pt x="329565" y="302953"/>
                      <a:pt x="361950" y="275648"/>
                    </a:cubicBezTo>
                    <a:cubicBezTo>
                      <a:pt x="394335" y="248343"/>
                      <a:pt x="442595" y="212783"/>
                      <a:pt x="476250" y="188018"/>
                    </a:cubicBez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" name="フリーフォーム: 図形 8">
                <a:extLst>
                  <a:ext uri="{FF2B5EF4-FFF2-40B4-BE49-F238E27FC236}">
                    <a16:creationId xmlns:a16="http://schemas.microsoft.com/office/drawing/2014/main" id="{C0369A4C-A55D-436D-9219-53B5568D6B14}"/>
                  </a:ext>
                </a:extLst>
              </p:cNvPr>
              <p:cNvSpPr/>
              <p:nvPr/>
            </p:nvSpPr>
            <p:spPr>
              <a:xfrm>
                <a:off x="1710192" y="3821249"/>
                <a:ext cx="1385662" cy="1167768"/>
              </a:xfrm>
              <a:custGeom>
                <a:avLst/>
                <a:gdLst>
                  <a:gd name="connsiteX0" fmla="*/ 187821 w 1385662"/>
                  <a:gd name="connsiteY0" fmla="*/ 1132046 h 1168093"/>
                  <a:gd name="connsiteX1" fmla="*/ 88761 w 1385662"/>
                  <a:gd name="connsiteY1" fmla="*/ 1158716 h 1168093"/>
                  <a:gd name="connsiteX2" fmla="*/ 27801 w 1385662"/>
                  <a:gd name="connsiteY2" fmla="*/ 1166336 h 1168093"/>
                  <a:gd name="connsiteX3" fmla="*/ 1131 w 1385662"/>
                  <a:gd name="connsiteY3" fmla="*/ 1128236 h 1168093"/>
                  <a:gd name="connsiteX4" fmla="*/ 4941 w 1385662"/>
                  <a:gd name="connsiteY4" fmla="*/ 987266 h 1168093"/>
                  <a:gd name="connsiteX5" fmla="*/ 4941 w 1385662"/>
                  <a:gd name="connsiteY5" fmla="*/ 701516 h 1168093"/>
                  <a:gd name="connsiteX6" fmla="*/ 1131 w 1385662"/>
                  <a:gd name="connsiteY6" fmla="*/ 423386 h 1168093"/>
                  <a:gd name="connsiteX7" fmla="*/ 1131 w 1385662"/>
                  <a:gd name="connsiteY7" fmla="*/ 217646 h 1168093"/>
                  <a:gd name="connsiteX8" fmla="*/ 1131 w 1385662"/>
                  <a:gd name="connsiteY8" fmla="*/ 99536 h 1168093"/>
                  <a:gd name="connsiteX9" fmla="*/ 8751 w 1385662"/>
                  <a:gd name="connsiteY9" fmla="*/ 27146 h 1168093"/>
                  <a:gd name="connsiteX10" fmla="*/ 58281 w 1385662"/>
                  <a:gd name="connsiteY10" fmla="*/ 11906 h 1168093"/>
                  <a:gd name="connsiteX11" fmla="*/ 130671 w 1385662"/>
                  <a:gd name="connsiteY11" fmla="*/ 476 h 1168093"/>
                  <a:gd name="connsiteX12" fmla="*/ 332601 w 1385662"/>
                  <a:gd name="connsiteY12" fmla="*/ 4286 h 1168093"/>
                  <a:gd name="connsiteX13" fmla="*/ 507861 w 1385662"/>
                  <a:gd name="connsiteY13" fmla="*/ 23336 h 1168093"/>
                  <a:gd name="connsiteX14" fmla="*/ 725031 w 1385662"/>
                  <a:gd name="connsiteY14" fmla="*/ 53816 h 1168093"/>
                  <a:gd name="connsiteX15" fmla="*/ 885051 w 1385662"/>
                  <a:gd name="connsiteY15" fmla="*/ 91916 h 1168093"/>
                  <a:gd name="connsiteX16" fmla="*/ 1056501 w 1385662"/>
                  <a:gd name="connsiteY16" fmla="*/ 168116 h 1168093"/>
                  <a:gd name="connsiteX17" fmla="*/ 1224141 w 1385662"/>
                  <a:gd name="connsiteY17" fmla="*/ 259556 h 1168093"/>
                  <a:gd name="connsiteX18" fmla="*/ 1357491 w 1385662"/>
                  <a:gd name="connsiteY18" fmla="*/ 377666 h 1168093"/>
                  <a:gd name="connsiteX19" fmla="*/ 1384161 w 1385662"/>
                  <a:gd name="connsiteY19" fmla="*/ 476726 h 1168093"/>
                  <a:gd name="connsiteX20" fmla="*/ 1330821 w 1385662"/>
                  <a:gd name="connsiteY20" fmla="*/ 606266 h 1168093"/>
                  <a:gd name="connsiteX21" fmla="*/ 1197471 w 1385662"/>
                  <a:gd name="connsiteY21" fmla="*/ 640556 h 1168093"/>
                  <a:gd name="connsiteX22" fmla="*/ 1117461 w 1385662"/>
                  <a:gd name="connsiteY22" fmla="*/ 659606 h 1168093"/>
                  <a:gd name="connsiteX23" fmla="*/ 965061 w 1385662"/>
                  <a:gd name="connsiteY23" fmla="*/ 655796 h 1168093"/>
                  <a:gd name="connsiteX24" fmla="*/ 812661 w 1385662"/>
                  <a:gd name="connsiteY24" fmla="*/ 697706 h 1168093"/>
                  <a:gd name="connsiteX25" fmla="*/ 747891 w 1385662"/>
                  <a:gd name="connsiteY25" fmla="*/ 762476 h 1168093"/>
                  <a:gd name="connsiteX26" fmla="*/ 683121 w 1385662"/>
                  <a:gd name="connsiteY26" fmla="*/ 812006 h 1168093"/>
                  <a:gd name="connsiteX27" fmla="*/ 538341 w 1385662"/>
                  <a:gd name="connsiteY27" fmla="*/ 865346 h 1168093"/>
                  <a:gd name="connsiteX28" fmla="*/ 389751 w 1385662"/>
                  <a:gd name="connsiteY28" fmla="*/ 892016 h 1168093"/>
                  <a:gd name="connsiteX29" fmla="*/ 340221 w 1385662"/>
                  <a:gd name="connsiteY29" fmla="*/ 899636 h 1168093"/>
                  <a:gd name="connsiteX30" fmla="*/ 256401 w 1385662"/>
                  <a:gd name="connsiteY30" fmla="*/ 876776 h 1168093"/>
                  <a:gd name="connsiteX31" fmla="*/ 225921 w 1385662"/>
                  <a:gd name="connsiteY31" fmla="*/ 869156 h 1168093"/>
                  <a:gd name="connsiteX32" fmla="*/ 313551 w 1385662"/>
                  <a:gd name="connsiteY32" fmla="*/ 926306 h 1168093"/>
                  <a:gd name="connsiteX33" fmla="*/ 344031 w 1385662"/>
                  <a:gd name="connsiteY33" fmla="*/ 968216 h 1168093"/>
                  <a:gd name="connsiteX34" fmla="*/ 317361 w 1385662"/>
                  <a:gd name="connsiteY34" fmla="*/ 1059656 h 1168093"/>
                  <a:gd name="connsiteX35" fmla="*/ 252591 w 1385662"/>
                  <a:gd name="connsiteY35" fmla="*/ 1128236 h 1168093"/>
                  <a:gd name="connsiteX36" fmla="*/ 138291 w 1385662"/>
                  <a:gd name="connsiteY36" fmla="*/ 1139666 h 1168093"/>
                  <a:gd name="connsiteX37" fmla="*/ 187821 w 1385662"/>
                  <a:gd name="connsiteY37" fmla="*/ 1132046 h 1168093"/>
                  <a:gd name="connsiteX0" fmla="*/ 138291 w 1385662"/>
                  <a:gd name="connsiteY0" fmla="*/ 1139666 h 1167935"/>
                  <a:gd name="connsiteX1" fmla="*/ 88761 w 1385662"/>
                  <a:gd name="connsiteY1" fmla="*/ 1158716 h 1167935"/>
                  <a:gd name="connsiteX2" fmla="*/ 27801 w 1385662"/>
                  <a:gd name="connsiteY2" fmla="*/ 1166336 h 1167935"/>
                  <a:gd name="connsiteX3" fmla="*/ 1131 w 1385662"/>
                  <a:gd name="connsiteY3" fmla="*/ 1128236 h 1167935"/>
                  <a:gd name="connsiteX4" fmla="*/ 4941 w 1385662"/>
                  <a:gd name="connsiteY4" fmla="*/ 987266 h 1167935"/>
                  <a:gd name="connsiteX5" fmla="*/ 4941 w 1385662"/>
                  <a:gd name="connsiteY5" fmla="*/ 701516 h 1167935"/>
                  <a:gd name="connsiteX6" fmla="*/ 1131 w 1385662"/>
                  <a:gd name="connsiteY6" fmla="*/ 423386 h 1167935"/>
                  <a:gd name="connsiteX7" fmla="*/ 1131 w 1385662"/>
                  <a:gd name="connsiteY7" fmla="*/ 217646 h 1167935"/>
                  <a:gd name="connsiteX8" fmla="*/ 1131 w 1385662"/>
                  <a:gd name="connsiteY8" fmla="*/ 99536 h 1167935"/>
                  <a:gd name="connsiteX9" fmla="*/ 8751 w 1385662"/>
                  <a:gd name="connsiteY9" fmla="*/ 27146 h 1167935"/>
                  <a:gd name="connsiteX10" fmla="*/ 58281 w 1385662"/>
                  <a:gd name="connsiteY10" fmla="*/ 11906 h 1167935"/>
                  <a:gd name="connsiteX11" fmla="*/ 130671 w 1385662"/>
                  <a:gd name="connsiteY11" fmla="*/ 476 h 1167935"/>
                  <a:gd name="connsiteX12" fmla="*/ 332601 w 1385662"/>
                  <a:gd name="connsiteY12" fmla="*/ 4286 h 1167935"/>
                  <a:gd name="connsiteX13" fmla="*/ 507861 w 1385662"/>
                  <a:gd name="connsiteY13" fmla="*/ 23336 h 1167935"/>
                  <a:gd name="connsiteX14" fmla="*/ 725031 w 1385662"/>
                  <a:gd name="connsiteY14" fmla="*/ 53816 h 1167935"/>
                  <a:gd name="connsiteX15" fmla="*/ 885051 w 1385662"/>
                  <a:gd name="connsiteY15" fmla="*/ 91916 h 1167935"/>
                  <a:gd name="connsiteX16" fmla="*/ 1056501 w 1385662"/>
                  <a:gd name="connsiteY16" fmla="*/ 168116 h 1167935"/>
                  <a:gd name="connsiteX17" fmla="*/ 1224141 w 1385662"/>
                  <a:gd name="connsiteY17" fmla="*/ 259556 h 1167935"/>
                  <a:gd name="connsiteX18" fmla="*/ 1357491 w 1385662"/>
                  <a:gd name="connsiteY18" fmla="*/ 377666 h 1167935"/>
                  <a:gd name="connsiteX19" fmla="*/ 1384161 w 1385662"/>
                  <a:gd name="connsiteY19" fmla="*/ 476726 h 1167935"/>
                  <a:gd name="connsiteX20" fmla="*/ 1330821 w 1385662"/>
                  <a:gd name="connsiteY20" fmla="*/ 606266 h 1167935"/>
                  <a:gd name="connsiteX21" fmla="*/ 1197471 w 1385662"/>
                  <a:gd name="connsiteY21" fmla="*/ 640556 h 1167935"/>
                  <a:gd name="connsiteX22" fmla="*/ 1117461 w 1385662"/>
                  <a:gd name="connsiteY22" fmla="*/ 659606 h 1167935"/>
                  <a:gd name="connsiteX23" fmla="*/ 965061 w 1385662"/>
                  <a:gd name="connsiteY23" fmla="*/ 655796 h 1167935"/>
                  <a:gd name="connsiteX24" fmla="*/ 812661 w 1385662"/>
                  <a:gd name="connsiteY24" fmla="*/ 697706 h 1167935"/>
                  <a:gd name="connsiteX25" fmla="*/ 747891 w 1385662"/>
                  <a:gd name="connsiteY25" fmla="*/ 762476 h 1167935"/>
                  <a:gd name="connsiteX26" fmla="*/ 683121 w 1385662"/>
                  <a:gd name="connsiteY26" fmla="*/ 812006 h 1167935"/>
                  <a:gd name="connsiteX27" fmla="*/ 538341 w 1385662"/>
                  <a:gd name="connsiteY27" fmla="*/ 865346 h 1167935"/>
                  <a:gd name="connsiteX28" fmla="*/ 389751 w 1385662"/>
                  <a:gd name="connsiteY28" fmla="*/ 892016 h 1167935"/>
                  <a:gd name="connsiteX29" fmla="*/ 340221 w 1385662"/>
                  <a:gd name="connsiteY29" fmla="*/ 899636 h 1167935"/>
                  <a:gd name="connsiteX30" fmla="*/ 256401 w 1385662"/>
                  <a:gd name="connsiteY30" fmla="*/ 876776 h 1167935"/>
                  <a:gd name="connsiteX31" fmla="*/ 225921 w 1385662"/>
                  <a:gd name="connsiteY31" fmla="*/ 869156 h 1167935"/>
                  <a:gd name="connsiteX32" fmla="*/ 313551 w 1385662"/>
                  <a:gd name="connsiteY32" fmla="*/ 926306 h 1167935"/>
                  <a:gd name="connsiteX33" fmla="*/ 344031 w 1385662"/>
                  <a:gd name="connsiteY33" fmla="*/ 968216 h 1167935"/>
                  <a:gd name="connsiteX34" fmla="*/ 317361 w 1385662"/>
                  <a:gd name="connsiteY34" fmla="*/ 1059656 h 1167935"/>
                  <a:gd name="connsiteX35" fmla="*/ 252591 w 1385662"/>
                  <a:gd name="connsiteY35" fmla="*/ 1128236 h 1167935"/>
                  <a:gd name="connsiteX36" fmla="*/ 138291 w 1385662"/>
                  <a:gd name="connsiteY36" fmla="*/ 1139666 h 1167935"/>
                  <a:gd name="connsiteX0" fmla="*/ 157341 w 1385662"/>
                  <a:gd name="connsiteY0" fmla="*/ 1149191 h 1167768"/>
                  <a:gd name="connsiteX1" fmla="*/ 88761 w 1385662"/>
                  <a:gd name="connsiteY1" fmla="*/ 1158716 h 1167768"/>
                  <a:gd name="connsiteX2" fmla="*/ 27801 w 1385662"/>
                  <a:gd name="connsiteY2" fmla="*/ 1166336 h 1167768"/>
                  <a:gd name="connsiteX3" fmla="*/ 1131 w 1385662"/>
                  <a:gd name="connsiteY3" fmla="*/ 1128236 h 1167768"/>
                  <a:gd name="connsiteX4" fmla="*/ 4941 w 1385662"/>
                  <a:gd name="connsiteY4" fmla="*/ 987266 h 1167768"/>
                  <a:gd name="connsiteX5" fmla="*/ 4941 w 1385662"/>
                  <a:gd name="connsiteY5" fmla="*/ 701516 h 1167768"/>
                  <a:gd name="connsiteX6" fmla="*/ 1131 w 1385662"/>
                  <a:gd name="connsiteY6" fmla="*/ 423386 h 1167768"/>
                  <a:gd name="connsiteX7" fmla="*/ 1131 w 1385662"/>
                  <a:gd name="connsiteY7" fmla="*/ 217646 h 1167768"/>
                  <a:gd name="connsiteX8" fmla="*/ 1131 w 1385662"/>
                  <a:gd name="connsiteY8" fmla="*/ 99536 h 1167768"/>
                  <a:gd name="connsiteX9" fmla="*/ 8751 w 1385662"/>
                  <a:gd name="connsiteY9" fmla="*/ 27146 h 1167768"/>
                  <a:gd name="connsiteX10" fmla="*/ 58281 w 1385662"/>
                  <a:gd name="connsiteY10" fmla="*/ 11906 h 1167768"/>
                  <a:gd name="connsiteX11" fmla="*/ 130671 w 1385662"/>
                  <a:gd name="connsiteY11" fmla="*/ 476 h 1167768"/>
                  <a:gd name="connsiteX12" fmla="*/ 332601 w 1385662"/>
                  <a:gd name="connsiteY12" fmla="*/ 4286 h 1167768"/>
                  <a:gd name="connsiteX13" fmla="*/ 507861 w 1385662"/>
                  <a:gd name="connsiteY13" fmla="*/ 23336 h 1167768"/>
                  <a:gd name="connsiteX14" fmla="*/ 725031 w 1385662"/>
                  <a:gd name="connsiteY14" fmla="*/ 53816 h 1167768"/>
                  <a:gd name="connsiteX15" fmla="*/ 885051 w 1385662"/>
                  <a:gd name="connsiteY15" fmla="*/ 91916 h 1167768"/>
                  <a:gd name="connsiteX16" fmla="*/ 1056501 w 1385662"/>
                  <a:gd name="connsiteY16" fmla="*/ 168116 h 1167768"/>
                  <a:gd name="connsiteX17" fmla="*/ 1224141 w 1385662"/>
                  <a:gd name="connsiteY17" fmla="*/ 259556 h 1167768"/>
                  <a:gd name="connsiteX18" fmla="*/ 1357491 w 1385662"/>
                  <a:gd name="connsiteY18" fmla="*/ 377666 h 1167768"/>
                  <a:gd name="connsiteX19" fmla="*/ 1384161 w 1385662"/>
                  <a:gd name="connsiteY19" fmla="*/ 476726 h 1167768"/>
                  <a:gd name="connsiteX20" fmla="*/ 1330821 w 1385662"/>
                  <a:gd name="connsiteY20" fmla="*/ 606266 h 1167768"/>
                  <a:gd name="connsiteX21" fmla="*/ 1197471 w 1385662"/>
                  <a:gd name="connsiteY21" fmla="*/ 640556 h 1167768"/>
                  <a:gd name="connsiteX22" fmla="*/ 1117461 w 1385662"/>
                  <a:gd name="connsiteY22" fmla="*/ 659606 h 1167768"/>
                  <a:gd name="connsiteX23" fmla="*/ 965061 w 1385662"/>
                  <a:gd name="connsiteY23" fmla="*/ 655796 h 1167768"/>
                  <a:gd name="connsiteX24" fmla="*/ 812661 w 1385662"/>
                  <a:gd name="connsiteY24" fmla="*/ 697706 h 1167768"/>
                  <a:gd name="connsiteX25" fmla="*/ 747891 w 1385662"/>
                  <a:gd name="connsiteY25" fmla="*/ 762476 h 1167768"/>
                  <a:gd name="connsiteX26" fmla="*/ 683121 w 1385662"/>
                  <a:gd name="connsiteY26" fmla="*/ 812006 h 1167768"/>
                  <a:gd name="connsiteX27" fmla="*/ 538341 w 1385662"/>
                  <a:gd name="connsiteY27" fmla="*/ 865346 h 1167768"/>
                  <a:gd name="connsiteX28" fmla="*/ 389751 w 1385662"/>
                  <a:gd name="connsiteY28" fmla="*/ 892016 h 1167768"/>
                  <a:gd name="connsiteX29" fmla="*/ 340221 w 1385662"/>
                  <a:gd name="connsiteY29" fmla="*/ 899636 h 1167768"/>
                  <a:gd name="connsiteX30" fmla="*/ 256401 w 1385662"/>
                  <a:gd name="connsiteY30" fmla="*/ 876776 h 1167768"/>
                  <a:gd name="connsiteX31" fmla="*/ 225921 w 1385662"/>
                  <a:gd name="connsiteY31" fmla="*/ 869156 h 1167768"/>
                  <a:gd name="connsiteX32" fmla="*/ 313551 w 1385662"/>
                  <a:gd name="connsiteY32" fmla="*/ 926306 h 1167768"/>
                  <a:gd name="connsiteX33" fmla="*/ 344031 w 1385662"/>
                  <a:gd name="connsiteY33" fmla="*/ 968216 h 1167768"/>
                  <a:gd name="connsiteX34" fmla="*/ 317361 w 1385662"/>
                  <a:gd name="connsiteY34" fmla="*/ 1059656 h 1167768"/>
                  <a:gd name="connsiteX35" fmla="*/ 252591 w 1385662"/>
                  <a:gd name="connsiteY35" fmla="*/ 1128236 h 1167768"/>
                  <a:gd name="connsiteX36" fmla="*/ 157341 w 1385662"/>
                  <a:gd name="connsiteY36" fmla="*/ 1149191 h 11677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1385662" h="1167768">
                    <a:moveTo>
                      <a:pt x="157341" y="1149191"/>
                    </a:moveTo>
                    <a:cubicBezTo>
                      <a:pt x="130036" y="1154271"/>
                      <a:pt x="110351" y="1155859"/>
                      <a:pt x="88761" y="1158716"/>
                    </a:cubicBezTo>
                    <a:cubicBezTo>
                      <a:pt x="67171" y="1161574"/>
                      <a:pt x="42406" y="1171416"/>
                      <a:pt x="27801" y="1166336"/>
                    </a:cubicBezTo>
                    <a:cubicBezTo>
                      <a:pt x="13196" y="1161256"/>
                      <a:pt x="4941" y="1158081"/>
                      <a:pt x="1131" y="1128236"/>
                    </a:cubicBezTo>
                    <a:cubicBezTo>
                      <a:pt x="-2679" y="1098391"/>
                      <a:pt x="4306" y="1058386"/>
                      <a:pt x="4941" y="987266"/>
                    </a:cubicBezTo>
                    <a:cubicBezTo>
                      <a:pt x="5576" y="916146"/>
                      <a:pt x="5576" y="795496"/>
                      <a:pt x="4941" y="701516"/>
                    </a:cubicBezTo>
                    <a:cubicBezTo>
                      <a:pt x="4306" y="607536"/>
                      <a:pt x="1766" y="504031"/>
                      <a:pt x="1131" y="423386"/>
                    </a:cubicBezTo>
                    <a:cubicBezTo>
                      <a:pt x="496" y="342741"/>
                      <a:pt x="1131" y="217646"/>
                      <a:pt x="1131" y="217646"/>
                    </a:cubicBezTo>
                    <a:cubicBezTo>
                      <a:pt x="1131" y="163671"/>
                      <a:pt x="-139" y="131286"/>
                      <a:pt x="1131" y="99536"/>
                    </a:cubicBezTo>
                    <a:cubicBezTo>
                      <a:pt x="2401" y="67786"/>
                      <a:pt x="-774" y="41751"/>
                      <a:pt x="8751" y="27146"/>
                    </a:cubicBezTo>
                    <a:cubicBezTo>
                      <a:pt x="18276" y="12541"/>
                      <a:pt x="37961" y="16351"/>
                      <a:pt x="58281" y="11906"/>
                    </a:cubicBezTo>
                    <a:cubicBezTo>
                      <a:pt x="78601" y="7461"/>
                      <a:pt x="130671" y="476"/>
                      <a:pt x="130671" y="476"/>
                    </a:cubicBezTo>
                    <a:cubicBezTo>
                      <a:pt x="176391" y="-794"/>
                      <a:pt x="269736" y="476"/>
                      <a:pt x="332601" y="4286"/>
                    </a:cubicBezTo>
                    <a:cubicBezTo>
                      <a:pt x="395466" y="8096"/>
                      <a:pt x="507861" y="23336"/>
                      <a:pt x="507861" y="23336"/>
                    </a:cubicBezTo>
                    <a:cubicBezTo>
                      <a:pt x="573266" y="31591"/>
                      <a:pt x="662166" y="42386"/>
                      <a:pt x="725031" y="53816"/>
                    </a:cubicBezTo>
                    <a:cubicBezTo>
                      <a:pt x="787896" y="65246"/>
                      <a:pt x="829806" y="72866"/>
                      <a:pt x="885051" y="91916"/>
                    </a:cubicBezTo>
                    <a:cubicBezTo>
                      <a:pt x="940296" y="110966"/>
                      <a:pt x="999986" y="140176"/>
                      <a:pt x="1056501" y="168116"/>
                    </a:cubicBezTo>
                    <a:cubicBezTo>
                      <a:pt x="1113016" y="196056"/>
                      <a:pt x="1173976" y="224631"/>
                      <a:pt x="1224141" y="259556"/>
                    </a:cubicBezTo>
                    <a:cubicBezTo>
                      <a:pt x="1274306" y="294481"/>
                      <a:pt x="1330821" y="341471"/>
                      <a:pt x="1357491" y="377666"/>
                    </a:cubicBezTo>
                    <a:cubicBezTo>
                      <a:pt x="1384161" y="413861"/>
                      <a:pt x="1388606" y="438626"/>
                      <a:pt x="1384161" y="476726"/>
                    </a:cubicBezTo>
                    <a:cubicBezTo>
                      <a:pt x="1379716" y="514826"/>
                      <a:pt x="1361936" y="578961"/>
                      <a:pt x="1330821" y="606266"/>
                    </a:cubicBezTo>
                    <a:cubicBezTo>
                      <a:pt x="1299706" y="633571"/>
                      <a:pt x="1233031" y="631666"/>
                      <a:pt x="1197471" y="640556"/>
                    </a:cubicBezTo>
                    <a:cubicBezTo>
                      <a:pt x="1161911" y="649446"/>
                      <a:pt x="1156196" y="657066"/>
                      <a:pt x="1117461" y="659606"/>
                    </a:cubicBezTo>
                    <a:cubicBezTo>
                      <a:pt x="1078726" y="662146"/>
                      <a:pt x="1015861" y="649446"/>
                      <a:pt x="965061" y="655796"/>
                    </a:cubicBezTo>
                    <a:cubicBezTo>
                      <a:pt x="914261" y="662146"/>
                      <a:pt x="848856" y="679926"/>
                      <a:pt x="812661" y="697706"/>
                    </a:cubicBezTo>
                    <a:cubicBezTo>
                      <a:pt x="776466" y="715486"/>
                      <a:pt x="769481" y="743426"/>
                      <a:pt x="747891" y="762476"/>
                    </a:cubicBezTo>
                    <a:cubicBezTo>
                      <a:pt x="726301" y="781526"/>
                      <a:pt x="718046" y="794861"/>
                      <a:pt x="683121" y="812006"/>
                    </a:cubicBezTo>
                    <a:cubicBezTo>
                      <a:pt x="648196" y="829151"/>
                      <a:pt x="587236" y="852011"/>
                      <a:pt x="538341" y="865346"/>
                    </a:cubicBezTo>
                    <a:cubicBezTo>
                      <a:pt x="489446" y="878681"/>
                      <a:pt x="389751" y="892016"/>
                      <a:pt x="389751" y="892016"/>
                    </a:cubicBezTo>
                    <a:cubicBezTo>
                      <a:pt x="356731" y="897731"/>
                      <a:pt x="362446" y="902176"/>
                      <a:pt x="340221" y="899636"/>
                    </a:cubicBezTo>
                    <a:cubicBezTo>
                      <a:pt x="317996" y="897096"/>
                      <a:pt x="256401" y="876776"/>
                      <a:pt x="256401" y="876776"/>
                    </a:cubicBezTo>
                    <a:cubicBezTo>
                      <a:pt x="237351" y="871696"/>
                      <a:pt x="216396" y="860901"/>
                      <a:pt x="225921" y="869156"/>
                    </a:cubicBezTo>
                    <a:cubicBezTo>
                      <a:pt x="235446" y="877411"/>
                      <a:pt x="293866" y="909796"/>
                      <a:pt x="313551" y="926306"/>
                    </a:cubicBezTo>
                    <a:cubicBezTo>
                      <a:pt x="333236" y="942816"/>
                      <a:pt x="343396" y="945991"/>
                      <a:pt x="344031" y="968216"/>
                    </a:cubicBezTo>
                    <a:cubicBezTo>
                      <a:pt x="344666" y="990441"/>
                      <a:pt x="332601" y="1032986"/>
                      <a:pt x="317361" y="1059656"/>
                    </a:cubicBezTo>
                    <a:cubicBezTo>
                      <a:pt x="302121" y="1086326"/>
                      <a:pt x="282436" y="1114901"/>
                      <a:pt x="252591" y="1128236"/>
                    </a:cubicBezTo>
                    <a:cubicBezTo>
                      <a:pt x="222746" y="1141571"/>
                      <a:pt x="184646" y="1144111"/>
                      <a:pt x="157341" y="1149191"/>
                    </a:cubicBezTo>
                    <a:close/>
                  </a:path>
                </a:pathLst>
              </a:cu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46" name="フリーフォーム: 図形 45">
              <a:extLst>
                <a:ext uri="{FF2B5EF4-FFF2-40B4-BE49-F238E27FC236}">
                  <a16:creationId xmlns:a16="http://schemas.microsoft.com/office/drawing/2014/main" id="{6D2E68CB-417C-A141-2B57-0D7998F599AD}"/>
                </a:ext>
              </a:extLst>
            </p:cNvPr>
            <p:cNvSpPr/>
            <p:nvPr/>
          </p:nvSpPr>
          <p:spPr>
            <a:xfrm rot="422949">
              <a:off x="9070498" y="4999516"/>
              <a:ext cx="178825" cy="193073"/>
            </a:xfrm>
            <a:custGeom>
              <a:avLst/>
              <a:gdLst>
                <a:gd name="connsiteX0" fmla="*/ 393752 w 1199329"/>
                <a:gd name="connsiteY0" fmla="*/ 1315155 h 1315775"/>
                <a:gd name="connsiteX1" fmla="*/ 190552 w 1199329"/>
                <a:gd name="connsiteY1" fmla="*/ 1223715 h 1315775"/>
                <a:gd name="connsiteX2" fmla="*/ 78792 w 1199329"/>
                <a:gd name="connsiteY2" fmla="*/ 1040835 h 1315775"/>
                <a:gd name="connsiteX3" fmla="*/ 7672 w 1199329"/>
                <a:gd name="connsiteY3" fmla="*/ 847795 h 1315775"/>
                <a:gd name="connsiteX4" fmla="*/ 7672 w 1199329"/>
                <a:gd name="connsiteY4" fmla="*/ 664915 h 1315775"/>
                <a:gd name="connsiteX5" fmla="*/ 58472 w 1199329"/>
                <a:gd name="connsiteY5" fmla="*/ 542995 h 1315775"/>
                <a:gd name="connsiteX6" fmla="*/ 58472 w 1199329"/>
                <a:gd name="connsiteY6" fmla="*/ 390595 h 1315775"/>
                <a:gd name="connsiteX7" fmla="*/ 58472 w 1199329"/>
                <a:gd name="connsiteY7" fmla="*/ 309315 h 1315775"/>
                <a:gd name="connsiteX8" fmla="*/ 149912 w 1199329"/>
                <a:gd name="connsiteY8" fmla="*/ 156915 h 1315775"/>
                <a:gd name="connsiteX9" fmla="*/ 210872 w 1199329"/>
                <a:gd name="connsiteY9" fmla="*/ 65475 h 1315775"/>
                <a:gd name="connsiteX10" fmla="*/ 332792 w 1199329"/>
                <a:gd name="connsiteY10" fmla="*/ 55315 h 1315775"/>
                <a:gd name="connsiteX11" fmla="*/ 485192 w 1199329"/>
                <a:gd name="connsiteY11" fmla="*/ 4515 h 1315775"/>
                <a:gd name="connsiteX12" fmla="*/ 617272 w 1199329"/>
                <a:gd name="connsiteY12" fmla="*/ 4515 h 1315775"/>
                <a:gd name="connsiteX13" fmla="*/ 698552 w 1199329"/>
                <a:gd name="connsiteY13" fmla="*/ 4515 h 1315775"/>
                <a:gd name="connsiteX14" fmla="*/ 850952 w 1199329"/>
                <a:gd name="connsiteY14" fmla="*/ 65475 h 1315775"/>
                <a:gd name="connsiteX15" fmla="*/ 962712 w 1199329"/>
                <a:gd name="connsiteY15" fmla="*/ 177235 h 1315775"/>
                <a:gd name="connsiteX16" fmla="*/ 1013512 w 1199329"/>
                <a:gd name="connsiteY16" fmla="*/ 278835 h 1315775"/>
                <a:gd name="connsiteX17" fmla="*/ 1115112 w 1199329"/>
                <a:gd name="connsiteY17" fmla="*/ 339795 h 1315775"/>
                <a:gd name="connsiteX18" fmla="*/ 1196392 w 1199329"/>
                <a:gd name="connsiteY18" fmla="*/ 482035 h 1315775"/>
                <a:gd name="connsiteX19" fmla="*/ 1155752 w 1199329"/>
                <a:gd name="connsiteY19" fmla="*/ 593795 h 1315775"/>
                <a:gd name="connsiteX20" fmla="*/ 1186232 w 1199329"/>
                <a:gd name="connsiteY20" fmla="*/ 705555 h 1315775"/>
                <a:gd name="connsiteX21" fmla="*/ 1196392 w 1199329"/>
                <a:gd name="connsiteY21" fmla="*/ 857955 h 1315775"/>
                <a:gd name="connsiteX22" fmla="*/ 1135432 w 1199329"/>
                <a:gd name="connsiteY22" fmla="*/ 1010355 h 1315775"/>
                <a:gd name="connsiteX23" fmla="*/ 1023672 w 1199329"/>
                <a:gd name="connsiteY23" fmla="*/ 1111955 h 1315775"/>
                <a:gd name="connsiteX24" fmla="*/ 891592 w 1199329"/>
                <a:gd name="connsiteY24" fmla="*/ 1193235 h 1315775"/>
                <a:gd name="connsiteX25" fmla="*/ 749352 w 1199329"/>
                <a:gd name="connsiteY25" fmla="*/ 1264355 h 1315775"/>
                <a:gd name="connsiteX26" fmla="*/ 556312 w 1199329"/>
                <a:gd name="connsiteY26" fmla="*/ 1264355 h 1315775"/>
                <a:gd name="connsiteX27" fmla="*/ 393752 w 1199329"/>
                <a:gd name="connsiteY27" fmla="*/ 1315155 h 13157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199329" h="1315775">
                  <a:moveTo>
                    <a:pt x="393752" y="1315155"/>
                  </a:moveTo>
                  <a:cubicBezTo>
                    <a:pt x="332792" y="1308382"/>
                    <a:pt x="243045" y="1269435"/>
                    <a:pt x="190552" y="1223715"/>
                  </a:cubicBezTo>
                  <a:cubicBezTo>
                    <a:pt x="138059" y="1177995"/>
                    <a:pt x="109272" y="1103488"/>
                    <a:pt x="78792" y="1040835"/>
                  </a:cubicBezTo>
                  <a:cubicBezTo>
                    <a:pt x="48312" y="978182"/>
                    <a:pt x="19525" y="910448"/>
                    <a:pt x="7672" y="847795"/>
                  </a:cubicBezTo>
                  <a:cubicBezTo>
                    <a:pt x="-4181" y="785142"/>
                    <a:pt x="-795" y="715715"/>
                    <a:pt x="7672" y="664915"/>
                  </a:cubicBezTo>
                  <a:cubicBezTo>
                    <a:pt x="16139" y="614115"/>
                    <a:pt x="50005" y="588715"/>
                    <a:pt x="58472" y="542995"/>
                  </a:cubicBezTo>
                  <a:cubicBezTo>
                    <a:pt x="66939" y="497275"/>
                    <a:pt x="58472" y="390595"/>
                    <a:pt x="58472" y="390595"/>
                  </a:cubicBezTo>
                  <a:cubicBezTo>
                    <a:pt x="58472" y="351648"/>
                    <a:pt x="43232" y="348262"/>
                    <a:pt x="58472" y="309315"/>
                  </a:cubicBezTo>
                  <a:cubicBezTo>
                    <a:pt x="73712" y="270368"/>
                    <a:pt x="124512" y="197555"/>
                    <a:pt x="149912" y="156915"/>
                  </a:cubicBezTo>
                  <a:cubicBezTo>
                    <a:pt x="175312" y="116275"/>
                    <a:pt x="180392" y="82408"/>
                    <a:pt x="210872" y="65475"/>
                  </a:cubicBezTo>
                  <a:cubicBezTo>
                    <a:pt x="241352" y="48542"/>
                    <a:pt x="287072" y="65475"/>
                    <a:pt x="332792" y="55315"/>
                  </a:cubicBezTo>
                  <a:cubicBezTo>
                    <a:pt x="378512" y="45155"/>
                    <a:pt x="437779" y="12982"/>
                    <a:pt x="485192" y="4515"/>
                  </a:cubicBezTo>
                  <a:cubicBezTo>
                    <a:pt x="532605" y="-3952"/>
                    <a:pt x="617272" y="4515"/>
                    <a:pt x="617272" y="4515"/>
                  </a:cubicBezTo>
                  <a:cubicBezTo>
                    <a:pt x="652832" y="4515"/>
                    <a:pt x="659605" y="-5645"/>
                    <a:pt x="698552" y="4515"/>
                  </a:cubicBezTo>
                  <a:cubicBezTo>
                    <a:pt x="737499" y="14675"/>
                    <a:pt x="806925" y="36688"/>
                    <a:pt x="850952" y="65475"/>
                  </a:cubicBezTo>
                  <a:cubicBezTo>
                    <a:pt x="894979" y="94262"/>
                    <a:pt x="935619" y="141675"/>
                    <a:pt x="962712" y="177235"/>
                  </a:cubicBezTo>
                  <a:cubicBezTo>
                    <a:pt x="989805" y="212795"/>
                    <a:pt x="988112" y="251742"/>
                    <a:pt x="1013512" y="278835"/>
                  </a:cubicBezTo>
                  <a:cubicBezTo>
                    <a:pt x="1038912" y="305928"/>
                    <a:pt x="1084632" y="305928"/>
                    <a:pt x="1115112" y="339795"/>
                  </a:cubicBezTo>
                  <a:cubicBezTo>
                    <a:pt x="1145592" y="373662"/>
                    <a:pt x="1189619" y="439702"/>
                    <a:pt x="1196392" y="482035"/>
                  </a:cubicBezTo>
                  <a:cubicBezTo>
                    <a:pt x="1203165" y="524368"/>
                    <a:pt x="1157445" y="556542"/>
                    <a:pt x="1155752" y="593795"/>
                  </a:cubicBezTo>
                  <a:cubicBezTo>
                    <a:pt x="1154059" y="631048"/>
                    <a:pt x="1179459" y="661528"/>
                    <a:pt x="1186232" y="705555"/>
                  </a:cubicBezTo>
                  <a:cubicBezTo>
                    <a:pt x="1193005" y="749582"/>
                    <a:pt x="1204859" y="807155"/>
                    <a:pt x="1196392" y="857955"/>
                  </a:cubicBezTo>
                  <a:cubicBezTo>
                    <a:pt x="1187925" y="908755"/>
                    <a:pt x="1164219" y="968022"/>
                    <a:pt x="1135432" y="1010355"/>
                  </a:cubicBezTo>
                  <a:cubicBezTo>
                    <a:pt x="1106645" y="1052688"/>
                    <a:pt x="1064312" y="1081475"/>
                    <a:pt x="1023672" y="1111955"/>
                  </a:cubicBezTo>
                  <a:cubicBezTo>
                    <a:pt x="983032" y="1142435"/>
                    <a:pt x="937312" y="1167835"/>
                    <a:pt x="891592" y="1193235"/>
                  </a:cubicBezTo>
                  <a:cubicBezTo>
                    <a:pt x="845872" y="1218635"/>
                    <a:pt x="805232" y="1252502"/>
                    <a:pt x="749352" y="1264355"/>
                  </a:cubicBezTo>
                  <a:cubicBezTo>
                    <a:pt x="693472" y="1276208"/>
                    <a:pt x="610499" y="1257582"/>
                    <a:pt x="556312" y="1264355"/>
                  </a:cubicBezTo>
                  <a:cubicBezTo>
                    <a:pt x="502125" y="1271128"/>
                    <a:pt x="454712" y="1321928"/>
                    <a:pt x="393752" y="1315155"/>
                  </a:cubicBezTo>
                  <a:close/>
                </a:path>
              </a:pathLst>
            </a:cu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" name="フリーフォーム: 図形 47">
              <a:extLst>
                <a:ext uri="{FF2B5EF4-FFF2-40B4-BE49-F238E27FC236}">
                  <a16:creationId xmlns:a16="http://schemas.microsoft.com/office/drawing/2014/main" id="{A6F65A3C-AD66-8C8E-34DC-2BF06DBA121B}"/>
                </a:ext>
              </a:extLst>
            </p:cNvPr>
            <p:cNvSpPr/>
            <p:nvPr/>
          </p:nvSpPr>
          <p:spPr>
            <a:xfrm rot="422949">
              <a:off x="9736577" y="4974270"/>
              <a:ext cx="178825" cy="193073"/>
            </a:xfrm>
            <a:custGeom>
              <a:avLst/>
              <a:gdLst>
                <a:gd name="connsiteX0" fmla="*/ 393752 w 1199329"/>
                <a:gd name="connsiteY0" fmla="*/ 1315155 h 1315775"/>
                <a:gd name="connsiteX1" fmla="*/ 190552 w 1199329"/>
                <a:gd name="connsiteY1" fmla="*/ 1223715 h 1315775"/>
                <a:gd name="connsiteX2" fmla="*/ 78792 w 1199329"/>
                <a:gd name="connsiteY2" fmla="*/ 1040835 h 1315775"/>
                <a:gd name="connsiteX3" fmla="*/ 7672 w 1199329"/>
                <a:gd name="connsiteY3" fmla="*/ 847795 h 1315775"/>
                <a:gd name="connsiteX4" fmla="*/ 7672 w 1199329"/>
                <a:gd name="connsiteY4" fmla="*/ 664915 h 1315775"/>
                <a:gd name="connsiteX5" fmla="*/ 58472 w 1199329"/>
                <a:gd name="connsiteY5" fmla="*/ 542995 h 1315775"/>
                <a:gd name="connsiteX6" fmla="*/ 58472 w 1199329"/>
                <a:gd name="connsiteY6" fmla="*/ 390595 h 1315775"/>
                <a:gd name="connsiteX7" fmla="*/ 58472 w 1199329"/>
                <a:gd name="connsiteY7" fmla="*/ 309315 h 1315775"/>
                <a:gd name="connsiteX8" fmla="*/ 149912 w 1199329"/>
                <a:gd name="connsiteY8" fmla="*/ 156915 h 1315775"/>
                <a:gd name="connsiteX9" fmla="*/ 210872 w 1199329"/>
                <a:gd name="connsiteY9" fmla="*/ 65475 h 1315775"/>
                <a:gd name="connsiteX10" fmla="*/ 332792 w 1199329"/>
                <a:gd name="connsiteY10" fmla="*/ 55315 h 1315775"/>
                <a:gd name="connsiteX11" fmla="*/ 485192 w 1199329"/>
                <a:gd name="connsiteY11" fmla="*/ 4515 h 1315775"/>
                <a:gd name="connsiteX12" fmla="*/ 617272 w 1199329"/>
                <a:gd name="connsiteY12" fmla="*/ 4515 h 1315775"/>
                <a:gd name="connsiteX13" fmla="*/ 698552 w 1199329"/>
                <a:gd name="connsiteY13" fmla="*/ 4515 h 1315775"/>
                <a:gd name="connsiteX14" fmla="*/ 850952 w 1199329"/>
                <a:gd name="connsiteY14" fmla="*/ 65475 h 1315775"/>
                <a:gd name="connsiteX15" fmla="*/ 962712 w 1199329"/>
                <a:gd name="connsiteY15" fmla="*/ 177235 h 1315775"/>
                <a:gd name="connsiteX16" fmla="*/ 1013512 w 1199329"/>
                <a:gd name="connsiteY16" fmla="*/ 278835 h 1315775"/>
                <a:gd name="connsiteX17" fmla="*/ 1115112 w 1199329"/>
                <a:gd name="connsiteY17" fmla="*/ 339795 h 1315775"/>
                <a:gd name="connsiteX18" fmla="*/ 1196392 w 1199329"/>
                <a:gd name="connsiteY18" fmla="*/ 482035 h 1315775"/>
                <a:gd name="connsiteX19" fmla="*/ 1155752 w 1199329"/>
                <a:gd name="connsiteY19" fmla="*/ 593795 h 1315775"/>
                <a:gd name="connsiteX20" fmla="*/ 1186232 w 1199329"/>
                <a:gd name="connsiteY20" fmla="*/ 705555 h 1315775"/>
                <a:gd name="connsiteX21" fmla="*/ 1196392 w 1199329"/>
                <a:gd name="connsiteY21" fmla="*/ 857955 h 1315775"/>
                <a:gd name="connsiteX22" fmla="*/ 1135432 w 1199329"/>
                <a:gd name="connsiteY22" fmla="*/ 1010355 h 1315775"/>
                <a:gd name="connsiteX23" fmla="*/ 1023672 w 1199329"/>
                <a:gd name="connsiteY23" fmla="*/ 1111955 h 1315775"/>
                <a:gd name="connsiteX24" fmla="*/ 891592 w 1199329"/>
                <a:gd name="connsiteY24" fmla="*/ 1193235 h 1315775"/>
                <a:gd name="connsiteX25" fmla="*/ 749352 w 1199329"/>
                <a:gd name="connsiteY25" fmla="*/ 1264355 h 1315775"/>
                <a:gd name="connsiteX26" fmla="*/ 556312 w 1199329"/>
                <a:gd name="connsiteY26" fmla="*/ 1264355 h 1315775"/>
                <a:gd name="connsiteX27" fmla="*/ 393752 w 1199329"/>
                <a:gd name="connsiteY27" fmla="*/ 1315155 h 13157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199329" h="1315775">
                  <a:moveTo>
                    <a:pt x="393752" y="1315155"/>
                  </a:moveTo>
                  <a:cubicBezTo>
                    <a:pt x="332792" y="1308382"/>
                    <a:pt x="243045" y="1269435"/>
                    <a:pt x="190552" y="1223715"/>
                  </a:cubicBezTo>
                  <a:cubicBezTo>
                    <a:pt x="138059" y="1177995"/>
                    <a:pt x="109272" y="1103488"/>
                    <a:pt x="78792" y="1040835"/>
                  </a:cubicBezTo>
                  <a:cubicBezTo>
                    <a:pt x="48312" y="978182"/>
                    <a:pt x="19525" y="910448"/>
                    <a:pt x="7672" y="847795"/>
                  </a:cubicBezTo>
                  <a:cubicBezTo>
                    <a:pt x="-4181" y="785142"/>
                    <a:pt x="-795" y="715715"/>
                    <a:pt x="7672" y="664915"/>
                  </a:cubicBezTo>
                  <a:cubicBezTo>
                    <a:pt x="16139" y="614115"/>
                    <a:pt x="50005" y="588715"/>
                    <a:pt x="58472" y="542995"/>
                  </a:cubicBezTo>
                  <a:cubicBezTo>
                    <a:pt x="66939" y="497275"/>
                    <a:pt x="58472" y="390595"/>
                    <a:pt x="58472" y="390595"/>
                  </a:cubicBezTo>
                  <a:cubicBezTo>
                    <a:pt x="58472" y="351648"/>
                    <a:pt x="43232" y="348262"/>
                    <a:pt x="58472" y="309315"/>
                  </a:cubicBezTo>
                  <a:cubicBezTo>
                    <a:pt x="73712" y="270368"/>
                    <a:pt x="124512" y="197555"/>
                    <a:pt x="149912" y="156915"/>
                  </a:cubicBezTo>
                  <a:cubicBezTo>
                    <a:pt x="175312" y="116275"/>
                    <a:pt x="180392" y="82408"/>
                    <a:pt x="210872" y="65475"/>
                  </a:cubicBezTo>
                  <a:cubicBezTo>
                    <a:pt x="241352" y="48542"/>
                    <a:pt x="287072" y="65475"/>
                    <a:pt x="332792" y="55315"/>
                  </a:cubicBezTo>
                  <a:cubicBezTo>
                    <a:pt x="378512" y="45155"/>
                    <a:pt x="437779" y="12982"/>
                    <a:pt x="485192" y="4515"/>
                  </a:cubicBezTo>
                  <a:cubicBezTo>
                    <a:pt x="532605" y="-3952"/>
                    <a:pt x="617272" y="4515"/>
                    <a:pt x="617272" y="4515"/>
                  </a:cubicBezTo>
                  <a:cubicBezTo>
                    <a:pt x="652832" y="4515"/>
                    <a:pt x="659605" y="-5645"/>
                    <a:pt x="698552" y="4515"/>
                  </a:cubicBezTo>
                  <a:cubicBezTo>
                    <a:pt x="737499" y="14675"/>
                    <a:pt x="806925" y="36688"/>
                    <a:pt x="850952" y="65475"/>
                  </a:cubicBezTo>
                  <a:cubicBezTo>
                    <a:pt x="894979" y="94262"/>
                    <a:pt x="935619" y="141675"/>
                    <a:pt x="962712" y="177235"/>
                  </a:cubicBezTo>
                  <a:cubicBezTo>
                    <a:pt x="989805" y="212795"/>
                    <a:pt x="988112" y="251742"/>
                    <a:pt x="1013512" y="278835"/>
                  </a:cubicBezTo>
                  <a:cubicBezTo>
                    <a:pt x="1038912" y="305928"/>
                    <a:pt x="1084632" y="305928"/>
                    <a:pt x="1115112" y="339795"/>
                  </a:cubicBezTo>
                  <a:cubicBezTo>
                    <a:pt x="1145592" y="373662"/>
                    <a:pt x="1189619" y="439702"/>
                    <a:pt x="1196392" y="482035"/>
                  </a:cubicBezTo>
                  <a:cubicBezTo>
                    <a:pt x="1203165" y="524368"/>
                    <a:pt x="1157445" y="556542"/>
                    <a:pt x="1155752" y="593795"/>
                  </a:cubicBezTo>
                  <a:cubicBezTo>
                    <a:pt x="1154059" y="631048"/>
                    <a:pt x="1179459" y="661528"/>
                    <a:pt x="1186232" y="705555"/>
                  </a:cubicBezTo>
                  <a:cubicBezTo>
                    <a:pt x="1193005" y="749582"/>
                    <a:pt x="1204859" y="807155"/>
                    <a:pt x="1196392" y="857955"/>
                  </a:cubicBezTo>
                  <a:cubicBezTo>
                    <a:pt x="1187925" y="908755"/>
                    <a:pt x="1164219" y="968022"/>
                    <a:pt x="1135432" y="1010355"/>
                  </a:cubicBezTo>
                  <a:cubicBezTo>
                    <a:pt x="1106645" y="1052688"/>
                    <a:pt x="1064312" y="1081475"/>
                    <a:pt x="1023672" y="1111955"/>
                  </a:cubicBezTo>
                  <a:cubicBezTo>
                    <a:pt x="983032" y="1142435"/>
                    <a:pt x="937312" y="1167835"/>
                    <a:pt x="891592" y="1193235"/>
                  </a:cubicBezTo>
                  <a:cubicBezTo>
                    <a:pt x="845872" y="1218635"/>
                    <a:pt x="805232" y="1252502"/>
                    <a:pt x="749352" y="1264355"/>
                  </a:cubicBezTo>
                  <a:cubicBezTo>
                    <a:pt x="693472" y="1276208"/>
                    <a:pt x="610499" y="1257582"/>
                    <a:pt x="556312" y="1264355"/>
                  </a:cubicBezTo>
                  <a:cubicBezTo>
                    <a:pt x="502125" y="1271128"/>
                    <a:pt x="454712" y="1321928"/>
                    <a:pt x="393752" y="1315155"/>
                  </a:cubicBezTo>
                  <a:close/>
                </a:path>
              </a:pathLst>
            </a:cu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34AA5CFC-30ED-8AF5-4C8C-6985FC423461}"/>
              </a:ext>
            </a:extLst>
          </p:cNvPr>
          <p:cNvCxnSpPr>
            <a:cxnSpLocks/>
          </p:cNvCxnSpPr>
          <p:nvPr/>
        </p:nvCxnSpPr>
        <p:spPr>
          <a:xfrm flipH="1">
            <a:off x="10010553" y="3687845"/>
            <a:ext cx="370295" cy="745528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5798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7">
            <a:extLst>
              <a:ext uri="{FF2B5EF4-FFF2-40B4-BE49-F238E27FC236}">
                <a16:creationId xmlns:a16="http://schemas.microsoft.com/office/drawing/2014/main" id="{8876AC5F-D3A1-4641-A3DA-ABEF1A75F9C5}"/>
              </a:ext>
            </a:extLst>
          </p:cNvPr>
          <p:cNvSpPr/>
          <p:nvPr/>
        </p:nvSpPr>
        <p:spPr>
          <a:xfrm>
            <a:off x="3135089" y="374366"/>
            <a:ext cx="5887614" cy="11293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コンテンツ プレースホルダー 2">
            <a:extLst>
              <a:ext uri="{FF2B5EF4-FFF2-40B4-BE49-F238E27FC236}">
                <a16:creationId xmlns:a16="http://schemas.microsoft.com/office/drawing/2014/main" id="{DFFCD9CC-562E-459E-9607-52E8B40C2AFA}"/>
              </a:ext>
            </a:extLst>
          </p:cNvPr>
          <p:cNvSpPr txBox="1">
            <a:spLocks/>
          </p:cNvSpPr>
          <p:nvPr/>
        </p:nvSpPr>
        <p:spPr>
          <a:xfrm>
            <a:off x="1179642" y="5399610"/>
            <a:ext cx="4646353" cy="56080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HCC measuring </a:t>
            </a:r>
            <a:r>
              <a:rPr lang="en-PH" altLang="ja-JP" sz="16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≥</a:t>
            </a:r>
            <a:r>
              <a:rPr lang="en-PH" altLang="ja-JP" sz="1600" kern="0" dirty="0"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4 cm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treated with CIRT</a:t>
            </a:r>
          </a:p>
          <a:p>
            <a:pPr marL="0" indent="0" algn="ctr">
              <a:buNone/>
            </a:pPr>
            <a:r>
              <a:rPr lang="en-US" altLang="ja-JP" sz="16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38</a:t>
            </a:r>
            <a:endParaRPr kumimoji="1" lang="en-US" altLang="ja-JP" sz="16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6" name="正方形/長方形 29">
            <a:extLst>
              <a:ext uri="{FF2B5EF4-FFF2-40B4-BE49-F238E27FC236}">
                <a16:creationId xmlns:a16="http://schemas.microsoft.com/office/drawing/2014/main" id="{391C7868-5EF1-47A2-8C8A-C43A9677DF7A}"/>
              </a:ext>
            </a:extLst>
          </p:cNvPr>
          <p:cNvSpPr/>
          <p:nvPr/>
        </p:nvSpPr>
        <p:spPr>
          <a:xfrm>
            <a:off x="1436912" y="5259822"/>
            <a:ext cx="4295773" cy="8260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A7E46716-1EC8-45D0-9BCB-F0E6B2BAC79F}"/>
              </a:ext>
            </a:extLst>
          </p:cNvPr>
          <p:cNvSpPr txBox="1">
            <a:spLocks/>
          </p:cNvSpPr>
          <p:nvPr/>
        </p:nvSpPr>
        <p:spPr>
          <a:xfrm>
            <a:off x="2289896" y="494421"/>
            <a:ext cx="7612207" cy="92796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HCC measuring </a:t>
            </a:r>
            <a:r>
              <a:rPr lang="en-PH" altLang="ja-JP" sz="16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≥</a:t>
            </a:r>
            <a:r>
              <a:rPr lang="en-PH" altLang="ja-JP" sz="16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4 cm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diagnosed</a:t>
            </a:r>
            <a:r>
              <a:rPr lang="ja-JP" altLang="en-US" sz="1600" dirty="0">
                <a:solidFill>
                  <a:srgbClr val="000000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at Yamagata University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(from January 2019 to December 2023)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ja-JP" sz="16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6</a:t>
            </a:r>
          </a:p>
        </p:txBody>
      </p:sp>
      <p:cxnSp>
        <p:nvCxnSpPr>
          <p:cNvPr id="8" name="直線矢印コネクタ 22">
            <a:extLst>
              <a:ext uri="{FF2B5EF4-FFF2-40B4-BE49-F238E27FC236}">
                <a16:creationId xmlns:a16="http://schemas.microsoft.com/office/drawing/2014/main" id="{6AD1C95F-091C-44FB-A63A-91F97BF465A6}"/>
              </a:ext>
            </a:extLst>
          </p:cNvPr>
          <p:cNvCxnSpPr>
            <a:cxnSpLocks/>
          </p:cNvCxnSpPr>
          <p:nvPr/>
        </p:nvCxnSpPr>
        <p:spPr>
          <a:xfrm>
            <a:off x="3567061" y="4582159"/>
            <a:ext cx="0" cy="6776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7AC191F9-F30B-4003-9C8F-C61735679831}"/>
              </a:ext>
            </a:extLst>
          </p:cNvPr>
          <p:cNvSpPr txBox="1">
            <a:spLocks/>
          </p:cNvSpPr>
          <p:nvPr/>
        </p:nvSpPr>
        <p:spPr>
          <a:xfrm>
            <a:off x="6546046" y="5403263"/>
            <a:ext cx="4994800" cy="9076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HCC measuring </a:t>
            </a:r>
            <a:r>
              <a:rPr lang="en-PH" altLang="ja-JP" sz="16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≥</a:t>
            </a:r>
            <a:r>
              <a:rPr lang="en-PH" altLang="ja-JP" sz="1600" kern="0" dirty="0"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4 cm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treated with h</a:t>
            </a:r>
            <a:r>
              <a:rPr lang="en-US" altLang="ja-JP" sz="1600" dirty="0">
                <a:effectLst/>
                <a:latin typeface="Calibri" panose="020F0502020204030204" pitchFamily="34" charset="0"/>
                <a:ea typeface="ＭＳ Ｐゴシック" panose="020B0600070205080204" pitchFamily="50" charset="-128"/>
              </a:rPr>
              <a:t>epatectomy</a:t>
            </a:r>
            <a:endParaRPr lang="en-US" altLang="ja-JP" sz="16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  <a:p>
            <a:pPr marL="0" indent="0" algn="ctr">
              <a:buNone/>
            </a:pPr>
            <a:r>
              <a:rPr lang="en-US" altLang="ja-JP" sz="16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6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13</a:t>
            </a:r>
            <a:endParaRPr kumimoji="1" lang="en-US" altLang="ja-JP" sz="16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10" name="正方形/長方形 35">
            <a:extLst>
              <a:ext uri="{FF2B5EF4-FFF2-40B4-BE49-F238E27FC236}">
                <a16:creationId xmlns:a16="http://schemas.microsoft.com/office/drawing/2014/main" id="{180A0839-C9B1-4FAB-8279-DBFB1DB4F65D}"/>
              </a:ext>
            </a:extLst>
          </p:cNvPr>
          <p:cNvSpPr/>
          <p:nvPr/>
        </p:nvSpPr>
        <p:spPr>
          <a:xfrm>
            <a:off x="6596742" y="5274190"/>
            <a:ext cx="4822801" cy="8116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3">
            <a:extLst>
              <a:ext uri="{FF2B5EF4-FFF2-40B4-BE49-F238E27FC236}">
                <a16:creationId xmlns:a16="http://schemas.microsoft.com/office/drawing/2014/main" id="{836D6C86-DFFD-4ADA-A012-C2F62B09E10F}"/>
              </a:ext>
            </a:extLst>
          </p:cNvPr>
          <p:cNvSpPr/>
          <p:nvPr/>
        </p:nvSpPr>
        <p:spPr>
          <a:xfrm>
            <a:off x="6933867" y="1662715"/>
            <a:ext cx="4140400" cy="272640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" name="直線矢印コネクタ 13">
            <a:extLst>
              <a:ext uri="{FF2B5EF4-FFF2-40B4-BE49-F238E27FC236}">
                <a16:creationId xmlns:a16="http://schemas.microsoft.com/office/drawing/2014/main" id="{30372499-D15E-41DC-BC2F-9BF73E417781}"/>
              </a:ext>
            </a:extLst>
          </p:cNvPr>
          <p:cNvCxnSpPr>
            <a:cxnSpLocks/>
          </p:cNvCxnSpPr>
          <p:nvPr/>
        </p:nvCxnSpPr>
        <p:spPr>
          <a:xfrm>
            <a:off x="8657221" y="4582159"/>
            <a:ext cx="0" cy="6776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5">
            <a:extLst>
              <a:ext uri="{FF2B5EF4-FFF2-40B4-BE49-F238E27FC236}">
                <a16:creationId xmlns:a16="http://schemas.microsoft.com/office/drawing/2014/main" id="{FB1406F3-3B09-42A3-858E-C1A3062230CE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6078896" y="1503667"/>
            <a:ext cx="17104" cy="3078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7">
            <a:extLst>
              <a:ext uri="{FF2B5EF4-FFF2-40B4-BE49-F238E27FC236}">
                <a16:creationId xmlns:a16="http://schemas.microsoft.com/office/drawing/2014/main" id="{F7657B28-346C-40E3-87ED-D9F434FBD15C}"/>
              </a:ext>
            </a:extLst>
          </p:cNvPr>
          <p:cNvCxnSpPr>
            <a:cxnSpLocks/>
          </p:cNvCxnSpPr>
          <p:nvPr/>
        </p:nvCxnSpPr>
        <p:spPr>
          <a:xfrm>
            <a:off x="6093584" y="2940114"/>
            <a:ext cx="83786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8">
            <a:extLst>
              <a:ext uri="{FF2B5EF4-FFF2-40B4-BE49-F238E27FC236}">
                <a16:creationId xmlns:a16="http://schemas.microsoft.com/office/drawing/2014/main" id="{306E15AE-CF5B-4C9F-A94A-F34EFBB07173}"/>
              </a:ext>
            </a:extLst>
          </p:cNvPr>
          <p:cNvCxnSpPr>
            <a:cxnSpLocks/>
          </p:cNvCxnSpPr>
          <p:nvPr/>
        </p:nvCxnSpPr>
        <p:spPr>
          <a:xfrm>
            <a:off x="3556000" y="4582159"/>
            <a:ext cx="51063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コンテンツ プレースホルダー 2">
            <a:extLst>
              <a:ext uri="{FF2B5EF4-FFF2-40B4-BE49-F238E27FC236}">
                <a16:creationId xmlns:a16="http://schemas.microsoft.com/office/drawing/2014/main" id="{FA249106-8844-4FFF-A739-5CAC62287CA0}"/>
              </a:ext>
            </a:extLst>
          </p:cNvPr>
          <p:cNvSpPr txBox="1">
            <a:spLocks/>
          </p:cNvSpPr>
          <p:nvPr/>
        </p:nvSpPr>
        <p:spPr>
          <a:xfrm>
            <a:off x="7012624" y="1692740"/>
            <a:ext cx="4061643" cy="264703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PH" altLang="ja-JP" sz="14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S</a:t>
            </a:r>
            <a:r>
              <a:rPr lang="en-PH" altLang="ja-JP" sz="14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ystemic therapy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(</a:t>
            </a:r>
            <a:r>
              <a:rPr kumimoji="1"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11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)               </a:t>
            </a:r>
            <a:endParaRPr kumimoji="1" lang="en-US" altLang="ja-JP" sz="14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  <a:p>
            <a:pPr marL="0" indent="0">
              <a:buNone/>
            </a:pPr>
            <a:r>
              <a:rPr lang="en-PH" altLang="ja-JP" sz="1400" kern="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en-PH" altLang="ja-JP" sz="1400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stemic therapy</a:t>
            </a: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fter CIRT </a:t>
            </a:r>
            <a:r>
              <a:rPr lang="en-US" altLang="ja-JP" sz="1400" b="0" i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ecause of positive vascular invasion</a:t>
            </a: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kumimoji="1" lang="en-US" altLang="ja-JP" sz="14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= </a:t>
            </a: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pPr marL="0" indent="0">
              <a:buNone/>
            </a:pP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oncurative radical radiation (</a:t>
            </a:r>
            <a:r>
              <a:rPr kumimoji="1"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9)</a:t>
            </a:r>
          </a:p>
          <a:p>
            <a:pPr marL="0" indent="0">
              <a:buNone/>
            </a:pP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o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follow-up for  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&gt;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3 months (</a:t>
            </a:r>
            <a:r>
              <a:rPr kumimoji="1"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3)</a:t>
            </a:r>
          </a:p>
          <a:p>
            <a:pPr marL="0" indent="0">
              <a:buNone/>
            </a:pPr>
            <a:r>
              <a:rPr lang="en-US" altLang="ja-JP" sz="1400" dirty="0"/>
              <a:t>Duplicate cancer</a:t>
            </a:r>
            <a:r>
              <a:rPr kumimoji="1" lang="en-US" altLang="ja-JP" sz="1400" dirty="0">
                <a:ea typeface="ＭＳ Ｐゴシック" panose="020B0600070205080204" pitchFamily="50" charset="-128"/>
                <a:cs typeface="Calibri" panose="020F0502020204030204" pitchFamily="34" charset="0"/>
              </a:rPr>
              <a:t> (</a:t>
            </a:r>
            <a:r>
              <a:rPr kumimoji="1" lang="en-US" altLang="ja-JP" sz="1400" i="1" dirty="0"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kumimoji="1" lang="en-US" altLang="ja-JP" sz="1400" dirty="0">
                <a:ea typeface="ＭＳ Ｐゴシック" panose="020B0600070205080204" pitchFamily="50" charset="-128"/>
                <a:cs typeface="Calibri" panose="020F0502020204030204" pitchFamily="34" charset="0"/>
              </a:rPr>
              <a:t> = 1)</a:t>
            </a:r>
            <a:r>
              <a:rPr lang="en-US" altLang="ja-JP" sz="1400" dirty="0">
                <a:ea typeface="ＭＳ Ｐゴシック" panose="020B0600070205080204" pitchFamily="50" charset="-128"/>
                <a:cs typeface="Calibri" panose="020F0502020204030204" pitchFamily="34" charset="0"/>
              </a:rPr>
              <a:t>       </a:t>
            </a:r>
          </a:p>
          <a:p>
            <a:pPr marL="0" indent="0">
              <a:buNone/>
            </a:pP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TAE after rupture (</a:t>
            </a:r>
            <a:r>
              <a:rPr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5)</a:t>
            </a:r>
          </a:p>
          <a:p>
            <a:pPr marL="0" indent="0">
              <a:buNone/>
            </a:pP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BSC</a:t>
            </a:r>
            <a:r>
              <a:rPr lang="ja-JP" altLang="en-US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(</a:t>
            </a:r>
            <a:r>
              <a:rPr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= 4)</a:t>
            </a:r>
          </a:p>
          <a:p>
            <a:pPr marL="0" indent="0">
              <a:buNone/>
            </a:pP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                                          </a:t>
            </a:r>
            <a:r>
              <a:rPr lang="en-US" altLang="ja-JP" sz="1400" i="1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n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 </a:t>
            </a:r>
            <a:r>
              <a:rPr kumimoji="1"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= </a:t>
            </a:r>
            <a:r>
              <a:rPr lang="en-US" altLang="ja-JP" sz="14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35</a:t>
            </a:r>
            <a:endParaRPr kumimoji="1" lang="en-US" altLang="ja-JP" sz="14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  <a:p>
            <a:pPr marL="0" indent="0">
              <a:buNone/>
            </a:pPr>
            <a:endParaRPr kumimoji="1" lang="en-US" altLang="ja-JP" sz="1600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17" name="テキスト ボックス 1">
            <a:extLst>
              <a:ext uri="{FF2B5EF4-FFF2-40B4-BE49-F238E27FC236}">
                <a16:creationId xmlns:a16="http://schemas.microsoft.com/office/drawing/2014/main" id="{3E490EFF-4A2C-455F-A87E-394F5EB8A1CD}"/>
              </a:ext>
            </a:extLst>
          </p:cNvPr>
          <p:cNvSpPr txBox="1"/>
          <p:nvPr/>
        </p:nvSpPr>
        <p:spPr>
          <a:xfrm>
            <a:off x="226340" y="80022"/>
            <a:ext cx="2550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kern="0" spc="-1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en-US" altLang="ja-JP" sz="1800" b="1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</a:t>
            </a:r>
            <a:endParaRPr kumimoji="1" lang="ja-JP" altLang="en-US" b="1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394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AD1A4C3-034D-EF11-04E3-01837B69E2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4659" y="791431"/>
            <a:ext cx="6327777" cy="5111529"/>
          </a:xfrm>
          <a:prstGeom prst="rect">
            <a:avLst/>
          </a:prstGeom>
        </p:spPr>
      </p:pic>
      <p:sp>
        <p:nvSpPr>
          <p:cNvPr id="2" name="テキスト ボックス 7">
            <a:extLst>
              <a:ext uri="{FF2B5EF4-FFF2-40B4-BE49-F238E27FC236}">
                <a16:creationId xmlns:a16="http://schemas.microsoft.com/office/drawing/2014/main" id="{9A2FC9BB-1D8E-497D-D563-F7FA2FD7296B}"/>
              </a:ext>
            </a:extLst>
          </p:cNvPr>
          <p:cNvSpPr txBox="1"/>
          <p:nvPr/>
        </p:nvSpPr>
        <p:spPr>
          <a:xfrm>
            <a:off x="4500106" y="3911692"/>
            <a:ext cx="12731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 </a:t>
            </a:r>
            <a:r>
              <a:rPr kumimoji="1" lang="en-US" altLang="ja-JP" sz="2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= 0.6200</a:t>
            </a:r>
            <a:endParaRPr kumimoji="1" lang="ja-JP" altLang="en-US" sz="2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C92EF93-4C49-553F-0FBE-F8195C856FD1}"/>
              </a:ext>
            </a:extLst>
          </p:cNvPr>
          <p:cNvSpPr txBox="1"/>
          <p:nvPr/>
        </p:nvSpPr>
        <p:spPr>
          <a:xfrm>
            <a:off x="226340" y="80022"/>
            <a:ext cx="2550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kern="0" spc="-1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en-US" altLang="ja-JP" sz="1800" b="1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endParaRPr kumimoji="1" lang="ja-JP" altLang="en-US" b="1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5056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60E1FC-7F29-98AF-B992-AA0E920A1E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4FBB213-590C-936F-F81F-8631F435A2C5}"/>
              </a:ext>
            </a:extLst>
          </p:cNvPr>
          <p:cNvGraphicFramePr>
            <a:graphicFrameLocks noGrp="1"/>
          </p:cNvGraphicFramePr>
          <p:nvPr/>
        </p:nvGraphicFramePr>
        <p:xfrm>
          <a:off x="170420" y="626276"/>
          <a:ext cx="11968241" cy="56303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9417">
                  <a:extLst>
                    <a:ext uri="{9D8B030D-6E8A-4147-A177-3AD203B41FA5}">
                      <a16:colId xmlns:a16="http://schemas.microsoft.com/office/drawing/2014/main" val="2515318166"/>
                    </a:ext>
                  </a:extLst>
                </a:gridCol>
                <a:gridCol w="1287624">
                  <a:extLst>
                    <a:ext uri="{9D8B030D-6E8A-4147-A177-3AD203B41FA5}">
                      <a16:colId xmlns:a16="http://schemas.microsoft.com/office/drawing/2014/main" val="4005554281"/>
                    </a:ext>
                  </a:extLst>
                </a:gridCol>
                <a:gridCol w="578498">
                  <a:extLst>
                    <a:ext uri="{9D8B030D-6E8A-4147-A177-3AD203B41FA5}">
                      <a16:colId xmlns:a16="http://schemas.microsoft.com/office/drawing/2014/main" val="1370495336"/>
                    </a:ext>
                  </a:extLst>
                </a:gridCol>
                <a:gridCol w="867747">
                  <a:extLst>
                    <a:ext uri="{9D8B030D-6E8A-4147-A177-3AD203B41FA5}">
                      <a16:colId xmlns:a16="http://schemas.microsoft.com/office/drawing/2014/main" val="4225878124"/>
                    </a:ext>
                  </a:extLst>
                </a:gridCol>
                <a:gridCol w="1502229">
                  <a:extLst>
                    <a:ext uri="{9D8B030D-6E8A-4147-A177-3AD203B41FA5}">
                      <a16:colId xmlns:a16="http://schemas.microsoft.com/office/drawing/2014/main" val="4248483303"/>
                    </a:ext>
                  </a:extLst>
                </a:gridCol>
                <a:gridCol w="3004457">
                  <a:extLst>
                    <a:ext uri="{9D8B030D-6E8A-4147-A177-3AD203B41FA5}">
                      <a16:colId xmlns:a16="http://schemas.microsoft.com/office/drawing/2014/main" val="2775418910"/>
                    </a:ext>
                  </a:extLst>
                </a:gridCol>
                <a:gridCol w="1810139">
                  <a:extLst>
                    <a:ext uri="{9D8B030D-6E8A-4147-A177-3AD203B41FA5}">
                      <a16:colId xmlns:a16="http://schemas.microsoft.com/office/drawing/2014/main" val="2819265479"/>
                    </a:ext>
                  </a:extLst>
                </a:gridCol>
                <a:gridCol w="2528130">
                  <a:extLst>
                    <a:ext uri="{9D8B030D-6E8A-4147-A177-3AD203B41FA5}">
                      <a16:colId xmlns:a16="http://schemas.microsoft.com/office/drawing/2014/main" val="3494234104"/>
                    </a:ext>
                  </a:extLst>
                </a:gridCol>
              </a:tblGrid>
              <a:tr h="4920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.</a:t>
                      </a: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uthor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ea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umber of 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tients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tient age, 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 (range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dose,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RBE)/fraction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umor size, median (range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cal control</a:t>
                      </a:r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t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4508574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asuya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 (3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4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9.6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12 Fr, 58.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8</a:t>
                      </a:r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, 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0 (1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0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4.7%, 3 y: 91.4%, 5 y: 90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886556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 (8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12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5 (15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3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y: 89.2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7466814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uy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7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3 (3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, 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 (8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3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4.6%, 3 y: 81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8421678"/>
                  </a:ext>
                </a:extLst>
              </a:tr>
              <a:tr h="31163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rcopenia: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pPr algn="l" fontAlgn="ctr"/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7 (5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5)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rcopenia:</a:t>
                      </a:r>
                    </a:p>
                    <a:p>
                      <a:pPr algn="l" fontAlgn="ctr"/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 (12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0) mm 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y: 81% (sarcopenia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996700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T>
                      <a:noFill/>
                    </a:lnT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nsarcopenia:</a:t>
                      </a:r>
                    </a:p>
                    <a:p>
                      <a:pPr algn="l" fontAlgn="ctr"/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6 (9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it-IT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7) mm</a:t>
                      </a:r>
                      <a:endParaRPr lang="it-IT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y: 72% (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nsarcopenia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749179"/>
                  </a:ext>
                </a:extLst>
              </a:tr>
              <a:tr h="341968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nsarcopenia: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pPr algn="l" fontAlgn="ctr"/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 (45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it-IT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0)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6209720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 (45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–9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12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4 (11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y: 80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8505700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asud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 (49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9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5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3 (13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5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8.0%, 3 y: 91.0%, 5 y: 91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1440590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uy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 (58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88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8 (3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100%, 2 y: 92.3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0863517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 (5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6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12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3 (2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9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y: 78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8554510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ibuy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 (5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5 (12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7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y: 92.6%, 3 y: 76.5%, 4 y: 76.5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3559415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ujit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 (43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3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5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, 4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, 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7 (1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8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y: 92.1%, 5 y: 89.7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4257380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roshima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4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1 (49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4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5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, 4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2 Fr, 52.8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, 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 (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5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6.4%, 2 y: 96.4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3733108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mizawa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 (49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91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.8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 (9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0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3.4%, 2 y: 83.0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7038893"/>
                  </a:ext>
                </a:extLst>
              </a:tr>
              <a:tr h="3116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ong et al.</a:t>
                      </a:r>
                      <a:r>
                        <a:rPr lang="en-US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6</a:t>
                      </a:r>
                      <a:endParaRPr lang="en-US" sz="12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7 (28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5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10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3 (17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5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100%, 3 y: 94.4%, 5 y: 94.4%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9619503"/>
                  </a:ext>
                </a:extLst>
              </a:tr>
              <a:tr h="3110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4</a:t>
                      </a: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hang et al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</a:t>
                      </a:r>
                      <a:r>
                        <a:rPr lang="en-US" altLang="ja-JP" sz="1200" u="none" strike="noStrike" baseline="30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7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3</a:t>
                      </a: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  <a:cs typeface="Calibri" panose="020F0502020204030204" pitchFamily="34" charset="0"/>
                        </a:rPr>
                        <a:t>90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.5 (28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7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 Gy/10 Fr</a:t>
                      </a: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, 6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7.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Gy/15 Fr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6 (16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5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 mm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96.4%, 2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96.4%, 3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93.1%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9335176"/>
                  </a:ext>
                </a:extLst>
              </a:tr>
              <a:tr h="3110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ur ca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2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  <a:cs typeface="Calibri" panose="020F0502020204030204" pitchFamily="34" charset="0"/>
                        </a:rPr>
                        <a:t>38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 (56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3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0 </a:t>
                      </a:r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y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4 F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3.5 (40</a:t>
                      </a:r>
                      <a:r>
                        <a:rPr kumimoji="1" lang="en-PH" altLang="ja-JP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0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 m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y: 81.5%, 2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76.3%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538" marR="6538" marT="6538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396076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EDD84A0-D5BA-B15A-5B31-86254144D29F}"/>
              </a:ext>
            </a:extLst>
          </p:cNvPr>
          <p:cNvSpPr txBox="1"/>
          <p:nvPr/>
        </p:nvSpPr>
        <p:spPr>
          <a:xfrm>
            <a:off x="104378" y="61364"/>
            <a:ext cx="10848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b="1" kern="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en-US" altLang="ja-JP" sz="1800" b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able</a:t>
            </a:r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1.</a:t>
            </a:r>
            <a:r>
              <a:rPr kumimoji="1" lang="ja-JP" alt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kumimoji="1"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vious clinical study results in patients with HCC treated with CIRT</a:t>
            </a:r>
            <a:endParaRPr kumimoji="1" lang="ja-JP" altLang="en-US" dirty="0"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48D27DC9-D363-C710-E3C9-5B0B449EB85F}"/>
              </a:ext>
            </a:extLst>
          </p:cNvPr>
          <p:cNvCxnSpPr>
            <a:cxnSpLocks/>
          </p:cNvCxnSpPr>
          <p:nvPr/>
        </p:nvCxnSpPr>
        <p:spPr>
          <a:xfrm>
            <a:off x="53340" y="644056"/>
            <a:ext cx="120091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60301C0-50FB-2474-578B-411CB87E6D33}"/>
              </a:ext>
            </a:extLst>
          </p:cNvPr>
          <p:cNvCxnSpPr>
            <a:cxnSpLocks/>
          </p:cNvCxnSpPr>
          <p:nvPr/>
        </p:nvCxnSpPr>
        <p:spPr>
          <a:xfrm>
            <a:off x="81519" y="143371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4213AF1-D57B-21D7-1AEC-0EA040BD0317}"/>
              </a:ext>
            </a:extLst>
          </p:cNvPr>
          <p:cNvCxnSpPr>
            <a:cxnSpLocks/>
          </p:cNvCxnSpPr>
          <p:nvPr/>
        </p:nvCxnSpPr>
        <p:spPr>
          <a:xfrm>
            <a:off x="59870" y="1136559"/>
            <a:ext cx="120091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A87BA435-0577-2083-F30E-97D71B659CE9}"/>
              </a:ext>
            </a:extLst>
          </p:cNvPr>
          <p:cNvCxnSpPr>
            <a:cxnSpLocks/>
          </p:cNvCxnSpPr>
          <p:nvPr/>
        </p:nvCxnSpPr>
        <p:spPr>
          <a:xfrm>
            <a:off x="84059" y="173851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75BF371-CD35-D81D-4A1F-5680E8E4E534}"/>
              </a:ext>
            </a:extLst>
          </p:cNvPr>
          <p:cNvCxnSpPr>
            <a:cxnSpLocks/>
          </p:cNvCxnSpPr>
          <p:nvPr/>
        </p:nvCxnSpPr>
        <p:spPr>
          <a:xfrm>
            <a:off x="86599" y="203569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80BD50CD-61AD-DF63-972F-E6E170BF206B}"/>
              </a:ext>
            </a:extLst>
          </p:cNvPr>
          <p:cNvCxnSpPr>
            <a:cxnSpLocks/>
          </p:cNvCxnSpPr>
          <p:nvPr/>
        </p:nvCxnSpPr>
        <p:spPr>
          <a:xfrm>
            <a:off x="84059" y="284087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908A415C-0CF7-B401-E6E9-3BB5597939DB}"/>
              </a:ext>
            </a:extLst>
          </p:cNvPr>
          <p:cNvCxnSpPr>
            <a:cxnSpLocks/>
          </p:cNvCxnSpPr>
          <p:nvPr/>
        </p:nvCxnSpPr>
        <p:spPr>
          <a:xfrm>
            <a:off x="86599" y="315329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63A6E023-D6F3-5FE4-6DDF-0A054C95E197}"/>
              </a:ext>
            </a:extLst>
          </p:cNvPr>
          <p:cNvCxnSpPr>
            <a:cxnSpLocks/>
          </p:cNvCxnSpPr>
          <p:nvPr/>
        </p:nvCxnSpPr>
        <p:spPr>
          <a:xfrm>
            <a:off x="84059" y="345555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45CCD2CD-0BA9-94C9-C15D-A84F83425723}"/>
              </a:ext>
            </a:extLst>
          </p:cNvPr>
          <p:cNvCxnSpPr>
            <a:cxnSpLocks/>
          </p:cNvCxnSpPr>
          <p:nvPr/>
        </p:nvCxnSpPr>
        <p:spPr>
          <a:xfrm>
            <a:off x="86599" y="376797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6C42EFB6-7CC7-B365-0FAB-BBFBAAE00493}"/>
              </a:ext>
            </a:extLst>
          </p:cNvPr>
          <p:cNvCxnSpPr>
            <a:cxnSpLocks/>
          </p:cNvCxnSpPr>
          <p:nvPr/>
        </p:nvCxnSpPr>
        <p:spPr>
          <a:xfrm>
            <a:off x="84059" y="407023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8DA894EE-6CA4-5D55-1792-4A339602BF7A}"/>
              </a:ext>
            </a:extLst>
          </p:cNvPr>
          <p:cNvCxnSpPr>
            <a:cxnSpLocks/>
          </p:cNvCxnSpPr>
          <p:nvPr/>
        </p:nvCxnSpPr>
        <p:spPr>
          <a:xfrm>
            <a:off x="89139" y="440043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4674AAA-EE01-B433-ECCA-432F7EF890A8}"/>
              </a:ext>
            </a:extLst>
          </p:cNvPr>
          <p:cNvCxnSpPr>
            <a:cxnSpLocks/>
          </p:cNvCxnSpPr>
          <p:nvPr/>
        </p:nvCxnSpPr>
        <p:spPr>
          <a:xfrm>
            <a:off x="89139" y="470777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DEC2AE4-8889-02FC-3278-437ECC6AFBA5}"/>
              </a:ext>
            </a:extLst>
          </p:cNvPr>
          <p:cNvCxnSpPr>
            <a:cxnSpLocks/>
          </p:cNvCxnSpPr>
          <p:nvPr/>
        </p:nvCxnSpPr>
        <p:spPr>
          <a:xfrm>
            <a:off x="91679" y="502781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ACBAC1D5-AD46-C122-0ABA-52481BF0F3E1}"/>
              </a:ext>
            </a:extLst>
          </p:cNvPr>
          <p:cNvCxnSpPr>
            <a:cxnSpLocks/>
          </p:cNvCxnSpPr>
          <p:nvPr/>
        </p:nvCxnSpPr>
        <p:spPr>
          <a:xfrm>
            <a:off x="84059" y="533515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012C7894-1C8E-FB29-A54A-743916775CF6}"/>
              </a:ext>
            </a:extLst>
          </p:cNvPr>
          <p:cNvCxnSpPr>
            <a:cxnSpLocks/>
          </p:cNvCxnSpPr>
          <p:nvPr/>
        </p:nvCxnSpPr>
        <p:spPr>
          <a:xfrm>
            <a:off x="91679" y="565265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1FDEF6A4-6F97-A708-801D-75375655FED0}"/>
              </a:ext>
            </a:extLst>
          </p:cNvPr>
          <p:cNvCxnSpPr>
            <a:cxnSpLocks/>
          </p:cNvCxnSpPr>
          <p:nvPr/>
        </p:nvCxnSpPr>
        <p:spPr>
          <a:xfrm>
            <a:off x="84059" y="5954914"/>
            <a:ext cx="1196824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531F5C70-4A96-E192-331B-68E4AB7193A3}"/>
              </a:ext>
            </a:extLst>
          </p:cNvPr>
          <p:cNvCxnSpPr>
            <a:cxnSpLocks/>
          </p:cNvCxnSpPr>
          <p:nvPr/>
        </p:nvCxnSpPr>
        <p:spPr>
          <a:xfrm>
            <a:off x="59870" y="6277519"/>
            <a:ext cx="120091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6AE2CF5-F5A7-A276-4064-A307CFE92805}"/>
              </a:ext>
            </a:extLst>
          </p:cNvPr>
          <p:cNvSpPr txBox="1"/>
          <p:nvPr/>
        </p:nvSpPr>
        <p:spPr>
          <a:xfrm>
            <a:off x="90910" y="6377546"/>
            <a:ext cx="4104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RT, carbon-ion radiotherapy; HCC, hepatocellular carcinoma.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99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875</Words>
  <Application>Microsoft Office PowerPoint</Application>
  <PresentationFormat>Widescreen</PresentationFormat>
  <Paragraphs>16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MDPI</cp:lastModifiedBy>
  <cp:revision>17</cp:revision>
  <dcterms:created xsi:type="dcterms:W3CDTF">2025-03-01T06:28:01Z</dcterms:created>
  <dcterms:modified xsi:type="dcterms:W3CDTF">2025-08-11T11:03:07Z</dcterms:modified>
</cp:coreProperties>
</file>